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theme/themeOverride10.xml" ContentType="application/vnd.openxmlformats-officedocument.themeOverride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theme/themeOverride11.xml" ContentType="application/vnd.openxmlformats-officedocument.themeOverride+xml"/>
  <Override PartName="/ppt/drawings/drawing1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  <Override PartName="/ppt/charts/style4.xml" ContentType="application/vnd.ms-office.chartstyle+xml"/>
  <Override PartName="/ppt/charts/colors4.xml" ContentType="application/vnd.ms-office.chartcolorstyle+xml"/>
  <Override PartName="/ppt/charts/style5.xml" ContentType="application/vnd.ms-office.chartstyle+xml"/>
  <Override PartName="/ppt/charts/colors5.xml" ContentType="application/vnd.ms-office.chartcolorstyle+xml"/>
  <Override PartName="/ppt/charts/style6.xml" ContentType="application/vnd.ms-office.chartstyle+xml"/>
  <Override PartName="/ppt/charts/colors6.xml" ContentType="application/vnd.ms-office.chartcolorstyle+xml"/>
  <Override PartName="/ppt/charts/style7.xml" ContentType="application/vnd.ms-office.chartstyle+xml"/>
  <Override PartName="/ppt/charts/colors7.xml" ContentType="application/vnd.ms-office.chartcolorstyle+xml"/>
  <Override PartName="/ppt/charts/style8.xml" ContentType="application/vnd.ms-office.chartstyle+xml"/>
  <Override PartName="/ppt/charts/colors8.xml" ContentType="application/vnd.ms-office.chartcolorstyle+xml"/>
  <Override PartName="/ppt/charts/style9.xml" ContentType="application/vnd.ms-office.chartstyle+xml"/>
  <Override PartName="/ppt/charts/colors9.xml" ContentType="application/vnd.ms-office.chartcolorstyle+xml"/>
  <Override PartName="/ppt/charts/style10.xml" ContentType="application/vnd.ms-office.chartstyle+xml"/>
  <Override PartName="/ppt/charts/colors10.xml" ContentType="application/vnd.ms-office.chartcolorstyle+xml"/>
  <Override PartName="/ppt/charts/style11.xml" ContentType="application/vnd.ms-office.chartstyle+xml"/>
  <Override PartName="/ppt/charts/colors1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7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481" autoAdjust="0"/>
    <p:restoredTop sz="94660"/>
  </p:normalViewPr>
  <p:slideViewPr>
    <p:cSldViewPr snapToGrid="0">
      <p:cViewPr>
        <p:scale>
          <a:sx n="125" d="100"/>
          <a:sy n="125" d="100"/>
        </p:scale>
        <p:origin x="-784" y="-19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4" Type="http://schemas.microsoft.com/office/2011/relationships/chartStyle" Target="style1.xml"/><Relationship Id="rId5" Type="http://schemas.microsoft.com/office/2011/relationships/chartColorStyle" Target="colors1.xml"/><Relationship Id="rId1" Type="http://schemas.openxmlformats.org/officeDocument/2006/relationships/themeOverride" Target="../theme/themeOverride1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0.xml"/><Relationship Id="rId4" Type="http://schemas.microsoft.com/office/2011/relationships/chartStyle" Target="style10.xml"/><Relationship Id="rId5" Type="http://schemas.microsoft.com/office/2011/relationships/chartColorStyle" Target="colors10.xml"/><Relationship Id="rId1" Type="http://schemas.openxmlformats.org/officeDocument/2006/relationships/themeOverride" Target="../theme/themeOverride10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1.xml"/><Relationship Id="rId4" Type="http://schemas.microsoft.com/office/2011/relationships/chartStyle" Target="style11.xml"/><Relationship Id="rId5" Type="http://schemas.microsoft.com/office/2011/relationships/chartColorStyle" Target="colors11.xml"/><Relationship Id="rId1" Type="http://schemas.openxmlformats.org/officeDocument/2006/relationships/themeOverride" Target="../theme/themeOverride11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4" Type="http://schemas.microsoft.com/office/2011/relationships/chartStyle" Target="style2.xml"/><Relationship Id="rId5" Type="http://schemas.microsoft.com/office/2011/relationships/chartColorStyle" Target="colors2.xml"/><Relationship Id="rId1" Type="http://schemas.openxmlformats.org/officeDocument/2006/relationships/themeOverride" Target="../theme/themeOverride2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3.xml"/><Relationship Id="rId4" Type="http://schemas.microsoft.com/office/2011/relationships/chartStyle" Target="style3.xml"/><Relationship Id="rId5" Type="http://schemas.microsoft.com/office/2011/relationships/chartColorStyle" Target="colors3.xml"/><Relationship Id="rId1" Type="http://schemas.openxmlformats.org/officeDocument/2006/relationships/themeOverride" Target="../theme/themeOverride3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4.xml"/><Relationship Id="rId4" Type="http://schemas.microsoft.com/office/2011/relationships/chartStyle" Target="style4.xml"/><Relationship Id="rId5" Type="http://schemas.microsoft.com/office/2011/relationships/chartColorStyle" Target="colors4.xml"/><Relationship Id="rId1" Type="http://schemas.openxmlformats.org/officeDocument/2006/relationships/themeOverride" Target="../theme/themeOverride4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5.xml"/><Relationship Id="rId4" Type="http://schemas.microsoft.com/office/2011/relationships/chartStyle" Target="style5.xml"/><Relationship Id="rId5" Type="http://schemas.microsoft.com/office/2011/relationships/chartColorStyle" Target="colors5.xml"/><Relationship Id="rId1" Type="http://schemas.openxmlformats.org/officeDocument/2006/relationships/themeOverride" Target="../theme/themeOverride5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6.xml"/><Relationship Id="rId4" Type="http://schemas.microsoft.com/office/2011/relationships/chartStyle" Target="style6.xml"/><Relationship Id="rId5" Type="http://schemas.microsoft.com/office/2011/relationships/chartColorStyle" Target="colors6.xml"/><Relationship Id="rId1" Type="http://schemas.openxmlformats.org/officeDocument/2006/relationships/themeOverride" Target="../theme/themeOverride6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7.xml"/><Relationship Id="rId4" Type="http://schemas.microsoft.com/office/2011/relationships/chartStyle" Target="style7.xml"/><Relationship Id="rId5" Type="http://schemas.microsoft.com/office/2011/relationships/chartColorStyle" Target="colors7.xml"/><Relationship Id="rId1" Type="http://schemas.openxmlformats.org/officeDocument/2006/relationships/themeOverride" Target="../theme/themeOverride7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8.xml"/><Relationship Id="rId4" Type="http://schemas.microsoft.com/office/2011/relationships/chartStyle" Target="style8.xml"/><Relationship Id="rId5" Type="http://schemas.microsoft.com/office/2011/relationships/chartColorStyle" Target="colors8.xml"/><Relationship Id="rId1" Type="http://schemas.openxmlformats.org/officeDocument/2006/relationships/themeOverride" Target="../theme/themeOverride8.xml"/><Relationship Id="rId2" Type="http://schemas.openxmlformats.org/officeDocument/2006/relationships/oleObject" Target="file:///C:\Users\Admin\Desktop\last\sira_dataase\combined_species_2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9.xml"/><Relationship Id="rId4" Type="http://schemas.microsoft.com/office/2011/relationships/chartStyle" Target="style9.xml"/><Relationship Id="rId5" Type="http://schemas.microsoft.com/office/2011/relationships/chartColorStyle" Target="colors9.xml"/><Relationship Id="rId1" Type="http://schemas.openxmlformats.org/officeDocument/2006/relationships/themeOverride" Target="../theme/themeOverride9.xml"/><Relationship Id="rId2" Type="http://schemas.openxmlformats.org/officeDocument/2006/relationships/oleObject" Target="file:///C:\Users\Admin\Desktop\last\sira_dataase\combined_species_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1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2:$AF$19</c:f>
                <c:numCache>
                  <c:formatCode>General</c:formatCode>
                  <c:ptCount val="18"/>
                  <c:pt idx="0">
                    <c:v>2323.948415409825</c:v>
                  </c:pt>
                  <c:pt idx="1">
                    <c:v>10821.90517183778</c:v>
                  </c:pt>
                  <c:pt idx="2">
                    <c:v>31072.58497970361</c:v>
                  </c:pt>
                  <c:pt idx="3">
                    <c:v>3131.455320446284</c:v>
                  </c:pt>
                  <c:pt idx="4">
                    <c:v>65315.47432455722</c:v>
                  </c:pt>
                  <c:pt idx="5">
                    <c:v>6400.399024309973</c:v>
                  </c:pt>
                  <c:pt idx="6">
                    <c:v>2194.618880182966</c:v>
                  </c:pt>
                  <c:pt idx="7">
                    <c:v>3057.798226393198</c:v>
                  </c:pt>
                  <c:pt idx="8">
                    <c:v>95731.71177555238</c:v>
                  </c:pt>
                  <c:pt idx="9">
                    <c:v>3549.521894474186</c:v>
                  </c:pt>
                  <c:pt idx="10">
                    <c:v>15277.21103982347</c:v>
                  </c:pt>
                  <c:pt idx="11">
                    <c:v>4390.48869351125</c:v>
                  </c:pt>
                  <c:pt idx="12">
                    <c:v>24968.21472765607</c:v>
                  </c:pt>
                  <c:pt idx="13">
                    <c:v>11356.28176611353</c:v>
                  </c:pt>
                  <c:pt idx="14">
                    <c:v>11247.35664823127</c:v>
                  </c:pt>
                  <c:pt idx="15">
                    <c:v>2085.87366295924</c:v>
                  </c:pt>
                  <c:pt idx="16">
                    <c:v>965.2607092282645</c:v>
                  </c:pt>
                  <c:pt idx="17">
                    <c:v>1640.250911048971</c:v>
                  </c:pt>
                </c:numCache>
              </c:numRef>
            </c:plus>
            <c:minus>
              <c:numRef>
                <c:f>'Dharmafect Species'!$AF$2:$AF$19</c:f>
                <c:numCache>
                  <c:formatCode>General</c:formatCode>
                  <c:ptCount val="18"/>
                  <c:pt idx="0">
                    <c:v>2323.948415409825</c:v>
                  </c:pt>
                  <c:pt idx="1">
                    <c:v>10821.90517183778</c:v>
                  </c:pt>
                  <c:pt idx="2">
                    <c:v>31072.58497970361</c:v>
                  </c:pt>
                  <c:pt idx="3">
                    <c:v>3131.455320446284</c:v>
                  </c:pt>
                  <c:pt idx="4">
                    <c:v>65315.47432455722</c:v>
                  </c:pt>
                  <c:pt idx="5">
                    <c:v>6400.399024309973</c:v>
                  </c:pt>
                  <c:pt idx="6">
                    <c:v>2194.618880182966</c:v>
                  </c:pt>
                  <c:pt idx="7">
                    <c:v>3057.798226393198</c:v>
                  </c:pt>
                  <c:pt idx="8">
                    <c:v>95731.71177555238</c:v>
                  </c:pt>
                  <c:pt idx="9">
                    <c:v>3549.521894474186</c:v>
                  </c:pt>
                  <c:pt idx="10">
                    <c:v>15277.21103982347</c:v>
                  </c:pt>
                  <c:pt idx="11">
                    <c:v>4390.48869351125</c:v>
                  </c:pt>
                  <c:pt idx="12">
                    <c:v>24968.21472765607</c:v>
                  </c:pt>
                  <c:pt idx="13">
                    <c:v>11356.28176611353</c:v>
                  </c:pt>
                  <c:pt idx="14">
                    <c:v>11247.35664823127</c:v>
                  </c:pt>
                  <c:pt idx="15">
                    <c:v>2085.87366295924</c:v>
                  </c:pt>
                  <c:pt idx="16">
                    <c:v>965.2607092282645</c:v>
                  </c:pt>
                  <c:pt idx="17">
                    <c:v>1640.2509110489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:$Y$19</c:f>
              <c:strCache>
                <c:ptCount val="18"/>
                <c:pt idx="0">
                  <c:v>Cer d16:1_20:1</c:v>
                </c:pt>
                <c:pt idx="1">
                  <c:v>Cer d16:1_24:1A</c:v>
                </c:pt>
                <c:pt idx="2">
                  <c:v>Cer d16:1_24:1B</c:v>
                </c:pt>
                <c:pt idx="3">
                  <c:v>Cer d16:1_25:2</c:v>
                </c:pt>
                <c:pt idx="4">
                  <c:v>Cer d16:1_26:2</c:v>
                </c:pt>
                <c:pt idx="5">
                  <c:v>Cer d18:0_16:0A</c:v>
                </c:pt>
                <c:pt idx="6">
                  <c:v>Cer d18:0_16:0B</c:v>
                </c:pt>
                <c:pt idx="7">
                  <c:v>Cer d18:0_24:0</c:v>
                </c:pt>
                <c:pt idx="8">
                  <c:v>Cer d18:1_16:0</c:v>
                </c:pt>
                <c:pt idx="9">
                  <c:v>Cer d18:1_17:0</c:v>
                </c:pt>
                <c:pt idx="10">
                  <c:v>Cer d18:1_18:0B</c:v>
                </c:pt>
                <c:pt idx="11">
                  <c:v>Cer d18:1_20:0</c:v>
                </c:pt>
                <c:pt idx="12">
                  <c:v>Cer d18:1_22:0</c:v>
                </c:pt>
                <c:pt idx="13">
                  <c:v>Cer d18:1_23:1A</c:v>
                </c:pt>
                <c:pt idx="14">
                  <c:v>Cer d18:1_23:1B</c:v>
                </c:pt>
                <c:pt idx="15">
                  <c:v>Cer d18:1_24:3</c:v>
                </c:pt>
                <c:pt idx="16">
                  <c:v>Cer d18:1_25:0A</c:v>
                </c:pt>
                <c:pt idx="17">
                  <c:v>Cer d18:1_25:0B</c:v>
                </c:pt>
              </c:strCache>
            </c:strRef>
          </c:cat>
          <c:val>
            <c:numRef>
              <c:f>'Dharmafect Species'!$Z$2:$Z$19</c:f>
              <c:numCache>
                <c:formatCode>General</c:formatCode>
                <c:ptCount val="18"/>
                <c:pt idx="0">
                  <c:v>33582.66919962564</c:v>
                </c:pt>
                <c:pt idx="1">
                  <c:v>118471.6136963296</c:v>
                </c:pt>
                <c:pt idx="2">
                  <c:v>54282.54076183121</c:v>
                </c:pt>
                <c:pt idx="3">
                  <c:v>26998.59044254227</c:v>
                </c:pt>
                <c:pt idx="4">
                  <c:v>329019.3142631615</c:v>
                </c:pt>
                <c:pt idx="5">
                  <c:v>55832.77953338623</c:v>
                </c:pt>
                <c:pt idx="6">
                  <c:v>28553.20959472657</c:v>
                </c:pt>
                <c:pt idx="7">
                  <c:v>9614.126210530592</c:v>
                </c:pt>
                <c:pt idx="8">
                  <c:v>463613.9754231772</c:v>
                </c:pt>
                <c:pt idx="9">
                  <c:v>31841.40574977915</c:v>
                </c:pt>
                <c:pt idx="10">
                  <c:v>110328.8953959147</c:v>
                </c:pt>
                <c:pt idx="11">
                  <c:v>38292.90401361543</c:v>
                </c:pt>
                <c:pt idx="12">
                  <c:v>254729.3001330732</c:v>
                </c:pt>
                <c:pt idx="13">
                  <c:v>68142.88953249028</c:v>
                </c:pt>
                <c:pt idx="14">
                  <c:v>67952.88133834392</c:v>
                </c:pt>
                <c:pt idx="15">
                  <c:v>13062.41625976562</c:v>
                </c:pt>
                <c:pt idx="16">
                  <c:v>10394.60738118489</c:v>
                </c:pt>
                <c:pt idx="17">
                  <c:v>12799.88566080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038-454D-B80D-ED46D3DD8944}"/>
            </c:ext>
          </c:extLst>
        </c:ser>
        <c:ser>
          <c:idx val="1"/>
          <c:order val="1"/>
          <c:tx>
            <c:strRef>
              <c:f>'Dharmafect Species'!$AA$1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2:$AG$19</c:f>
                <c:numCache>
                  <c:formatCode>General</c:formatCode>
                  <c:ptCount val="18"/>
                  <c:pt idx="0">
                    <c:v>4890.503723891623</c:v>
                  </c:pt>
                  <c:pt idx="1">
                    <c:v>16186.30486002495</c:v>
                  </c:pt>
                  <c:pt idx="2">
                    <c:v>4704.69259971194</c:v>
                  </c:pt>
                  <c:pt idx="3">
                    <c:v>2692.658543893948</c:v>
                  </c:pt>
                  <c:pt idx="4">
                    <c:v>37918.44155369423</c:v>
                  </c:pt>
                  <c:pt idx="5">
                    <c:v>8929.341301442873</c:v>
                  </c:pt>
                  <c:pt idx="6">
                    <c:v>2923.650135989186</c:v>
                  </c:pt>
                  <c:pt idx="7">
                    <c:v>3142.44500221532</c:v>
                  </c:pt>
                  <c:pt idx="8">
                    <c:v>68052.44956052027</c:v>
                  </c:pt>
                  <c:pt idx="9">
                    <c:v>4595.269595511178</c:v>
                  </c:pt>
                  <c:pt idx="10">
                    <c:v>18497.73296825327</c:v>
                  </c:pt>
                  <c:pt idx="11">
                    <c:v>7776.785351709312</c:v>
                  </c:pt>
                  <c:pt idx="12">
                    <c:v>49510.72438391487</c:v>
                  </c:pt>
                  <c:pt idx="13">
                    <c:v>8069.04720146168</c:v>
                  </c:pt>
                  <c:pt idx="14">
                    <c:v>8071.730927392382</c:v>
                  </c:pt>
                  <c:pt idx="15">
                    <c:v>1900.182581046554</c:v>
                  </c:pt>
                  <c:pt idx="16">
                    <c:v>2139.443457868596</c:v>
                  </c:pt>
                  <c:pt idx="17">
                    <c:v>2805.624023975921</c:v>
                  </c:pt>
                </c:numCache>
              </c:numRef>
            </c:plus>
            <c:minus>
              <c:numRef>
                <c:f>'Dharmafect Species'!$AG$2:$AG$19</c:f>
                <c:numCache>
                  <c:formatCode>General</c:formatCode>
                  <c:ptCount val="18"/>
                  <c:pt idx="0">
                    <c:v>4890.503723891623</c:v>
                  </c:pt>
                  <c:pt idx="1">
                    <c:v>16186.30486002495</c:v>
                  </c:pt>
                  <c:pt idx="2">
                    <c:v>4704.69259971194</c:v>
                  </c:pt>
                  <c:pt idx="3">
                    <c:v>2692.658543893948</c:v>
                  </c:pt>
                  <c:pt idx="4">
                    <c:v>37918.44155369423</c:v>
                  </c:pt>
                  <c:pt idx="5">
                    <c:v>8929.341301442873</c:v>
                  </c:pt>
                  <c:pt idx="6">
                    <c:v>2923.650135989186</c:v>
                  </c:pt>
                  <c:pt idx="7">
                    <c:v>3142.44500221532</c:v>
                  </c:pt>
                  <c:pt idx="8">
                    <c:v>68052.44956052027</c:v>
                  </c:pt>
                  <c:pt idx="9">
                    <c:v>4595.269595511178</c:v>
                  </c:pt>
                  <c:pt idx="10">
                    <c:v>18497.73296825327</c:v>
                  </c:pt>
                  <c:pt idx="11">
                    <c:v>7776.785351709312</c:v>
                  </c:pt>
                  <c:pt idx="12">
                    <c:v>49510.72438391487</c:v>
                  </c:pt>
                  <c:pt idx="13">
                    <c:v>8069.04720146168</c:v>
                  </c:pt>
                  <c:pt idx="14">
                    <c:v>8071.730927392382</c:v>
                  </c:pt>
                  <c:pt idx="15">
                    <c:v>1900.182581046554</c:v>
                  </c:pt>
                  <c:pt idx="16">
                    <c:v>2139.443457868596</c:v>
                  </c:pt>
                  <c:pt idx="17">
                    <c:v>2805.6240239759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:$Y$19</c:f>
              <c:strCache>
                <c:ptCount val="18"/>
                <c:pt idx="0">
                  <c:v>Cer d16:1_20:1</c:v>
                </c:pt>
                <c:pt idx="1">
                  <c:v>Cer d16:1_24:1A</c:v>
                </c:pt>
                <c:pt idx="2">
                  <c:v>Cer d16:1_24:1B</c:v>
                </c:pt>
                <c:pt idx="3">
                  <c:v>Cer d16:1_25:2</c:v>
                </c:pt>
                <c:pt idx="4">
                  <c:v>Cer d16:1_26:2</c:v>
                </c:pt>
                <c:pt idx="5">
                  <c:v>Cer d18:0_16:0A</c:v>
                </c:pt>
                <c:pt idx="6">
                  <c:v>Cer d18:0_16:0B</c:v>
                </c:pt>
                <c:pt idx="7">
                  <c:v>Cer d18:0_24:0</c:v>
                </c:pt>
                <c:pt idx="8">
                  <c:v>Cer d18:1_16:0</c:v>
                </c:pt>
                <c:pt idx="9">
                  <c:v>Cer d18:1_17:0</c:v>
                </c:pt>
                <c:pt idx="10">
                  <c:v>Cer d18:1_18:0B</c:v>
                </c:pt>
                <c:pt idx="11">
                  <c:v>Cer d18:1_20:0</c:v>
                </c:pt>
                <c:pt idx="12">
                  <c:v>Cer d18:1_22:0</c:v>
                </c:pt>
                <c:pt idx="13">
                  <c:v>Cer d18:1_23:1A</c:v>
                </c:pt>
                <c:pt idx="14">
                  <c:v>Cer d18:1_23:1B</c:v>
                </c:pt>
                <c:pt idx="15">
                  <c:v>Cer d18:1_24:3</c:v>
                </c:pt>
                <c:pt idx="16">
                  <c:v>Cer d18:1_25:0A</c:v>
                </c:pt>
                <c:pt idx="17">
                  <c:v>Cer d18:1_25:0B</c:v>
                </c:pt>
              </c:strCache>
            </c:strRef>
          </c:cat>
          <c:val>
            <c:numRef>
              <c:f>'Dharmafect Species'!$AA$2:$AA$19</c:f>
              <c:numCache>
                <c:formatCode>General</c:formatCode>
                <c:ptCount val="18"/>
                <c:pt idx="0">
                  <c:v>40154.81681315106</c:v>
                </c:pt>
                <c:pt idx="1">
                  <c:v>106336.2538597263</c:v>
                </c:pt>
                <c:pt idx="2">
                  <c:v>37890.67028841518</c:v>
                </c:pt>
                <c:pt idx="3">
                  <c:v>24471.2755052456</c:v>
                </c:pt>
                <c:pt idx="4">
                  <c:v>270079.1844741717</c:v>
                </c:pt>
                <c:pt idx="5">
                  <c:v>79222.30781046551</c:v>
                </c:pt>
                <c:pt idx="6">
                  <c:v>26475.27313232424</c:v>
                </c:pt>
                <c:pt idx="7">
                  <c:v>9816.449020385747</c:v>
                </c:pt>
                <c:pt idx="8">
                  <c:v>564590.2922363282</c:v>
                </c:pt>
                <c:pt idx="9">
                  <c:v>41027.89068007945</c:v>
                </c:pt>
                <c:pt idx="10">
                  <c:v>131761.1591288248</c:v>
                </c:pt>
                <c:pt idx="11">
                  <c:v>41757.19743866998</c:v>
                </c:pt>
                <c:pt idx="12">
                  <c:v>263852.3190820874</c:v>
                </c:pt>
                <c:pt idx="13">
                  <c:v>61774.76426319731</c:v>
                </c:pt>
                <c:pt idx="14">
                  <c:v>61767.411297825</c:v>
                </c:pt>
                <c:pt idx="15">
                  <c:v>14184.96339925128</c:v>
                </c:pt>
                <c:pt idx="16">
                  <c:v>9276.05379231772</c:v>
                </c:pt>
                <c:pt idx="17">
                  <c:v>12246.782124837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038-454D-B80D-ED46D3DD8944}"/>
            </c:ext>
          </c:extLst>
        </c:ser>
        <c:ser>
          <c:idx val="2"/>
          <c:order val="2"/>
          <c:tx>
            <c:strRef>
              <c:f>'Dharmafect Species'!$AB$1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H$2:$AH$19</c:f>
                <c:numCache>
                  <c:formatCode>General</c:formatCode>
                  <c:ptCount val="18"/>
                  <c:pt idx="0">
                    <c:v>5731.26908266804</c:v>
                  </c:pt>
                  <c:pt idx="1">
                    <c:v>26252.91926202635</c:v>
                  </c:pt>
                  <c:pt idx="2">
                    <c:v>15615.55727736267</c:v>
                  </c:pt>
                  <c:pt idx="3">
                    <c:v>4549.967915843249</c:v>
                  </c:pt>
                  <c:pt idx="4">
                    <c:v>75021.23807811842</c:v>
                  </c:pt>
                  <c:pt idx="5">
                    <c:v>16795.64102094453</c:v>
                  </c:pt>
                  <c:pt idx="6">
                    <c:v>4579.870845549798</c:v>
                  </c:pt>
                  <c:pt idx="7">
                    <c:v>2030.9552437096</c:v>
                  </c:pt>
                  <c:pt idx="8">
                    <c:v>111182.5325528387</c:v>
                  </c:pt>
                  <c:pt idx="9">
                    <c:v>6375.390454565414</c:v>
                  </c:pt>
                  <c:pt idx="10">
                    <c:v>39571.07202143827</c:v>
                  </c:pt>
                  <c:pt idx="11">
                    <c:v>10030.90948126515</c:v>
                  </c:pt>
                  <c:pt idx="12">
                    <c:v>63688.80149944795</c:v>
                  </c:pt>
                  <c:pt idx="13">
                    <c:v>16167.78383050685</c:v>
                  </c:pt>
                  <c:pt idx="14">
                    <c:v>16352.61497627874</c:v>
                  </c:pt>
                  <c:pt idx="15">
                    <c:v>3014.135997966174</c:v>
                  </c:pt>
                  <c:pt idx="16">
                    <c:v>2060.38839316202</c:v>
                  </c:pt>
                  <c:pt idx="17">
                    <c:v>2876.844619602942</c:v>
                  </c:pt>
                </c:numCache>
              </c:numRef>
            </c:plus>
            <c:minus>
              <c:numRef>
                <c:f>'Dharmafect Species'!$AH$2:$AH$19</c:f>
                <c:numCache>
                  <c:formatCode>General</c:formatCode>
                  <c:ptCount val="18"/>
                  <c:pt idx="0">
                    <c:v>5731.26908266804</c:v>
                  </c:pt>
                  <c:pt idx="1">
                    <c:v>26252.91926202635</c:v>
                  </c:pt>
                  <c:pt idx="2">
                    <c:v>15615.55727736267</c:v>
                  </c:pt>
                  <c:pt idx="3">
                    <c:v>4549.967915843249</c:v>
                  </c:pt>
                  <c:pt idx="4">
                    <c:v>75021.23807811842</c:v>
                  </c:pt>
                  <c:pt idx="5">
                    <c:v>16795.64102094453</c:v>
                  </c:pt>
                  <c:pt idx="6">
                    <c:v>4579.870845549798</c:v>
                  </c:pt>
                  <c:pt idx="7">
                    <c:v>2030.9552437096</c:v>
                  </c:pt>
                  <c:pt idx="8">
                    <c:v>111182.5325528387</c:v>
                  </c:pt>
                  <c:pt idx="9">
                    <c:v>6375.390454565414</c:v>
                  </c:pt>
                  <c:pt idx="10">
                    <c:v>39571.07202143827</c:v>
                  </c:pt>
                  <c:pt idx="11">
                    <c:v>10030.90948126515</c:v>
                  </c:pt>
                  <c:pt idx="12">
                    <c:v>63688.80149944795</c:v>
                  </c:pt>
                  <c:pt idx="13">
                    <c:v>16167.78383050685</c:v>
                  </c:pt>
                  <c:pt idx="14">
                    <c:v>16352.61497627874</c:v>
                  </c:pt>
                  <c:pt idx="15">
                    <c:v>3014.135997966174</c:v>
                  </c:pt>
                  <c:pt idx="16">
                    <c:v>2060.38839316202</c:v>
                  </c:pt>
                  <c:pt idx="17">
                    <c:v>2876.8446196029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:$Y$19</c:f>
              <c:strCache>
                <c:ptCount val="18"/>
                <c:pt idx="0">
                  <c:v>Cer d16:1_20:1</c:v>
                </c:pt>
                <c:pt idx="1">
                  <c:v>Cer d16:1_24:1A</c:v>
                </c:pt>
                <c:pt idx="2">
                  <c:v>Cer d16:1_24:1B</c:v>
                </c:pt>
                <c:pt idx="3">
                  <c:v>Cer d16:1_25:2</c:v>
                </c:pt>
                <c:pt idx="4">
                  <c:v>Cer d16:1_26:2</c:v>
                </c:pt>
                <c:pt idx="5">
                  <c:v>Cer d18:0_16:0A</c:v>
                </c:pt>
                <c:pt idx="6">
                  <c:v>Cer d18:0_16:0B</c:v>
                </c:pt>
                <c:pt idx="7">
                  <c:v>Cer d18:0_24:0</c:v>
                </c:pt>
                <c:pt idx="8">
                  <c:v>Cer d18:1_16:0</c:v>
                </c:pt>
                <c:pt idx="9">
                  <c:v>Cer d18:1_17:0</c:v>
                </c:pt>
                <c:pt idx="10">
                  <c:v>Cer d18:1_18:0B</c:v>
                </c:pt>
                <c:pt idx="11">
                  <c:v>Cer d18:1_20:0</c:v>
                </c:pt>
                <c:pt idx="12">
                  <c:v>Cer d18:1_22:0</c:v>
                </c:pt>
                <c:pt idx="13">
                  <c:v>Cer d18:1_23:1A</c:v>
                </c:pt>
                <c:pt idx="14">
                  <c:v>Cer d18:1_23:1B</c:v>
                </c:pt>
                <c:pt idx="15">
                  <c:v>Cer d18:1_24:3</c:v>
                </c:pt>
                <c:pt idx="16">
                  <c:v>Cer d18:1_25:0A</c:v>
                </c:pt>
                <c:pt idx="17">
                  <c:v>Cer d18:1_25:0B</c:v>
                </c:pt>
              </c:strCache>
            </c:strRef>
          </c:cat>
          <c:val>
            <c:numRef>
              <c:f>'Dharmafect Species'!$AB$2:$AB$19</c:f>
              <c:numCache>
                <c:formatCode>General</c:formatCode>
                <c:ptCount val="18"/>
                <c:pt idx="0">
                  <c:v>32411.3987833659</c:v>
                </c:pt>
                <c:pt idx="1">
                  <c:v>83985.89724254927</c:v>
                </c:pt>
                <c:pt idx="2">
                  <c:v>39204.6979827349</c:v>
                </c:pt>
                <c:pt idx="3">
                  <c:v>20752.41108423658</c:v>
                </c:pt>
                <c:pt idx="4">
                  <c:v>214048.6118350355</c:v>
                </c:pt>
                <c:pt idx="5">
                  <c:v>57658.93187459312</c:v>
                </c:pt>
                <c:pt idx="6">
                  <c:v>20914.70098876955</c:v>
                </c:pt>
                <c:pt idx="7">
                  <c:v>7331.045939127605</c:v>
                </c:pt>
                <c:pt idx="8">
                  <c:v>431973.044026693</c:v>
                </c:pt>
                <c:pt idx="9">
                  <c:v>32637.46806964116</c:v>
                </c:pt>
                <c:pt idx="10">
                  <c:v>115013.4641952514</c:v>
                </c:pt>
                <c:pt idx="11">
                  <c:v>36167.1843921779</c:v>
                </c:pt>
                <c:pt idx="12">
                  <c:v>227779.3496516861</c:v>
                </c:pt>
                <c:pt idx="13">
                  <c:v>51634.23664280016</c:v>
                </c:pt>
                <c:pt idx="14">
                  <c:v>51493.7772614693</c:v>
                </c:pt>
                <c:pt idx="15">
                  <c:v>11607.16057840983</c:v>
                </c:pt>
                <c:pt idx="16">
                  <c:v>8123.859008789065</c:v>
                </c:pt>
                <c:pt idx="17">
                  <c:v>9867.749974568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038-454D-B80D-ED46D3DD89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9561784"/>
        <c:axId val="-2129558088"/>
      </c:barChart>
      <c:catAx>
        <c:axId val="-2129561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9558088"/>
        <c:crosses val="autoZero"/>
        <c:auto val="1"/>
        <c:lblAlgn val="ctr"/>
        <c:lblOffset val="100"/>
        <c:noMultiLvlLbl val="0"/>
      </c:catAx>
      <c:valAx>
        <c:axId val="-21295580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9561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209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210:$AE$244</c:f>
                <c:numCache>
                  <c:formatCode>General</c:formatCode>
                  <c:ptCount val="35"/>
                  <c:pt idx="0">
                    <c:v>6771.638619560977</c:v>
                  </c:pt>
                  <c:pt idx="1">
                    <c:v>30216.48962162077</c:v>
                  </c:pt>
                  <c:pt idx="2">
                    <c:v>7481.829887456801</c:v>
                  </c:pt>
                  <c:pt idx="3">
                    <c:v>948.1969570046739</c:v>
                  </c:pt>
                  <c:pt idx="4">
                    <c:v>84136.09997320137</c:v>
                  </c:pt>
                  <c:pt idx="5">
                    <c:v>36142.03101089952</c:v>
                  </c:pt>
                  <c:pt idx="6">
                    <c:v>4560.55292193149</c:v>
                  </c:pt>
                  <c:pt idx="7">
                    <c:v>4165.869020378731</c:v>
                  </c:pt>
                  <c:pt idx="8">
                    <c:v>4885.088762397249</c:v>
                  </c:pt>
                  <c:pt idx="9">
                    <c:v>977.6349813254967</c:v>
                  </c:pt>
                  <c:pt idx="10">
                    <c:v>3182.018818778418</c:v>
                  </c:pt>
                  <c:pt idx="11">
                    <c:v>17795.36930817274</c:v>
                  </c:pt>
                  <c:pt idx="12">
                    <c:v>94438.0550998458</c:v>
                  </c:pt>
                  <c:pt idx="13">
                    <c:v>16949.21102032028</c:v>
                  </c:pt>
                  <c:pt idx="14">
                    <c:v>1975.204589761163</c:v>
                  </c:pt>
                  <c:pt idx="15">
                    <c:v>2755.773592939195</c:v>
                  </c:pt>
                  <c:pt idx="16">
                    <c:v>2501.301159933658</c:v>
                  </c:pt>
                  <c:pt idx="17">
                    <c:v>2254.472332291697</c:v>
                  </c:pt>
                  <c:pt idx="18">
                    <c:v>13419.54417845797</c:v>
                  </c:pt>
                  <c:pt idx="19">
                    <c:v>42596.1417033886</c:v>
                  </c:pt>
                  <c:pt idx="20">
                    <c:v>5198.966047063143</c:v>
                  </c:pt>
                  <c:pt idx="21">
                    <c:v>3499.07237076241</c:v>
                  </c:pt>
                  <c:pt idx="22">
                    <c:v>1325.735564484343</c:v>
                  </c:pt>
                  <c:pt idx="23">
                    <c:v>1090.595930415563</c:v>
                  </c:pt>
                  <c:pt idx="24">
                    <c:v>1521.592938024278</c:v>
                  </c:pt>
                  <c:pt idx="25">
                    <c:v>4694.28166624544</c:v>
                  </c:pt>
                  <c:pt idx="26">
                    <c:v>4309.823735089165</c:v>
                  </c:pt>
                  <c:pt idx="27">
                    <c:v>796.2658276068056</c:v>
                  </c:pt>
                  <c:pt idx="28">
                    <c:v>2695.298993555026</c:v>
                  </c:pt>
                  <c:pt idx="29">
                    <c:v>993.2121257074278</c:v>
                  </c:pt>
                  <c:pt idx="30">
                    <c:v>768.2783435217125</c:v>
                  </c:pt>
                  <c:pt idx="31">
                    <c:v>1263.40168028663</c:v>
                  </c:pt>
                  <c:pt idx="32">
                    <c:v>2592.318981116442</c:v>
                  </c:pt>
                  <c:pt idx="33">
                    <c:v>791.8816039765966</c:v>
                  </c:pt>
                  <c:pt idx="34">
                    <c:v>907.7827940647555</c:v>
                  </c:pt>
                </c:numCache>
              </c:numRef>
            </c:plus>
            <c:minus>
              <c:numRef>
                <c:f>'Dharmafect Species'!$AE$210:$AE$244</c:f>
                <c:numCache>
                  <c:formatCode>General</c:formatCode>
                  <c:ptCount val="35"/>
                  <c:pt idx="0">
                    <c:v>6771.638619560977</c:v>
                  </c:pt>
                  <c:pt idx="1">
                    <c:v>30216.48962162077</c:v>
                  </c:pt>
                  <c:pt idx="2">
                    <c:v>7481.829887456801</c:v>
                  </c:pt>
                  <c:pt idx="3">
                    <c:v>948.1969570046739</c:v>
                  </c:pt>
                  <c:pt idx="4">
                    <c:v>84136.09997320137</c:v>
                  </c:pt>
                  <c:pt idx="5">
                    <c:v>36142.03101089952</c:v>
                  </c:pt>
                  <c:pt idx="6">
                    <c:v>4560.55292193149</c:v>
                  </c:pt>
                  <c:pt idx="7">
                    <c:v>4165.869020378731</c:v>
                  </c:pt>
                  <c:pt idx="8">
                    <c:v>4885.088762397249</c:v>
                  </c:pt>
                  <c:pt idx="9">
                    <c:v>977.6349813254967</c:v>
                  </c:pt>
                  <c:pt idx="10">
                    <c:v>3182.018818778418</c:v>
                  </c:pt>
                  <c:pt idx="11">
                    <c:v>17795.36930817274</c:v>
                  </c:pt>
                  <c:pt idx="12">
                    <c:v>94438.0550998458</c:v>
                  </c:pt>
                  <c:pt idx="13">
                    <c:v>16949.21102032028</c:v>
                  </c:pt>
                  <c:pt idx="14">
                    <c:v>1975.204589761163</c:v>
                  </c:pt>
                  <c:pt idx="15">
                    <c:v>2755.773592939195</c:v>
                  </c:pt>
                  <c:pt idx="16">
                    <c:v>2501.301159933658</c:v>
                  </c:pt>
                  <c:pt idx="17">
                    <c:v>2254.472332291697</c:v>
                  </c:pt>
                  <c:pt idx="18">
                    <c:v>13419.54417845797</c:v>
                  </c:pt>
                  <c:pt idx="19">
                    <c:v>42596.1417033886</c:v>
                  </c:pt>
                  <c:pt idx="20">
                    <c:v>5198.966047063143</c:v>
                  </c:pt>
                  <c:pt idx="21">
                    <c:v>3499.07237076241</c:v>
                  </c:pt>
                  <c:pt idx="22">
                    <c:v>1325.735564484343</c:v>
                  </c:pt>
                  <c:pt idx="23">
                    <c:v>1090.595930415563</c:v>
                  </c:pt>
                  <c:pt idx="24">
                    <c:v>1521.592938024278</c:v>
                  </c:pt>
                  <c:pt idx="25">
                    <c:v>4694.28166624544</c:v>
                  </c:pt>
                  <c:pt idx="26">
                    <c:v>4309.823735089165</c:v>
                  </c:pt>
                  <c:pt idx="27">
                    <c:v>796.2658276068056</c:v>
                  </c:pt>
                  <c:pt idx="28">
                    <c:v>2695.298993555026</c:v>
                  </c:pt>
                  <c:pt idx="29">
                    <c:v>993.2121257074278</c:v>
                  </c:pt>
                  <c:pt idx="30">
                    <c:v>768.2783435217125</c:v>
                  </c:pt>
                  <c:pt idx="31">
                    <c:v>1263.40168028663</c:v>
                  </c:pt>
                  <c:pt idx="32">
                    <c:v>2592.318981116442</c:v>
                  </c:pt>
                  <c:pt idx="33">
                    <c:v>791.8816039765966</c:v>
                  </c:pt>
                  <c:pt idx="34">
                    <c:v>907.78279406475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10:$Y$244</c:f>
              <c:strCache>
                <c:ptCount val="35"/>
                <c:pt idx="0">
                  <c:v>TG 46:1</c:v>
                </c:pt>
                <c:pt idx="1">
                  <c:v>TG 48:1</c:v>
                </c:pt>
                <c:pt idx="2">
                  <c:v>TG 48:2</c:v>
                </c:pt>
                <c:pt idx="3">
                  <c:v>TG 48:3</c:v>
                </c:pt>
                <c:pt idx="4">
                  <c:v>TG 50:1</c:v>
                </c:pt>
                <c:pt idx="5">
                  <c:v>TG 50:2</c:v>
                </c:pt>
                <c:pt idx="6">
                  <c:v>TG 50:3</c:v>
                </c:pt>
                <c:pt idx="7">
                  <c:v>TG 51:1</c:v>
                </c:pt>
                <c:pt idx="8">
                  <c:v>TG 51:2</c:v>
                </c:pt>
                <c:pt idx="9">
                  <c:v>TG 51:3</c:v>
                </c:pt>
                <c:pt idx="10">
                  <c:v>TG 52:0</c:v>
                </c:pt>
                <c:pt idx="11">
                  <c:v>TG 52:1</c:v>
                </c:pt>
                <c:pt idx="12">
                  <c:v>TG 52:2</c:v>
                </c:pt>
                <c:pt idx="13">
                  <c:v>TG 52:3</c:v>
                </c:pt>
                <c:pt idx="14">
                  <c:v>TG 52:4</c:v>
                </c:pt>
                <c:pt idx="15">
                  <c:v>TG 53:2</c:v>
                </c:pt>
                <c:pt idx="16">
                  <c:v>TG 53:3</c:v>
                </c:pt>
                <c:pt idx="17">
                  <c:v>TG 54:1</c:v>
                </c:pt>
                <c:pt idx="18">
                  <c:v>TG 54:2</c:v>
                </c:pt>
                <c:pt idx="19">
                  <c:v>TG 54:3</c:v>
                </c:pt>
                <c:pt idx="20">
                  <c:v>TG 54:4</c:v>
                </c:pt>
                <c:pt idx="21">
                  <c:v>TG 54:5</c:v>
                </c:pt>
                <c:pt idx="22">
                  <c:v>TG 54:6</c:v>
                </c:pt>
                <c:pt idx="23">
                  <c:v>TG 54:7</c:v>
                </c:pt>
                <c:pt idx="24">
                  <c:v>TG 55:3</c:v>
                </c:pt>
                <c:pt idx="25">
                  <c:v>TG 56:3</c:v>
                </c:pt>
                <c:pt idx="26">
                  <c:v>TG 56:6</c:v>
                </c:pt>
                <c:pt idx="27">
                  <c:v>TG 56:7A</c:v>
                </c:pt>
                <c:pt idx="28">
                  <c:v>TG 56:7B</c:v>
                </c:pt>
                <c:pt idx="29">
                  <c:v>TG 56:8</c:v>
                </c:pt>
                <c:pt idx="30">
                  <c:v>TG 58:3</c:v>
                </c:pt>
                <c:pt idx="31">
                  <c:v>TG 58:6</c:v>
                </c:pt>
                <c:pt idx="32">
                  <c:v>TG 58:8</c:v>
                </c:pt>
                <c:pt idx="33">
                  <c:v>TG 58:9</c:v>
                </c:pt>
                <c:pt idx="34">
                  <c:v>TG 60:3</c:v>
                </c:pt>
              </c:strCache>
            </c:strRef>
          </c:cat>
          <c:val>
            <c:numRef>
              <c:f>'Dharmafect Species'!$Z$210:$Z$244</c:f>
              <c:numCache>
                <c:formatCode>General</c:formatCode>
                <c:ptCount val="35"/>
                <c:pt idx="0">
                  <c:v>46031.5074534153</c:v>
                </c:pt>
                <c:pt idx="1">
                  <c:v>206190.9636213417</c:v>
                </c:pt>
                <c:pt idx="2">
                  <c:v>52932.2409599771</c:v>
                </c:pt>
                <c:pt idx="3">
                  <c:v>5054.428141276042</c:v>
                </c:pt>
                <c:pt idx="4">
                  <c:v>482934.8496581723</c:v>
                </c:pt>
                <c:pt idx="5">
                  <c:v>242444.4469553147</c:v>
                </c:pt>
                <c:pt idx="6">
                  <c:v>31259.17651925962</c:v>
                </c:pt>
                <c:pt idx="7">
                  <c:v>19643.78868873357</c:v>
                </c:pt>
                <c:pt idx="8">
                  <c:v>33539.59068175126</c:v>
                </c:pt>
                <c:pt idx="9">
                  <c:v>7067.969656548537</c:v>
                </c:pt>
                <c:pt idx="10">
                  <c:v>20406.2867838542</c:v>
                </c:pt>
                <c:pt idx="11">
                  <c:v>85780.37308650842</c:v>
                </c:pt>
                <c:pt idx="12">
                  <c:v>608073.0804132958</c:v>
                </c:pt>
                <c:pt idx="13">
                  <c:v>118695.36856806</c:v>
                </c:pt>
                <c:pt idx="14">
                  <c:v>13451.91544596355</c:v>
                </c:pt>
                <c:pt idx="15">
                  <c:v>19080.29198772127</c:v>
                </c:pt>
                <c:pt idx="16">
                  <c:v>15991.84793141298</c:v>
                </c:pt>
                <c:pt idx="17">
                  <c:v>10755.00074724301</c:v>
                </c:pt>
                <c:pt idx="18">
                  <c:v>80294.11138448896</c:v>
                </c:pt>
                <c:pt idx="19">
                  <c:v>247650.1513904973</c:v>
                </c:pt>
                <c:pt idx="20">
                  <c:v>29197.66053919268</c:v>
                </c:pt>
                <c:pt idx="21">
                  <c:v>22198.11466471357</c:v>
                </c:pt>
                <c:pt idx="22">
                  <c:v>7045.969970703128</c:v>
                </c:pt>
                <c:pt idx="23">
                  <c:v>5467.138020833336</c:v>
                </c:pt>
                <c:pt idx="24">
                  <c:v>7592.715194702148</c:v>
                </c:pt>
                <c:pt idx="25">
                  <c:v>23891.46829485742</c:v>
                </c:pt>
                <c:pt idx="26">
                  <c:v>26647.82881673178</c:v>
                </c:pt>
                <c:pt idx="27">
                  <c:v>5853.059010823567</c:v>
                </c:pt>
                <c:pt idx="28">
                  <c:v>18431.58834838866</c:v>
                </c:pt>
                <c:pt idx="29">
                  <c:v>4276.756245930988</c:v>
                </c:pt>
                <c:pt idx="30">
                  <c:v>5506.920687357585</c:v>
                </c:pt>
                <c:pt idx="31">
                  <c:v>6101.497528076172</c:v>
                </c:pt>
                <c:pt idx="32">
                  <c:v>10551.73927815756</c:v>
                </c:pt>
                <c:pt idx="33">
                  <c:v>4382.31229909261</c:v>
                </c:pt>
                <c:pt idx="34">
                  <c:v>5031.1214612904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103-418D-82AA-16F508F97749}"/>
            </c:ext>
          </c:extLst>
        </c:ser>
        <c:ser>
          <c:idx val="1"/>
          <c:order val="1"/>
          <c:tx>
            <c:strRef>
              <c:f>'Dharmafect Species'!$AA$209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210:$AF$244</c:f>
                <c:numCache>
                  <c:formatCode>General</c:formatCode>
                  <c:ptCount val="35"/>
                  <c:pt idx="0">
                    <c:v>4012.3946020949</c:v>
                  </c:pt>
                  <c:pt idx="1">
                    <c:v>26168.99681048864</c:v>
                  </c:pt>
                  <c:pt idx="2">
                    <c:v>4961.13888588277</c:v>
                  </c:pt>
                  <c:pt idx="3">
                    <c:v>548.3990635593045</c:v>
                  </c:pt>
                  <c:pt idx="4">
                    <c:v>74917.05681583661</c:v>
                  </c:pt>
                  <c:pt idx="5">
                    <c:v>32535.02429162537</c:v>
                  </c:pt>
                  <c:pt idx="6">
                    <c:v>3122.234800591671</c:v>
                  </c:pt>
                  <c:pt idx="7">
                    <c:v>2262.729586986081</c:v>
                  </c:pt>
                  <c:pt idx="8">
                    <c:v>4133.459719295722</c:v>
                  </c:pt>
                  <c:pt idx="9">
                    <c:v>853.5208929352516</c:v>
                  </c:pt>
                  <c:pt idx="10">
                    <c:v>3063.235602333164</c:v>
                  </c:pt>
                  <c:pt idx="11">
                    <c:v>13572.91734357553</c:v>
                  </c:pt>
                  <c:pt idx="12">
                    <c:v>90344.91648425476</c:v>
                  </c:pt>
                  <c:pt idx="13">
                    <c:v>17581.41908285236</c:v>
                  </c:pt>
                  <c:pt idx="14">
                    <c:v>2140.17119149348</c:v>
                  </c:pt>
                  <c:pt idx="15">
                    <c:v>2984.372806476854</c:v>
                  </c:pt>
                  <c:pt idx="16">
                    <c:v>2544.935103011796</c:v>
                  </c:pt>
                  <c:pt idx="17">
                    <c:v>1897.050163342888</c:v>
                  </c:pt>
                  <c:pt idx="18">
                    <c:v>12987.38664701676</c:v>
                  </c:pt>
                  <c:pt idx="19">
                    <c:v>42910.66263562933</c:v>
                  </c:pt>
                  <c:pt idx="20">
                    <c:v>4583.230247203676</c:v>
                  </c:pt>
                  <c:pt idx="21">
                    <c:v>2424.24473886985</c:v>
                  </c:pt>
                  <c:pt idx="22">
                    <c:v>533.9612577692153</c:v>
                  </c:pt>
                  <c:pt idx="23">
                    <c:v>757.12873072934</c:v>
                  </c:pt>
                  <c:pt idx="24">
                    <c:v>1588.229198982538</c:v>
                  </c:pt>
                  <c:pt idx="25">
                    <c:v>3625.339107739441</c:v>
                  </c:pt>
                  <c:pt idx="26">
                    <c:v>4083.267465959599</c:v>
                  </c:pt>
                  <c:pt idx="27">
                    <c:v>791.9595638716489</c:v>
                  </c:pt>
                  <c:pt idx="28">
                    <c:v>2504.456825458836</c:v>
                  </c:pt>
                  <c:pt idx="29">
                    <c:v>671.5319262939271</c:v>
                  </c:pt>
                  <c:pt idx="30">
                    <c:v>1136.248297242475</c:v>
                  </c:pt>
                  <c:pt idx="31">
                    <c:v>1050.197826555728</c:v>
                  </c:pt>
                  <c:pt idx="32">
                    <c:v>1988.231382244683</c:v>
                  </c:pt>
                  <c:pt idx="33">
                    <c:v>835.4356054381656</c:v>
                  </c:pt>
                  <c:pt idx="34">
                    <c:v>746.3970666465781</c:v>
                  </c:pt>
                </c:numCache>
              </c:numRef>
            </c:plus>
            <c:minus>
              <c:numRef>
                <c:f>'Dharmafect Species'!$AF$210:$AF$244</c:f>
                <c:numCache>
                  <c:formatCode>General</c:formatCode>
                  <c:ptCount val="35"/>
                  <c:pt idx="0">
                    <c:v>4012.3946020949</c:v>
                  </c:pt>
                  <c:pt idx="1">
                    <c:v>26168.99681048864</c:v>
                  </c:pt>
                  <c:pt idx="2">
                    <c:v>4961.13888588277</c:v>
                  </c:pt>
                  <c:pt idx="3">
                    <c:v>548.3990635593045</c:v>
                  </c:pt>
                  <c:pt idx="4">
                    <c:v>74917.05681583661</c:v>
                  </c:pt>
                  <c:pt idx="5">
                    <c:v>32535.02429162537</c:v>
                  </c:pt>
                  <c:pt idx="6">
                    <c:v>3122.234800591671</c:v>
                  </c:pt>
                  <c:pt idx="7">
                    <c:v>2262.729586986081</c:v>
                  </c:pt>
                  <c:pt idx="8">
                    <c:v>4133.459719295722</c:v>
                  </c:pt>
                  <c:pt idx="9">
                    <c:v>853.5208929352516</c:v>
                  </c:pt>
                  <c:pt idx="10">
                    <c:v>3063.235602333164</c:v>
                  </c:pt>
                  <c:pt idx="11">
                    <c:v>13572.91734357553</c:v>
                  </c:pt>
                  <c:pt idx="12">
                    <c:v>90344.91648425476</c:v>
                  </c:pt>
                  <c:pt idx="13">
                    <c:v>17581.41908285236</c:v>
                  </c:pt>
                  <c:pt idx="14">
                    <c:v>2140.17119149348</c:v>
                  </c:pt>
                  <c:pt idx="15">
                    <c:v>2984.372806476854</c:v>
                  </c:pt>
                  <c:pt idx="16">
                    <c:v>2544.935103011796</c:v>
                  </c:pt>
                  <c:pt idx="17">
                    <c:v>1897.050163342888</c:v>
                  </c:pt>
                  <c:pt idx="18">
                    <c:v>12987.38664701676</c:v>
                  </c:pt>
                  <c:pt idx="19">
                    <c:v>42910.66263562933</c:v>
                  </c:pt>
                  <c:pt idx="20">
                    <c:v>4583.230247203676</c:v>
                  </c:pt>
                  <c:pt idx="21">
                    <c:v>2424.24473886985</c:v>
                  </c:pt>
                  <c:pt idx="22">
                    <c:v>533.9612577692153</c:v>
                  </c:pt>
                  <c:pt idx="23">
                    <c:v>757.12873072934</c:v>
                  </c:pt>
                  <c:pt idx="24">
                    <c:v>1588.229198982538</c:v>
                  </c:pt>
                  <c:pt idx="25">
                    <c:v>3625.339107739441</c:v>
                  </c:pt>
                  <c:pt idx="26">
                    <c:v>4083.267465959599</c:v>
                  </c:pt>
                  <c:pt idx="27">
                    <c:v>791.9595638716489</c:v>
                  </c:pt>
                  <c:pt idx="28">
                    <c:v>2504.456825458836</c:v>
                  </c:pt>
                  <c:pt idx="29">
                    <c:v>671.5319262939271</c:v>
                  </c:pt>
                  <c:pt idx="30">
                    <c:v>1136.248297242475</c:v>
                  </c:pt>
                  <c:pt idx="31">
                    <c:v>1050.197826555728</c:v>
                  </c:pt>
                  <c:pt idx="32">
                    <c:v>1988.231382244683</c:v>
                  </c:pt>
                  <c:pt idx="33">
                    <c:v>835.4356054381656</c:v>
                  </c:pt>
                  <c:pt idx="34">
                    <c:v>746.39706664657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10:$Y$244</c:f>
              <c:strCache>
                <c:ptCount val="35"/>
                <c:pt idx="0">
                  <c:v>TG 46:1</c:v>
                </c:pt>
                <c:pt idx="1">
                  <c:v>TG 48:1</c:v>
                </c:pt>
                <c:pt idx="2">
                  <c:v>TG 48:2</c:v>
                </c:pt>
                <c:pt idx="3">
                  <c:v>TG 48:3</c:v>
                </c:pt>
                <c:pt idx="4">
                  <c:v>TG 50:1</c:v>
                </c:pt>
                <c:pt idx="5">
                  <c:v>TG 50:2</c:v>
                </c:pt>
                <c:pt idx="6">
                  <c:v>TG 50:3</c:v>
                </c:pt>
                <c:pt idx="7">
                  <c:v>TG 51:1</c:v>
                </c:pt>
                <c:pt idx="8">
                  <c:v>TG 51:2</c:v>
                </c:pt>
                <c:pt idx="9">
                  <c:v>TG 51:3</c:v>
                </c:pt>
                <c:pt idx="10">
                  <c:v>TG 52:0</c:v>
                </c:pt>
                <c:pt idx="11">
                  <c:v>TG 52:1</c:v>
                </c:pt>
                <c:pt idx="12">
                  <c:v>TG 52:2</c:v>
                </c:pt>
                <c:pt idx="13">
                  <c:v>TG 52:3</c:v>
                </c:pt>
                <c:pt idx="14">
                  <c:v>TG 52:4</c:v>
                </c:pt>
                <c:pt idx="15">
                  <c:v>TG 53:2</c:v>
                </c:pt>
                <c:pt idx="16">
                  <c:v>TG 53:3</c:v>
                </c:pt>
                <c:pt idx="17">
                  <c:v>TG 54:1</c:v>
                </c:pt>
                <c:pt idx="18">
                  <c:v>TG 54:2</c:v>
                </c:pt>
                <c:pt idx="19">
                  <c:v>TG 54:3</c:v>
                </c:pt>
                <c:pt idx="20">
                  <c:v>TG 54:4</c:v>
                </c:pt>
                <c:pt idx="21">
                  <c:v>TG 54:5</c:v>
                </c:pt>
                <c:pt idx="22">
                  <c:v>TG 54:6</c:v>
                </c:pt>
                <c:pt idx="23">
                  <c:v>TG 54:7</c:v>
                </c:pt>
                <c:pt idx="24">
                  <c:v>TG 55:3</c:v>
                </c:pt>
                <c:pt idx="25">
                  <c:v>TG 56:3</c:v>
                </c:pt>
                <c:pt idx="26">
                  <c:v>TG 56:6</c:v>
                </c:pt>
                <c:pt idx="27">
                  <c:v>TG 56:7A</c:v>
                </c:pt>
                <c:pt idx="28">
                  <c:v>TG 56:7B</c:v>
                </c:pt>
                <c:pt idx="29">
                  <c:v>TG 56:8</c:v>
                </c:pt>
                <c:pt idx="30">
                  <c:v>TG 58:3</c:v>
                </c:pt>
                <c:pt idx="31">
                  <c:v>TG 58:6</c:v>
                </c:pt>
                <c:pt idx="32">
                  <c:v>TG 58:8</c:v>
                </c:pt>
                <c:pt idx="33">
                  <c:v>TG 58:9</c:v>
                </c:pt>
                <c:pt idx="34">
                  <c:v>TG 60:3</c:v>
                </c:pt>
              </c:strCache>
            </c:strRef>
          </c:cat>
          <c:val>
            <c:numRef>
              <c:f>'Dharmafect Species'!$AA$210:$AA$244</c:f>
              <c:numCache>
                <c:formatCode>General</c:formatCode>
                <c:ptCount val="35"/>
                <c:pt idx="0">
                  <c:v>40375.59078362627</c:v>
                </c:pt>
                <c:pt idx="1">
                  <c:v>174182.3138946951</c:v>
                </c:pt>
                <c:pt idx="2">
                  <c:v>52434.72155448053</c:v>
                </c:pt>
                <c:pt idx="3">
                  <c:v>5990.633227030437</c:v>
                </c:pt>
                <c:pt idx="4">
                  <c:v>408301.3506937479</c:v>
                </c:pt>
                <c:pt idx="5">
                  <c:v>241875.0390252945</c:v>
                </c:pt>
                <c:pt idx="6">
                  <c:v>35623.29543045619</c:v>
                </c:pt>
                <c:pt idx="7">
                  <c:v>17791.91412850156</c:v>
                </c:pt>
                <c:pt idx="8">
                  <c:v>33178.21885866827</c:v>
                </c:pt>
                <c:pt idx="9">
                  <c:v>8530.989693151405</c:v>
                </c:pt>
                <c:pt idx="10">
                  <c:v>21158.12093098957</c:v>
                </c:pt>
                <c:pt idx="11">
                  <c:v>82657.73093330614</c:v>
                </c:pt>
                <c:pt idx="12">
                  <c:v>559639.46521661</c:v>
                </c:pt>
                <c:pt idx="13">
                  <c:v>131312.9315085972</c:v>
                </c:pt>
                <c:pt idx="14">
                  <c:v>15716.6338297526</c:v>
                </c:pt>
                <c:pt idx="15">
                  <c:v>18803.94471737675</c:v>
                </c:pt>
                <c:pt idx="16">
                  <c:v>17995.80188456365</c:v>
                </c:pt>
                <c:pt idx="17">
                  <c:v>11495.4070755826</c:v>
                </c:pt>
                <c:pt idx="18">
                  <c:v>74971.01391376634</c:v>
                </c:pt>
                <c:pt idx="19">
                  <c:v>252259.4298190645</c:v>
                </c:pt>
                <c:pt idx="20">
                  <c:v>33268.56495471366</c:v>
                </c:pt>
                <c:pt idx="21">
                  <c:v>31148.53535970053</c:v>
                </c:pt>
                <c:pt idx="22">
                  <c:v>10533.97680664065</c:v>
                </c:pt>
                <c:pt idx="23">
                  <c:v>9172.76076253256</c:v>
                </c:pt>
                <c:pt idx="24">
                  <c:v>7932.633387247716</c:v>
                </c:pt>
                <c:pt idx="25">
                  <c:v>22420.88054427218</c:v>
                </c:pt>
                <c:pt idx="26">
                  <c:v>40504.48999023438</c:v>
                </c:pt>
                <c:pt idx="27">
                  <c:v>10210.24654134116</c:v>
                </c:pt>
                <c:pt idx="28">
                  <c:v>28790.71990966798</c:v>
                </c:pt>
                <c:pt idx="29">
                  <c:v>7453.460327148438</c:v>
                </c:pt>
                <c:pt idx="30">
                  <c:v>5310.79337819417</c:v>
                </c:pt>
                <c:pt idx="31">
                  <c:v>9732.14717610677</c:v>
                </c:pt>
                <c:pt idx="32">
                  <c:v>17124.31042480468</c:v>
                </c:pt>
                <c:pt idx="33">
                  <c:v>8187.059377034503</c:v>
                </c:pt>
                <c:pt idx="34">
                  <c:v>5420.1414261414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103-418D-82AA-16F508F97749}"/>
            </c:ext>
          </c:extLst>
        </c:ser>
        <c:ser>
          <c:idx val="2"/>
          <c:order val="2"/>
          <c:tx>
            <c:strRef>
              <c:f>'Dharmafect Species'!$AB$209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210:$AG$244</c:f>
                <c:numCache>
                  <c:formatCode>General</c:formatCode>
                  <c:ptCount val="35"/>
                  <c:pt idx="0">
                    <c:v>4021.359801087357</c:v>
                  </c:pt>
                  <c:pt idx="1">
                    <c:v>23593.79355686457</c:v>
                  </c:pt>
                  <c:pt idx="2">
                    <c:v>4052.635061760631</c:v>
                  </c:pt>
                  <c:pt idx="3">
                    <c:v>535.4694260245454</c:v>
                  </c:pt>
                  <c:pt idx="4">
                    <c:v>72414.88022374603</c:v>
                  </c:pt>
                  <c:pt idx="5">
                    <c:v>31022.60486331232</c:v>
                  </c:pt>
                  <c:pt idx="6">
                    <c:v>3481.609031017485</c:v>
                  </c:pt>
                  <c:pt idx="7">
                    <c:v>3359.954828345854</c:v>
                  </c:pt>
                  <c:pt idx="8">
                    <c:v>5142.58824616981</c:v>
                  </c:pt>
                  <c:pt idx="9">
                    <c:v>980.9672234219649</c:v>
                  </c:pt>
                  <c:pt idx="10">
                    <c:v>5880.703195772983</c:v>
                  </c:pt>
                  <c:pt idx="11">
                    <c:v>19053.82432644237</c:v>
                  </c:pt>
                  <c:pt idx="12">
                    <c:v>89366.41494619196</c:v>
                  </c:pt>
                  <c:pt idx="13">
                    <c:v>16874.64021600259</c:v>
                  </c:pt>
                  <c:pt idx="14">
                    <c:v>2758.508523851393</c:v>
                  </c:pt>
                  <c:pt idx="15">
                    <c:v>3829.208426867389</c:v>
                  </c:pt>
                  <c:pt idx="16">
                    <c:v>2771.917766562006</c:v>
                  </c:pt>
                  <c:pt idx="17">
                    <c:v>3264.668607423564</c:v>
                  </c:pt>
                  <c:pt idx="18">
                    <c:v>15515.55004113134</c:v>
                  </c:pt>
                  <c:pt idx="19">
                    <c:v>37965.67132006067</c:v>
                  </c:pt>
                  <c:pt idx="20">
                    <c:v>4761.985794907417</c:v>
                  </c:pt>
                  <c:pt idx="21">
                    <c:v>7283.959894712147</c:v>
                  </c:pt>
                  <c:pt idx="22">
                    <c:v>2417.83255021689</c:v>
                  </c:pt>
                  <c:pt idx="23">
                    <c:v>2078.546285220805</c:v>
                  </c:pt>
                  <c:pt idx="24">
                    <c:v>1043.25507628947</c:v>
                  </c:pt>
                  <c:pt idx="25">
                    <c:v>3914.568703774441</c:v>
                  </c:pt>
                  <c:pt idx="26">
                    <c:v>11384.09953240552</c:v>
                  </c:pt>
                  <c:pt idx="27">
                    <c:v>1906.92755776192</c:v>
                  </c:pt>
                  <c:pt idx="28">
                    <c:v>9558.444250286755</c:v>
                  </c:pt>
                  <c:pt idx="29">
                    <c:v>1949.871298303101</c:v>
                  </c:pt>
                  <c:pt idx="30">
                    <c:v>601.3858886615794</c:v>
                  </c:pt>
                  <c:pt idx="31">
                    <c:v>2585.081414014972</c:v>
                  </c:pt>
                  <c:pt idx="32">
                    <c:v>5533.787694452036</c:v>
                  </c:pt>
                  <c:pt idx="33">
                    <c:v>1448.789311500825</c:v>
                  </c:pt>
                  <c:pt idx="34">
                    <c:v>625.7740927043042</c:v>
                  </c:pt>
                </c:numCache>
              </c:numRef>
            </c:plus>
            <c:minus>
              <c:numRef>
                <c:f>'Dharmafect Species'!$AG$210:$AG$244</c:f>
                <c:numCache>
                  <c:formatCode>General</c:formatCode>
                  <c:ptCount val="35"/>
                  <c:pt idx="0">
                    <c:v>4021.359801087357</c:v>
                  </c:pt>
                  <c:pt idx="1">
                    <c:v>23593.79355686457</c:v>
                  </c:pt>
                  <c:pt idx="2">
                    <c:v>4052.635061760631</c:v>
                  </c:pt>
                  <c:pt idx="3">
                    <c:v>535.4694260245454</c:v>
                  </c:pt>
                  <c:pt idx="4">
                    <c:v>72414.88022374603</c:v>
                  </c:pt>
                  <c:pt idx="5">
                    <c:v>31022.60486331232</c:v>
                  </c:pt>
                  <c:pt idx="6">
                    <c:v>3481.609031017485</c:v>
                  </c:pt>
                  <c:pt idx="7">
                    <c:v>3359.954828345854</c:v>
                  </c:pt>
                  <c:pt idx="8">
                    <c:v>5142.58824616981</c:v>
                  </c:pt>
                  <c:pt idx="9">
                    <c:v>980.9672234219649</c:v>
                  </c:pt>
                  <c:pt idx="10">
                    <c:v>5880.703195772983</c:v>
                  </c:pt>
                  <c:pt idx="11">
                    <c:v>19053.82432644237</c:v>
                  </c:pt>
                  <c:pt idx="12">
                    <c:v>89366.41494619196</c:v>
                  </c:pt>
                  <c:pt idx="13">
                    <c:v>16874.64021600259</c:v>
                  </c:pt>
                  <c:pt idx="14">
                    <c:v>2758.508523851393</c:v>
                  </c:pt>
                  <c:pt idx="15">
                    <c:v>3829.208426867389</c:v>
                  </c:pt>
                  <c:pt idx="16">
                    <c:v>2771.917766562006</c:v>
                  </c:pt>
                  <c:pt idx="17">
                    <c:v>3264.668607423564</c:v>
                  </c:pt>
                  <c:pt idx="18">
                    <c:v>15515.55004113134</c:v>
                  </c:pt>
                  <c:pt idx="19">
                    <c:v>37965.67132006067</c:v>
                  </c:pt>
                  <c:pt idx="20">
                    <c:v>4761.985794907417</c:v>
                  </c:pt>
                  <c:pt idx="21">
                    <c:v>7283.959894712147</c:v>
                  </c:pt>
                  <c:pt idx="22">
                    <c:v>2417.83255021689</c:v>
                  </c:pt>
                  <c:pt idx="23">
                    <c:v>2078.546285220805</c:v>
                  </c:pt>
                  <c:pt idx="24">
                    <c:v>1043.25507628947</c:v>
                  </c:pt>
                  <c:pt idx="25">
                    <c:v>3914.568703774441</c:v>
                  </c:pt>
                  <c:pt idx="26">
                    <c:v>11384.09953240552</c:v>
                  </c:pt>
                  <c:pt idx="27">
                    <c:v>1906.92755776192</c:v>
                  </c:pt>
                  <c:pt idx="28">
                    <c:v>9558.444250286755</c:v>
                  </c:pt>
                  <c:pt idx="29">
                    <c:v>1949.871298303101</c:v>
                  </c:pt>
                  <c:pt idx="30">
                    <c:v>601.3858886615794</c:v>
                  </c:pt>
                  <c:pt idx="31">
                    <c:v>2585.081414014972</c:v>
                  </c:pt>
                  <c:pt idx="32">
                    <c:v>5533.787694452036</c:v>
                  </c:pt>
                  <c:pt idx="33">
                    <c:v>1448.789311500825</c:v>
                  </c:pt>
                  <c:pt idx="34">
                    <c:v>625.77409270430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10:$Y$244</c:f>
              <c:strCache>
                <c:ptCount val="35"/>
                <c:pt idx="0">
                  <c:v>TG 46:1</c:v>
                </c:pt>
                <c:pt idx="1">
                  <c:v>TG 48:1</c:v>
                </c:pt>
                <c:pt idx="2">
                  <c:v>TG 48:2</c:v>
                </c:pt>
                <c:pt idx="3">
                  <c:v>TG 48:3</c:v>
                </c:pt>
                <c:pt idx="4">
                  <c:v>TG 50:1</c:v>
                </c:pt>
                <c:pt idx="5">
                  <c:v>TG 50:2</c:v>
                </c:pt>
                <c:pt idx="6">
                  <c:v>TG 50:3</c:v>
                </c:pt>
                <c:pt idx="7">
                  <c:v>TG 51:1</c:v>
                </c:pt>
                <c:pt idx="8">
                  <c:v>TG 51:2</c:v>
                </c:pt>
                <c:pt idx="9">
                  <c:v>TG 51:3</c:v>
                </c:pt>
                <c:pt idx="10">
                  <c:v>TG 52:0</c:v>
                </c:pt>
                <c:pt idx="11">
                  <c:v>TG 52:1</c:v>
                </c:pt>
                <c:pt idx="12">
                  <c:v>TG 52:2</c:v>
                </c:pt>
                <c:pt idx="13">
                  <c:v>TG 52:3</c:v>
                </c:pt>
                <c:pt idx="14">
                  <c:v>TG 52:4</c:v>
                </c:pt>
                <c:pt idx="15">
                  <c:v>TG 53:2</c:v>
                </c:pt>
                <c:pt idx="16">
                  <c:v>TG 53:3</c:v>
                </c:pt>
                <c:pt idx="17">
                  <c:v>TG 54:1</c:v>
                </c:pt>
                <c:pt idx="18">
                  <c:v>TG 54:2</c:v>
                </c:pt>
                <c:pt idx="19">
                  <c:v>TG 54:3</c:v>
                </c:pt>
                <c:pt idx="20">
                  <c:v>TG 54:4</c:v>
                </c:pt>
                <c:pt idx="21">
                  <c:v>TG 54:5</c:v>
                </c:pt>
                <c:pt idx="22">
                  <c:v>TG 54:6</c:v>
                </c:pt>
                <c:pt idx="23">
                  <c:v>TG 54:7</c:v>
                </c:pt>
                <c:pt idx="24">
                  <c:v>TG 55:3</c:v>
                </c:pt>
                <c:pt idx="25">
                  <c:v>TG 56:3</c:v>
                </c:pt>
                <c:pt idx="26">
                  <c:v>TG 56:6</c:v>
                </c:pt>
                <c:pt idx="27">
                  <c:v>TG 56:7A</c:v>
                </c:pt>
                <c:pt idx="28">
                  <c:v>TG 56:7B</c:v>
                </c:pt>
                <c:pt idx="29">
                  <c:v>TG 56:8</c:v>
                </c:pt>
                <c:pt idx="30">
                  <c:v>TG 58:3</c:v>
                </c:pt>
                <c:pt idx="31">
                  <c:v>TG 58:6</c:v>
                </c:pt>
                <c:pt idx="32">
                  <c:v>TG 58:8</c:v>
                </c:pt>
                <c:pt idx="33">
                  <c:v>TG 58:9</c:v>
                </c:pt>
                <c:pt idx="34">
                  <c:v>TG 60:3</c:v>
                </c:pt>
              </c:strCache>
            </c:strRef>
          </c:cat>
          <c:val>
            <c:numRef>
              <c:f>'Dharmafect Species'!$AB$210:$AB$244</c:f>
              <c:numCache>
                <c:formatCode>General</c:formatCode>
                <c:ptCount val="35"/>
                <c:pt idx="0">
                  <c:v>24764.14257020378</c:v>
                </c:pt>
                <c:pt idx="1">
                  <c:v>104540.2708608792</c:v>
                </c:pt>
                <c:pt idx="2">
                  <c:v>28053.9089891757</c:v>
                </c:pt>
                <c:pt idx="3">
                  <c:v>3333.853736877445</c:v>
                </c:pt>
                <c:pt idx="4">
                  <c:v>255867.2756341428</c:v>
                </c:pt>
                <c:pt idx="5">
                  <c:v>131568.661961929</c:v>
                </c:pt>
                <c:pt idx="6">
                  <c:v>17887.0111837804</c:v>
                </c:pt>
                <c:pt idx="7">
                  <c:v>14303.91593740043</c:v>
                </c:pt>
                <c:pt idx="8">
                  <c:v>23542.2118587087</c:v>
                </c:pt>
                <c:pt idx="9">
                  <c:v>5438.590844835896</c:v>
                </c:pt>
                <c:pt idx="10">
                  <c:v>19318.76420084638</c:v>
                </c:pt>
                <c:pt idx="11">
                  <c:v>61343.92317064137</c:v>
                </c:pt>
                <c:pt idx="12">
                  <c:v>337971.2628432447</c:v>
                </c:pt>
                <c:pt idx="13">
                  <c:v>74061.72469521823</c:v>
                </c:pt>
                <c:pt idx="14">
                  <c:v>11825.82696533203</c:v>
                </c:pt>
                <c:pt idx="15">
                  <c:v>14262.47717466138</c:v>
                </c:pt>
                <c:pt idx="16">
                  <c:v>11336.29929609742</c:v>
                </c:pt>
                <c:pt idx="17">
                  <c:v>9137.974595959063</c:v>
                </c:pt>
                <c:pt idx="18">
                  <c:v>53557.61999606343</c:v>
                </c:pt>
                <c:pt idx="19">
                  <c:v>153707.9254754524</c:v>
                </c:pt>
                <c:pt idx="20">
                  <c:v>25132.74767109133</c:v>
                </c:pt>
                <c:pt idx="21">
                  <c:v>26337.50764973962</c:v>
                </c:pt>
                <c:pt idx="22">
                  <c:v>9442.004028320316</c:v>
                </c:pt>
                <c:pt idx="23">
                  <c:v>7883.51808675131</c:v>
                </c:pt>
                <c:pt idx="24">
                  <c:v>5978.587435404458</c:v>
                </c:pt>
                <c:pt idx="25">
                  <c:v>14382.57818398372</c:v>
                </c:pt>
                <c:pt idx="26">
                  <c:v>37355.27823893232</c:v>
                </c:pt>
                <c:pt idx="27">
                  <c:v>8672.827392578129</c:v>
                </c:pt>
                <c:pt idx="28">
                  <c:v>26867.02997843425</c:v>
                </c:pt>
                <c:pt idx="29">
                  <c:v>6779.819295247398</c:v>
                </c:pt>
                <c:pt idx="30">
                  <c:v>3428.55540974935</c:v>
                </c:pt>
                <c:pt idx="31">
                  <c:v>8799.732930501295</c:v>
                </c:pt>
                <c:pt idx="32">
                  <c:v>16352.31949869793</c:v>
                </c:pt>
                <c:pt idx="33">
                  <c:v>7880.19269816081</c:v>
                </c:pt>
                <c:pt idx="34">
                  <c:v>3659.4589137411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103-418D-82AA-16F508F977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43352120"/>
        <c:axId val="-2143348472"/>
      </c:barChart>
      <c:catAx>
        <c:axId val="-2143352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348472"/>
        <c:crosses val="autoZero"/>
        <c:auto val="1"/>
        <c:lblAlgn val="ctr"/>
        <c:lblOffset val="100"/>
        <c:noMultiLvlLbl val="0"/>
      </c:catAx>
      <c:valAx>
        <c:axId val="-21433484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352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249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250:$AE$254</c:f>
                <c:numCache>
                  <c:formatCode>General</c:formatCode>
                  <c:ptCount val="5"/>
                  <c:pt idx="0">
                    <c:v>4130.634737934806</c:v>
                  </c:pt>
                  <c:pt idx="1">
                    <c:v>1279.41802202853</c:v>
                  </c:pt>
                  <c:pt idx="2">
                    <c:v>3255.439461731137</c:v>
                  </c:pt>
                  <c:pt idx="3">
                    <c:v>8308.080760071186</c:v>
                  </c:pt>
                  <c:pt idx="4">
                    <c:v>2080.82339930855</c:v>
                  </c:pt>
                </c:numCache>
              </c:numRef>
            </c:plus>
            <c:minus>
              <c:numRef>
                <c:f>'Dharmafect Species'!$AE$250:$AE$254</c:f>
                <c:numCache>
                  <c:formatCode>General</c:formatCode>
                  <c:ptCount val="5"/>
                  <c:pt idx="0">
                    <c:v>4130.634737934806</c:v>
                  </c:pt>
                  <c:pt idx="1">
                    <c:v>1279.41802202853</c:v>
                  </c:pt>
                  <c:pt idx="2">
                    <c:v>3255.439461731137</c:v>
                  </c:pt>
                  <c:pt idx="3">
                    <c:v>8308.080760071186</c:v>
                  </c:pt>
                  <c:pt idx="4">
                    <c:v>2080.823399308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50:$Y$254</c:f>
              <c:strCache>
                <c:ptCount val="5"/>
                <c:pt idx="0">
                  <c:v>DG(36:2)</c:v>
                </c:pt>
                <c:pt idx="1">
                  <c:v>DG(36:1)</c:v>
                </c:pt>
                <c:pt idx="2">
                  <c:v>DG(34:2)</c:v>
                </c:pt>
                <c:pt idx="3">
                  <c:v>DG(34:1)</c:v>
                </c:pt>
                <c:pt idx="4">
                  <c:v>DG(32:1)</c:v>
                </c:pt>
              </c:strCache>
            </c:strRef>
          </c:cat>
          <c:val>
            <c:numRef>
              <c:f>'Dharmafect Species'!$Z$250:$Z$254</c:f>
              <c:numCache>
                <c:formatCode>General</c:formatCode>
                <c:ptCount val="5"/>
                <c:pt idx="0">
                  <c:v>36501.02788289385</c:v>
                </c:pt>
                <c:pt idx="1">
                  <c:v>13033.2933451335</c:v>
                </c:pt>
                <c:pt idx="2">
                  <c:v>20761.17407226564</c:v>
                </c:pt>
                <c:pt idx="3">
                  <c:v>87366.25263468416</c:v>
                </c:pt>
                <c:pt idx="4">
                  <c:v>40453.128148396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CFF-4C19-9183-FE1B03281A72}"/>
            </c:ext>
          </c:extLst>
        </c:ser>
        <c:ser>
          <c:idx val="1"/>
          <c:order val="1"/>
          <c:tx>
            <c:strRef>
              <c:f>'Dharmafect Species'!$AA$249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250:$AF$254</c:f>
                <c:numCache>
                  <c:formatCode>General</c:formatCode>
                  <c:ptCount val="5"/>
                  <c:pt idx="0">
                    <c:v>5992.4186654647</c:v>
                  </c:pt>
                  <c:pt idx="1">
                    <c:v>1805.46113481338</c:v>
                  </c:pt>
                  <c:pt idx="2">
                    <c:v>3818.1583249447</c:v>
                  </c:pt>
                  <c:pt idx="3">
                    <c:v>14787.75582321131</c:v>
                  </c:pt>
                  <c:pt idx="4">
                    <c:v>6397.27938347965</c:v>
                  </c:pt>
                </c:numCache>
              </c:numRef>
            </c:plus>
            <c:minus>
              <c:numRef>
                <c:f>'Dharmafect Species'!$AF$250:$AF$254</c:f>
                <c:numCache>
                  <c:formatCode>General</c:formatCode>
                  <c:ptCount val="5"/>
                  <c:pt idx="0">
                    <c:v>5992.4186654647</c:v>
                  </c:pt>
                  <c:pt idx="1">
                    <c:v>1805.46113481338</c:v>
                  </c:pt>
                  <c:pt idx="2">
                    <c:v>3818.1583249447</c:v>
                  </c:pt>
                  <c:pt idx="3">
                    <c:v>14787.75582321131</c:v>
                  </c:pt>
                  <c:pt idx="4">
                    <c:v>6397.279383479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50:$Y$254</c:f>
              <c:strCache>
                <c:ptCount val="5"/>
                <c:pt idx="0">
                  <c:v>DG(36:2)</c:v>
                </c:pt>
                <c:pt idx="1">
                  <c:v>DG(36:1)</c:v>
                </c:pt>
                <c:pt idx="2">
                  <c:v>DG(34:2)</c:v>
                </c:pt>
                <c:pt idx="3">
                  <c:v>DG(34:1)</c:v>
                </c:pt>
                <c:pt idx="4">
                  <c:v>DG(32:1)</c:v>
                </c:pt>
              </c:strCache>
            </c:strRef>
          </c:cat>
          <c:val>
            <c:numRef>
              <c:f>'Dharmafect Species'!$AA$250:$AA$254</c:f>
              <c:numCache>
                <c:formatCode>General</c:formatCode>
                <c:ptCount val="5"/>
                <c:pt idx="0">
                  <c:v>33349.82594807941</c:v>
                </c:pt>
                <c:pt idx="1">
                  <c:v>12301.57727813722</c:v>
                </c:pt>
                <c:pt idx="2">
                  <c:v>22041.7265930176</c:v>
                </c:pt>
                <c:pt idx="3">
                  <c:v>79166.70639038087</c:v>
                </c:pt>
                <c:pt idx="4">
                  <c:v>35819.913477579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CFF-4C19-9183-FE1B03281A72}"/>
            </c:ext>
          </c:extLst>
        </c:ser>
        <c:ser>
          <c:idx val="2"/>
          <c:order val="2"/>
          <c:tx>
            <c:strRef>
              <c:f>'Dharmafect Species'!$AB$249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250:$AG$254</c:f>
                <c:numCache>
                  <c:formatCode>General</c:formatCode>
                  <c:ptCount val="5"/>
                  <c:pt idx="0">
                    <c:v>4914.635792977204</c:v>
                  </c:pt>
                  <c:pt idx="1">
                    <c:v>1629.037528766838</c:v>
                  </c:pt>
                  <c:pt idx="2">
                    <c:v>3404.877795640917</c:v>
                  </c:pt>
                  <c:pt idx="3">
                    <c:v>14427.95953201293</c:v>
                  </c:pt>
                  <c:pt idx="4">
                    <c:v>7080.594907319944</c:v>
                  </c:pt>
                </c:numCache>
              </c:numRef>
            </c:plus>
            <c:minus>
              <c:numRef>
                <c:f>'Dharmafect Species'!$AG$250:$AG$254</c:f>
                <c:numCache>
                  <c:formatCode>General</c:formatCode>
                  <c:ptCount val="5"/>
                  <c:pt idx="0">
                    <c:v>4914.635792977204</c:v>
                  </c:pt>
                  <c:pt idx="1">
                    <c:v>1629.037528766838</c:v>
                  </c:pt>
                  <c:pt idx="2">
                    <c:v>3404.877795640917</c:v>
                  </c:pt>
                  <c:pt idx="3">
                    <c:v>14427.95953201293</c:v>
                  </c:pt>
                  <c:pt idx="4">
                    <c:v>7080.5949073199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50:$Y$254</c:f>
              <c:strCache>
                <c:ptCount val="5"/>
                <c:pt idx="0">
                  <c:v>DG(36:2)</c:v>
                </c:pt>
                <c:pt idx="1">
                  <c:v>DG(36:1)</c:v>
                </c:pt>
                <c:pt idx="2">
                  <c:v>DG(34:2)</c:v>
                </c:pt>
                <c:pt idx="3">
                  <c:v>DG(34:1)</c:v>
                </c:pt>
                <c:pt idx="4">
                  <c:v>DG(32:1)</c:v>
                </c:pt>
              </c:strCache>
            </c:strRef>
          </c:cat>
          <c:val>
            <c:numRef>
              <c:f>'Dharmafect Species'!$AB$250:$AB$254</c:f>
              <c:numCache>
                <c:formatCode>General</c:formatCode>
                <c:ptCount val="5"/>
                <c:pt idx="0">
                  <c:v>21378.20845540367</c:v>
                </c:pt>
                <c:pt idx="1">
                  <c:v>9346.104690551746</c:v>
                </c:pt>
                <c:pt idx="2">
                  <c:v>11396.49326578777</c:v>
                </c:pt>
                <c:pt idx="3">
                  <c:v>50177.46882120769</c:v>
                </c:pt>
                <c:pt idx="4">
                  <c:v>19882.909166971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CFF-4C19-9183-FE1B03281A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43968232"/>
        <c:axId val="-2143964536"/>
      </c:barChart>
      <c:catAx>
        <c:axId val="-2143968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964536"/>
        <c:crosses val="autoZero"/>
        <c:auto val="1"/>
        <c:lblAlgn val="ctr"/>
        <c:lblOffset val="100"/>
        <c:noMultiLvlLbl val="0"/>
      </c:catAx>
      <c:valAx>
        <c:axId val="-2143964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9682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28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29:$AG$77</c:f>
                <c:numCache>
                  <c:formatCode>General</c:formatCode>
                  <c:ptCount val="49"/>
                  <c:pt idx="0">
                    <c:v>543.8855628460276</c:v>
                  </c:pt>
                  <c:pt idx="1">
                    <c:v>78794.26340636345</c:v>
                  </c:pt>
                  <c:pt idx="2">
                    <c:v>26168.87327811781</c:v>
                  </c:pt>
                  <c:pt idx="3">
                    <c:v>196269.793659973</c:v>
                  </c:pt>
                  <c:pt idx="4">
                    <c:v>61985.92436016646</c:v>
                  </c:pt>
                  <c:pt idx="5">
                    <c:v>13833.41397637566</c:v>
                  </c:pt>
                  <c:pt idx="6">
                    <c:v>62675.50021500291</c:v>
                  </c:pt>
                  <c:pt idx="7">
                    <c:v>4532.128951885532</c:v>
                  </c:pt>
                  <c:pt idx="8">
                    <c:v>5471.954921056511</c:v>
                  </c:pt>
                  <c:pt idx="9">
                    <c:v>9027.22629041846</c:v>
                  </c:pt>
                  <c:pt idx="10">
                    <c:v>58041.6778781707</c:v>
                  </c:pt>
                  <c:pt idx="11">
                    <c:v>14338.4320493782</c:v>
                  </c:pt>
                  <c:pt idx="12">
                    <c:v>373083.8353438411</c:v>
                  </c:pt>
                  <c:pt idx="13">
                    <c:v>267158.4741695563</c:v>
                  </c:pt>
                  <c:pt idx="14">
                    <c:v>29137.69325991011</c:v>
                  </c:pt>
                  <c:pt idx="15">
                    <c:v>3812.403697500508</c:v>
                  </c:pt>
                  <c:pt idx="16">
                    <c:v>4789.899295473355</c:v>
                  </c:pt>
                  <c:pt idx="17">
                    <c:v>245810.4945386139</c:v>
                  </c:pt>
                  <c:pt idx="18">
                    <c:v>41737.61873605424</c:v>
                  </c:pt>
                  <c:pt idx="19">
                    <c:v>104722.8459692011</c:v>
                  </c:pt>
                  <c:pt idx="20">
                    <c:v>2737.117456947247</c:v>
                  </c:pt>
                  <c:pt idx="21">
                    <c:v>569.5650524869111</c:v>
                  </c:pt>
                  <c:pt idx="22">
                    <c:v>596.5292384509619</c:v>
                  </c:pt>
                  <c:pt idx="23">
                    <c:v>400.3731331669466</c:v>
                  </c:pt>
                  <c:pt idx="24">
                    <c:v>646.0958208259772</c:v>
                  </c:pt>
                  <c:pt idx="25">
                    <c:v>4333.333814836962</c:v>
                  </c:pt>
                  <c:pt idx="26">
                    <c:v>8727.668542204668</c:v>
                  </c:pt>
                  <c:pt idx="27">
                    <c:v>52400.44382044036</c:v>
                  </c:pt>
                  <c:pt idx="28">
                    <c:v>11991.75777468233</c:v>
                  </c:pt>
                  <c:pt idx="29">
                    <c:v>4501.464549373397</c:v>
                  </c:pt>
                  <c:pt idx="30">
                    <c:v>2219.98148058997</c:v>
                  </c:pt>
                  <c:pt idx="31">
                    <c:v>202585.94044342</c:v>
                  </c:pt>
                  <c:pt idx="32">
                    <c:v>202585.94044342</c:v>
                  </c:pt>
                  <c:pt idx="33">
                    <c:v>335052.7869806243</c:v>
                  </c:pt>
                  <c:pt idx="34">
                    <c:v>135281.0817129445</c:v>
                  </c:pt>
                  <c:pt idx="35">
                    <c:v>143338.3568342288</c:v>
                  </c:pt>
                  <c:pt idx="36">
                    <c:v>8224.069753554233</c:v>
                  </c:pt>
                  <c:pt idx="37">
                    <c:v>22446.60379489519</c:v>
                  </c:pt>
                  <c:pt idx="38">
                    <c:v>12717.02116610943</c:v>
                  </c:pt>
                  <c:pt idx="39">
                    <c:v>3187.131063482766</c:v>
                  </c:pt>
                  <c:pt idx="40">
                    <c:v>2904.085732808873</c:v>
                  </c:pt>
                  <c:pt idx="41">
                    <c:v>9721.5887111479</c:v>
                  </c:pt>
                  <c:pt idx="42">
                    <c:v>2522.940228836874</c:v>
                  </c:pt>
                  <c:pt idx="43">
                    <c:v>7613.446417549992</c:v>
                  </c:pt>
                  <c:pt idx="44">
                    <c:v>744.9338125124453</c:v>
                  </c:pt>
                  <c:pt idx="45">
                    <c:v>8505.796356276807</c:v>
                  </c:pt>
                  <c:pt idx="46">
                    <c:v>21782.75940495858</c:v>
                  </c:pt>
                  <c:pt idx="47">
                    <c:v>1198.473451442896</c:v>
                  </c:pt>
                  <c:pt idx="48">
                    <c:v>1123.563188621793</c:v>
                  </c:pt>
                </c:numCache>
              </c:numRef>
            </c:plus>
            <c:minus>
              <c:numRef>
                <c:f>'Dharmafect Species'!$AG$29:$AG$77</c:f>
                <c:numCache>
                  <c:formatCode>General</c:formatCode>
                  <c:ptCount val="49"/>
                  <c:pt idx="0">
                    <c:v>543.8855628460276</c:v>
                  </c:pt>
                  <c:pt idx="1">
                    <c:v>78794.26340636345</c:v>
                  </c:pt>
                  <c:pt idx="2">
                    <c:v>26168.87327811781</c:v>
                  </c:pt>
                  <c:pt idx="3">
                    <c:v>196269.793659973</c:v>
                  </c:pt>
                  <c:pt idx="4">
                    <c:v>61985.92436016646</c:v>
                  </c:pt>
                  <c:pt idx="5">
                    <c:v>13833.41397637566</c:v>
                  </c:pt>
                  <c:pt idx="6">
                    <c:v>62675.50021500291</c:v>
                  </c:pt>
                  <c:pt idx="7">
                    <c:v>4532.128951885532</c:v>
                  </c:pt>
                  <c:pt idx="8">
                    <c:v>5471.954921056511</c:v>
                  </c:pt>
                  <c:pt idx="9">
                    <c:v>9027.22629041846</c:v>
                  </c:pt>
                  <c:pt idx="10">
                    <c:v>58041.6778781707</c:v>
                  </c:pt>
                  <c:pt idx="11">
                    <c:v>14338.4320493782</c:v>
                  </c:pt>
                  <c:pt idx="12">
                    <c:v>373083.8353438411</c:v>
                  </c:pt>
                  <c:pt idx="13">
                    <c:v>267158.4741695563</c:v>
                  </c:pt>
                  <c:pt idx="14">
                    <c:v>29137.69325991011</c:v>
                  </c:pt>
                  <c:pt idx="15">
                    <c:v>3812.403697500508</c:v>
                  </c:pt>
                  <c:pt idx="16">
                    <c:v>4789.899295473355</c:v>
                  </c:pt>
                  <c:pt idx="17">
                    <c:v>245810.4945386139</c:v>
                  </c:pt>
                  <c:pt idx="18">
                    <c:v>41737.61873605424</c:v>
                  </c:pt>
                  <c:pt idx="19">
                    <c:v>104722.8459692011</c:v>
                  </c:pt>
                  <c:pt idx="20">
                    <c:v>2737.117456947247</c:v>
                  </c:pt>
                  <c:pt idx="21">
                    <c:v>569.5650524869111</c:v>
                  </c:pt>
                  <c:pt idx="22">
                    <c:v>596.5292384509619</c:v>
                  </c:pt>
                  <c:pt idx="23">
                    <c:v>400.3731331669466</c:v>
                  </c:pt>
                  <c:pt idx="24">
                    <c:v>646.0958208259772</c:v>
                  </c:pt>
                  <c:pt idx="25">
                    <c:v>4333.333814836962</c:v>
                  </c:pt>
                  <c:pt idx="26">
                    <c:v>8727.668542204668</c:v>
                  </c:pt>
                  <c:pt idx="27">
                    <c:v>52400.44382044036</c:v>
                  </c:pt>
                  <c:pt idx="28">
                    <c:v>11991.75777468233</c:v>
                  </c:pt>
                  <c:pt idx="29">
                    <c:v>4501.464549373397</c:v>
                  </c:pt>
                  <c:pt idx="30">
                    <c:v>2219.98148058997</c:v>
                  </c:pt>
                  <c:pt idx="31">
                    <c:v>202585.94044342</c:v>
                  </c:pt>
                  <c:pt idx="32">
                    <c:v>202585.94044342</c:v>
                  </c:pt>
                  <c:pt idx="33">
                    <c:v>335052.7869806243</c:v>
                  </c:pt>
                  <c:pt idx="34">
                    <c:v>135281.0817129445</c:v>
                  </c:pt>
                  <c:pt idx="35">
                    <c:v>143338.3568342288</c:v>
                  </c:pt>
                  <c:pt idx="36">
                    <c:v>8224.069753554233</c:v>
                  </c:pt>
                  <c:pt idx="37">
                    <c:v>22446.60379489519</c:v>
                  </c:pt>
                  <c:pt idx="38">
                    <c:v>12717.02116610943</c:v>
                  </c:pt>
                  <c:pt idx="39">
                    <c:v>3187.131063482766</c:v>
                  </c:pt>
                  <c:pt idx="40">
                    <c:v>2904.085732808873</c:v>
                  </c:pt>
                  <c:pt idx="41">
                    <c:v>9721.5887111479</c:v>
                  </c:pt>
                  <c:pt idx="42">
                    <c:v>2522.940228836874</c:v>
                  </c:pt>
                  <c:pt idx="43">
                    <c:v>7613.446417549992</c:v>
                  </c:pt>
                  <c:pt idx="44">
                    <c:v>744.9338125124453</c:v>
                  </c:pt>
                  <c:pt idx="45">
                    <c:v>8505.796356276807</c:v>
                  </c:pt>
                  <c:pt idx="46">
                    <c:v>21782.75940495858</c:v>
                  </c:pt>
                  <c:pt idx="47">
                    <c:v>1198.473451442896</c:v>
                  </c:pt>
                  <c:pt idx="48">
                    <c:v>1123.5631886217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9:$Y$77</c:f>
              <c:strCache>
                <c:ptCount val="49"/>
                <c:pt idx="0">
                  <c:v>LPE 16:0</c:v>
                </c:pt>
                <c:pt idx="1">
                  <c:v>PE 16:0_16:1</c:v>
                </c:pt>
                <c:pt idx="2">
                  <c:v>PE 16:0_18:0</c:v>
                </c:pt>
                <c:pt idx="3">
                  <c:v>PE 16:0_18:1</c:v>
                </c:pt>
                <c:pt idx="4">
                  <c:v>PE 16:0_20:4</c:v>
                </c:pt>
                <c:pt idx="5">
                  <c:v>PE 16:0_20:5</c:v>
                </c:pt>
                <c:pt idx="6">
                  <c:v>PE 16:1_18:1</c:v>
                </c:pt>
                <c:pt idx="7">
                  <c:v>PE 17:0_20:4</c:v>
                </c:pt>
                <c:pt idx="8">
                  <c:v>PE 18:0_20:2</c:v>
                </c:pt>
                <c:pt idx="9">
                  <c:v>PE 18:0_20:3</c:v>
                </c:pt>
                <c:pt idx="10">
                  <c:v>PE 18:0_20:5</c:v>
                </c:pt>
                <c:pt idx="11">
                  <c:v>PE 18:0_22:5</c:v>
                </c:pt>
                <c:pt idx="12">
                  <c:v>PE 18:0_22:6</c:v>
                </c:pt>
                <c:pt idx="13">
                  <c:v>PE 18:1_18:1</c:v>
                </c:pt>
                <c:pt idx="14">
                  <c:v>PE 18:1_18:2</c:v>
                </c:pt>
                <c:pt idx="15">
                  <c:v>PE 18:1_20:0</c:v>
                </c:pt>
                <c:pt idx="16">
                  <c:v>PE 18:1_20:1</c:v>
                </c:pt>
                <c:pt idx="17">
                  <c:v>PE 18:1_20:3</c:v>
                </c:pt>
                <c:pt idx="18">
                  <c:v>PE 18:1_20:5</c:v>
                </c:pt>
                <c:pt idx="19">
                  <c:v>PE 18:1_22:6</c:v>
                </c:pt>
                <c:pt idx="20">
                  <c:v>PE 20:1_20:3</c:v>
                </c:pt>
                <c:pt idx="21">
                  <c:v>PE 20:5_22:6</c:v>
                </c:pt>
                <c:pt idx="22">
                  <c:v>PE P-14:0_16:1</c:v>
                </c:pt>
                <c:pt idx="23">
                  <c:v>PE P-16:0_12:0 </c:v>
                </c:pt>
                <c:pt idx="24">
                  <c:v>PE P-16:0_14:1</c:v>
                </c:pt>
                <c:pt idx="25">
                  <c:v>PE P-16:0_16:0</c:v>
                </c:pt>
                <c:pt idx="26">
                  <c:v>PE P-16:0_16:1</c:v>
                </c:pt>
                <c:pt idx="27">
                  <c:v>PE P-16:0_18:1</c:v>
                </c:pt>
                <c:pt idx="28">
                  <c:v>PE P-16:0_18:2</c:v>
                </c:pt>
                <c:pt idx="29">
                  <c:v>PE P-16:0_20:3</c:v>
                </c:pt>
                <c:pt idx="30">
                  <c:v>PE P-16:0_20:3</c:v>
                </c:pt>
                <c:pt idx="31">
                  <c:v>PE P-16:0_20:4 A</c:v>
                </c:pt>
                <c:pt idx="32">
                  <c:v>PE P-16:0_20:4 B</c:v>
                </c:pt>
                <c:pt idx="33">
                  <c:v>PE P-16:0_20:5</c:v>
                </c:pt>
                <c:pt idx="34">
                  <c:v>PE P-16:0_22:5</c:v>
                </c:pt>
                <c:pt idx="35">
                  <c:v>PE P-16:0_22:6</c:v>
                </c:pt>
                <c:pt idx="36">
                  <c:v>PE P-17:0_18:1</c:v>
                </c:pt>
                <c:pt idx="37">
                  <c:v>PE P-17:0_20:4</c:v>
                </c:pt>
                <c:pt idx="38">
                  <c:v>PE P-17:0_22:6</c:v>
                </c:pt>
                <c:pt idx="39">
                  <c:v>PE P-18:0_16:0</c:v>
                </c:pt>
                <c:pt idx="40">
                  <c:v>PE P-18:0_16:0</c:v>
                </c:pt>
                <c:pt idx="41">
                  <c:v>PE P-18:0_18:1</c:v>
                </c:pt>
                <c:pt idx="42">
                  <c:v>PE P-18:0_18:1</c:v>
                </c:pt>
                <c:pt idx="43">
                  <c:v>PE P-18:0_20:3</c:v>
                </c:pt>
                <c:pt idx="44">
                  <c:v>PE P-18:0_22:4</c:v>
                </c:pt>
                <c:pt idx="45">
                  <c:v>PE P-18:0_22:5</c:v>
                </c:pt>
                <c:pt idx="46">
                  <c:v>PE P-18:0_22:6</c:v>
                </c:pt>
                <c:pt idx="47">
                  <c:v>PE P-20:0_22:6</c:v>
                </c:pt>
                <c:pt idx="48">
                  <c:v>PE P-32:4</c:v>
                </c:pt>
              </c:strCache>
            </c:strRef>
          </c:cat>
          <c:val>
            <c:numRef>
              <c:f>'Dharmafect Species'!$Z$29:$Z$77</c:f>
              <c:numCache>
                <c:formatCode>General</c:formatCode>
                <c:ptCount val="49"/>
                <c:pt idx="0">
                  <c:v>9476.513366699217</c:v>
                </c:pt>
                <c:pt idx="1">
                  <c:v>377540.884765625</c:v>
                </c:pt>
                <c:pt idx="2">
                  <c:v>73890.71997070307</c:v>
                </c:pt>
                <c:pt idx="3">
                  <c:v>1.25963831445312E6</c:v>
                </c:pt>
                <c:pt idx="4">
                  <c:v>339028.861246745</c:v>
                </c:pt>
                <c:pt idx="5">
                  <c:v>163843.3623860677</c:v>
                </c:pt>
                <c:pt idx="6">
                  <c:v>468439.7640740546</c:v>
                </c:pt>
                <c:pt idx="7">
                  <c:v>29993.11979166666</c:v>
                </c:pt>
                <c:pt idx="8">
                  <c:v>68630.39331054689</c:v>
                </c:pt>
                <c:pt idx="9">
                  <c:v>67428.93749999999</c:v>
                </c:pt>
                <c:pt idx="10">
                  <c:v>415330.6963021224</c:v>
                </c:pt>
                <c:pt idx="11">
                  <c:v>133880.0861332223</c:v>
                </c:pt>
                <c:pt idx="12">
                  <c:v>2.34035214757077E6</c:v>
                </c:pt>
                <c:pt idx="13">
                  <c:v>1.62085664874438E6</c:v>
                </c:pt>
                <c:pt idx="14">
                  <c:v>161453.6598865923</c:v>
                </c:pt>
                <c:pt idx="15">
                  <c:v>20220.00813802086</c:v>
                </c:pt>
                <c:pt idx="16">
                  <c:v>52927.12825520834</c:v>
                </c:pt>
                <c:pt idx="17">
                  <c:v>1.41741390890702E6</c:v>
                </c:pt>
                <c:pt idx="18">
                  <c:v>295873.3190554945</c:v>
                </c:pt>
                <c:pt idx="19">
                  <c:v>428888.6576011612</c:v>
                </c:pt>
                <c:pt idx="20">
                  <c:v>21129.56380208334</c:v>
                </c:pt>
                <c:pt idx="21">
                  <c:v>5574.104593912762</c:v>
                </c:pt>
                <c:pt idx="22">
                  <c:v>2917.07214609782</c:v>
                </c:pt>
                <c:pt idx="23">
                  <c:v>1997.709869384767</c:v>
                </c:pt>
                <c:pt idx="24">
                  <c:v>2554.644083658855</c:v>
                </c:pt>
                <c:pt idx="25">
                  <c:v>24758.86494954427</c:v>
                </c:pt>
                <c:pt idx="26">
                  <c:v>61830.00483194988</c:v>
                </c:pt>
                <c:pt idx="27">
                  <c:v>422053.7426324685</c:v>
                </c:pt>
                <c:pt idx="28">
                  <c:v>38661.12679036459</c:v>
                </c:pt>
                <c:pt idx="29">
                  <c:v>26190.14827473958</c:v>
                </c:pt>
                <c:pt idx="30">
                  <c:v>18470.9020182292</c:v>
                </c:pt>
                <c:pt idx="31">
                  <c:v>1.23710076009115E6</c:v>
                </c:pt>
                <c:pt idx="32">
                  <c:v>1.23710076009115E6</c:v>
                </c:pt>
                <c:pt idx="33">
                  <c:v>1.40055430338542E6</c:v>
                </c:pt>
                <c:pt idx="34">
                  <c:v>786528.1897786458</c:v>
                </c:pt>
                <c:pt idx="35">
                  <c:v>853361.2651936533</c:v>
                </c:pt>
                <c:pt idx="36">
                  <c:v>27729.21248372397</c:v>
                </c:pt>
                <c:pt idx="37">
                  <c:v>134722.3661499025</c:v>
                </c:pt>
                <c:pt idx="38">
                  <c:v>48989.96126302084</c:v>
                </c:pt>
                <c:pt idx="39">
                  <c:v>16770.23700968425</c:v>
                </c:pt>
                <c:pt idx="40">
                  <c:v>17364.12697347005</c:v>
                </c:pt>
                <c:pt idx="41">
                  <c:v>98570.66975911463</c:v>
                </c:pt>
                <c:pt idx="42">
                  <c:v>8925.12402343751</c:v>
                </c:pt>
                <c:pt idx="43">
                  <c:v>27765.71899414062</c:v>
                </c:pt>
                <c:pt idx="44">
                  <c:v>5666.680257161458</c:v>
                </c:pt>
                <c:pt idx="45">
                  <c:v>67310.79459635417</c:v>
                </c:pt>
                <c:pt idx="46">
                  <c:v>143316.1376557297</c:v>
                </c:pt>
                <c:pt idx="47">
                  <c:v>10146.35003662109</c:v>
                </c:pt>
                <c:pt idx="48">
                  <c:v>5439.6939493815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A1E-4742-9BD5-511198327357}"/>
            </c:ext>
          </c:extLst>
        </c:ser>
        <c:ser>
          <c:idx val="1"/>
          <c:order val="1"/>
          <c:tx>
            <c:strRef>
              <c:f>'Dharmafect Species'!$AA$28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29:$AG$77</c:f>
                <c:numCache>
                  <c:formatCode>General</c:formatCode>
                  <c:ptCount val="49"/>
                  <c:pt idx="0">
                    <c:v>543.8855628460276</c:v>
                  </c:pt>
                  <c:pt idx="1">
                    <c:v>78794.26340636345</c:v>
                  </c:pt>
                  <c:pt idx="2">
                    <c:v>26168.87327811781</c:v>
                  </c:pt>
                  <c:pt idx="3">
                    <c:v>196269.793659973</c:v>
                  </c:pt>
                  <c:pt idx="4">
                    <c:v>61985.92436016646</c:v>
                  </c:pt>
                  <c:pt idx="5">
                    <c:v>13833.41397637566</c:v>
                  </c:pt>
                  <c:pt idx="6">
                    <c:v>62675.50021500291</c:v>
                  </c:pt>
                  <c:pt idx="7">
                    <c:v>4532.128951885532</c:v>
                  </c:pt>
                  <c:pt idx="8">
                    <c:v>5471.954921056511</c:v>
                  </c:pt>
                  <c:pt idx="9">
                    <c:v>9027.22629041846</c:v>
                  </c:pt>
                  <c:pt idx="10">
                    <c:v>58041.6778781707</c:v>
                  </c:pt>
                  <c:pt idx="11">
                    <c:v>14338.4320493782</c:v>
                  </c:pt>
                  <c:pt idx="12">
                    <c:v>373083.8353438411</c:v>
                  </c:pt>
                  <c:pt idx="13">
                    <c:v>267158.4741695563</c:v>
                  </c:pt>
                  <c:pt idx="14">
                    <c:v>29137.69325991011</c:v>
                  </c:pt>
                  <c:pt idx="15">
                    <c:v>3812.403697500508</c:v>
                  </c:pt>
                  <c:pt idx="16">
                    <c:v>4789.899295473355</c:v>
                  </c:pt>
                  <c:pt idx="17">
                    <c:v>245810.4945386139</c:v>
                  </c:pt>
                  <c:pt idx="18">
                    <c:v>41737.61873605424</c:v>
                  </c:pt>
                  <c:pt idx="19">
                    <c:v>104722.8459692011</c:v>
                  </c:pt>
                  <c:pt idx="20">
                    <c:v>2737.117456947247</c:v>
                  </c:pt>
                  <c:pt idx="21">
                    <c:v>569.5650524869111</c:v>
                  </c:pt>
                  <c:pt idx="22">
                    <c:v>596.5292384509619</c:v>
                  </c:pt>
                  <c:pt idx="23">
                    <c:v>400.3731331669466</c:v>
                  </c:pt>
                  <c:pt idx="24">
                    <c:v>646.0958208259772</c:v>
                  </c:pt>
                  <c:pt idx="25">
                    <c:v>4333.333814836962</c:v>
                  </c:pt>
                  <c:pt idx="26">
                    <c:v>8727.668542204668</c:v>
                  </c:pt>
                  <c:pt idx="27">
                    <c:v>52400.44382044036</c:v>
                  </c:pt>
                  <c:pt idx="28">
                    <c:v>11991.75777468233</c:v>
                  </c:pt>
                  <c:pt idx="29">
                    <c:v>4501.464549373397</c:v>
                  </c:pt>
                  <c:pt idx="30">
                    <c:v>2219.98148058997</c:v>
                  </c:pt>
                  <c:pt idx="31">
                    <c:v>202585.94044342</c:v>
                  </c:pt>
                  <c:pt idx="32">
                    <c:v>202585.94044342</c:v>
                  </c:pt>
                  <c:pt idx="33">
                    <c:v>335052.7869806243</c:v>
                  </c:pt>
                  <c:pt idx="34">
                    <c:v>135281.0817129445</c:v>
                  </c:pt>
                  <c:pt idx="35">
                    <c:v>143338.3568342288</c:v>
                  </c:pt>
                  <c:pt idx="36">
                    <c:v>8224.069753554233</c:v>
                  </c:pt>
                  <c:pt idx="37">
                    <c:v>22446.60379489519</c:v>
                  </c:pt>
                  <c:pt idx="38">
                    <c:v>12717.02116610943</c:v>
                  </c:pt>
                  <c:pt idx="39">
                    <c:v>3187.131063482766</c:v>
                  </c:pt>
                  <c:pt idx="40">
                    <c:v>2904.085732808873</c:v>
                  </c:pt>
                  <c:pt idx="41">
                    <c:v>9721.5887111479</c:v>
                  </c:pt>
                  <c:pt idx="42">
                    <c:v>2522.940228836874</c:v>
                  </c:pt>
                  <c:pt idx="43">
                    <c:v>7613.446417549992</c:v>
                  </c:pt>
                  <c:pt idx="44">
                    <c:v>744.9338125124453</c:v>
                  </c:pt>
                  <c:pt idx="45">
                    <c:v>8505.796356276807</c:v>
                  </c:pt>
                  <c:pt idx="46">
                    <c:v>21782.75940495858</c:v>
                  </c:pt>
                  <c:pt idx="47">
                    <c:v>1198.473451442896</c:v>
                  </c:pt>
                  <c:pt idx="48">
                    <c:v>1123.563188621793</c:v>
                  </c:pt>
                </c:numCache>
              </c:numRef>
            </c:plus>
            <c:minus>
              <c:numRef>
                <c:f>'Dharmafect Species'!$AG$29:$AG$77</c:f>
                <c:numCache>
                  <c:formatCode>General</c:formatCode>
                  <c:ptCount val="49"/>
                  <c:pt idx="0">
                    <c:v>543.8855628460276</c:v>
                  </c:pt>
                  <c:pt idx="1">
                    <c:v>78794.26340636345</c:v>
                  </c:pt>
                  <c:pt idx="2">
                    <c:v>26168.87327811781</c:v>
                  </c:pt>
                  <c:pt idx="3">
                    <c:v>196269.793659973</c:v>
                  </c:pt>
                  <c:pt idx="4">
                    <c:v>61985.92436016646</c:v>
                  </c:pt>
                  <c:pt idx="5">
                    <c:v>13833.41397637566</c:v>
                  </c:pt>
                  <c:pt idx="6">
                    <c:v>62675.50021500291</c:v>
                  </c:pt>
                  <c:pt idx="7">
                    <c:v>4532.128951885532</c:v>
                  </c:pt>
                  <c:pt idx="8">
                    <c:v>5471.954921056511</c:v>
                  </c:pt>
                  <c:pt idx="9">
                    <c:v>9027.22629041846</c:v>
                  </c:pt>
                  <c:pt idx="10">
                    <c:v>58041.6778781707</c:v>
                  </c:pt>
                  <c:pt idx="11">
                    <c:v>14338.4320493782</c:v>
                  </c:pt>
                  <c:pt idx="12">
                    <c:v>373083.8353438411</c:v>
                  </c:pt>
                  <c:pt idx="13">
                    <c:v>267158.4741695563</c:v>
                  </c:pt>
                  <c:pt idx="14">
                    <c:v>29137.69325991011</c:v>
                  </c:pt>
                  <c:pt idx="15">
                    <c:v>3812.403697500508</c:v>
                  </c:pt>
                  <c:pt idx="16">
                    <c:v>4789.899295473355</c:v>
                  </c:pt>
                  <c:pt idx="17">
                    <c:v>245810.4945386139</c:v>
                  </c:pt>
                  <c:pt idx="18">
                    <c:v>41737.61873605424</c:v>
                  </c:pt>
                  <c:pt idx="19">
                    <c:v>104722.8459692011</c:v>
                  </c:pt>
                  <c:pt idx="20">
                    <c:v>2737.117456947247</c:v>
                  </c:pt>
                  <c:pt idx="21">
                    <c:v>569.5650524869111</c:v>
                  </c:pt>
                  <c:pt idx="22">
                    <c:v>596.5292384509619</c:v>
                  </c:pt>
                  <c:pt idx="23">
                    <c:v>400.3731331669466</c:v>
                  </c:pt>
                  <c:pt idx="24">
                    <c:v>646.0958208259772</c:v>
                  </c:pt>
                  <c:pt idx="25">
                    <c:v>4333.333814836962</c:v>
                  </c:pt>
                  <c:pt idx="26">
                    <c:v>8727.668542204668</c:v>
                  </c:pt>
                  <c:pt idx="27">
                    <c:v>52400.44382044036</c:v>
                  </c:pt>
                  <c:pt idx="28">
                    <c:v>11991.75777468233</c:v>
                  </c:pt>
                  <c:pt idx="29">
                    <c:v>4501.464549373397</c:v>
                  </c:pt>
                  <c:pt idx="30">
                    <c:v>2219.98148058997</c:v>
                  </c:pt>
                  <c:pt idx="31">
                    <c:v>202585.94044342</c:v>
                  </c:pt>
                  <c:pt idx="32">
                    <c:v>202585.94044342</c:v>
                  </c:pt>
                  <c:pt idx="33">
                    <c:v>335052.7869806243</c:v>
                  </c:pt>
                  <c:pt idx="34">
                    <c:v>135281.0817129445</c:v>
                  </c:pt>
                  <c:pt idx="35">
                    <c:v>143338.3568342288</c:v>
                  </c:pt>
                  <c:pt idx="36">
                    <c:v>8224.069753554233</c:v>
                  </c:pt>
                  <c:pt idx="37">
                    <c:v>22446.60379489519</c:v>
                  </c:pt>
                  <c:pt idx="38">
                    <c:v>12717.02116610943</c:v>
                  </c:pt>
                  <c:pt idx="39">
                    <c:v>3187.131063482766</c:v>
                  </c:pt>
                  <c:pt idx="40">
                    <c:v>2904.085732808873</c:v>
                  </c:pt>
                  <c:pt idx="41">
                    <c:v>9721.5887111479</c:v>
                  </c:pt>
                  <c:pt idx="42">
                    <c:v>2522.940228836874</c:v>
                  </c:pt>
                  <c:pt idx="43">
                    <c:v>7613.446417549992</c:v>
                  </c:pt>
                  <c:pt idx="44">
                    <c:v>744.9338125124453</c:v>
                  </c:pt>
                  <c:pt idx="45">
                    <c:v>8505.796356276807</c:v>
                  </c:pt>
                  <c:pt idx="46">
                    <c:v>21782.75940495858</c:v>
                  </c:pt>
                  <c:pt idx="47">
                    <c:v>1198.473451442896</c:v>
                  </c:pt>
                  <c:pt idx="48">
                    <c:v>1123.5631886217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9:$Y$77</c:f>
              <c:strCache>
                <c:ptCount val="49"/>
                <c:pt idx="0">
                  <c:v>LPE 16:0</c:v>
                </c:pt>
                <c:pt idx="1">
                  <c:v>PE 16:0_16:1</c:v>
                </c:pt>
                <c:pt idx="2">
                  <c:v>PE 16:0_18:0</c:v>
                </c:pt>
                <c:pt idx="3">
                  <c:v>PE 16:0_18:1</c:v>
                </c:pt>
                <c:pt idx="4">
                  <c:v>PE 16:0_20:4</c:v>
                </c:pt>
                <c:pt idx="5">
                  <c:v>PE 16:0_20:5</c:v>
                </c:pt>
                <c:pt idx="6">
                  <c:v>PE 16:1_18:1</c:v>
                </c:pt>
                <c:pt idx="7">
                  <c:v>PE 17:0_20:4</c:v>
                </c:pt>
                <c:pt idx="8">
                  <c:v>PE 18:0_20:2</c:v>
                </c:pt>
                <c:pt idx="9">
                  <c:v>PE 18:0_20:3</c:v>
                </c:pt>
                <c:pt idx="10">
                  <c:v>PE 18:0_20:5</c:v>
                </c:pt>
                <c:pt idx="11">
                  <c:v>PE 18:0_22:5</c:v>
                </c:pt>
                <c:pt idx="12">
                  <c:v>PE 18:0_22:6</c:v>
                </c:pt>
                <c:pt idx="13">
                  <c:v>PE 18:1_18:1</c:v>
                </c:pt>
                <c:pt idx="14">
                  <c:v>PE 18:1_18:2</c:v>
                </c:pt>
                <c:pt idx="15">
                  <c:v>PE 18:1_20:0</c:v>
                </c:pt>
                <c:pt idx="16">
                  <c:v>PE 18:1_20:1</c:v>
                </c:pt>
                <c:pt idx="17">
                  <c:v>PE 18:1_20:3</c:v>
                </c:pt>
                <c:pt idx="18">
                  <c:v>PE 18:1_20:5</c:v>
                </c:pt>
                <c:pt idx="19">
                  <c:v>PE 18:1_22:6</c:v>
                </c:pt>
                <c:pt idx="20">
                  <c:v>PE 20:1_20:3</c:v>
                </c:pt>
                <c:pt idx="21">
                  <c:v>PE 20:5_22:6</c:v>
                </c:pt>
                <c:pt idx="22">
                  <c:v>PE P-14:0_16:1</c:v>
                </c:pt>
                <c:pt idx="23">
                  <c:v>PE P-16:0_12:0 </c:v>
                </c:pt>
                <c:pt idx="24">
                  <c:v>PE P-16:0_14:1</c:v>
                </c:pt>
                <c:pt idx="25">
                  <c:v>PE P-16:0_16:0</c:v>
                </c:pt>
                <c:pt idx="26">
                  <c:v>PE P-16:0_16:1</c:v>
                </c:pt>
                <c:pt idx="27">
                  <c:v>PE P-16:0_18:1</c:v>
                </c:pt>
                <c:pt idx="28">
                  <c:v>PE P-16:0_18:2</c:v>
                </c:pt>
                <c:pt idx="29">
                  <c:v>PE P-16:0_20:3</c:v>
                </c:pt>
                <c:pt idx="30">
                  <c:v>PE P-16:0_20:3</c:v>
                </c:pt>
                <c:pt idx="31">
                  <c:v>PE P-16:0_20:4 A</c:v>
                </c:pt>
                <c:pt idx="32">
                  <c:v>PE P-16:0_20:4 B</c:v>
                </c:pt>
                <c:pt idx="33">
                  <c:v>PE P-16:0_20:5</c:v>
                </c:pt>
                <c:pt idx="34">
                  <c:v>PE P-16:0_22:5</c:v>
                </c:pt>
                <c:pt idx="35">
                  <c:v>PE P-16:0_22:6</c:v>
                </c:pt>
                <c:pt idx="36">
                  <c:v>PE P-17:0_18:1</c:v>
                </c:pt>
                <c:pt idx="37">
                  <c:v>PE P-17:0_20:4</c:v>
                </c:pt>
                <c:pt idx="38">
                  <c:v>PE P-17:0_22:6</c:v>
                </c:pt>
                <c:pt idx="39">
                  <c:v>PE P-18:0_16:0</c:v>
                </c:pt>
                <c:pt idx="40">
                  <c:v>PE P-18:0_16:0</c:v>
                </c:pt>
                <c:pt idx="41">
                  <c:v>PE P-18:0_18:1</c:v>
                </c:pt>
                <c:pt idx="42">
                  <c:v>PE P-18:0_18:1</c:v>
                </c:pt>
                <c:pt idx="43">
                  <c:v>PE P-18:0_20:3</c:v>
                </c:pt>
                <c:pt idx="44">
                  <c:v>PE P-18:0_22:4</c:v>
                </c:pt>
                <c:pt idx="45">
                  <c:v>PE P-18:0_22:5</c:v>
                </c:pt>
                <c:pt idx="46">
                  <c:v>PE P-18:0_22:6</c:v>
                </c:pt>
                <c:pt idx="47">
                  <c:v>PE P-20:0_22:6</c:v>
                </c:pt>
                <c:pt idx="48">
                  <c:v>PE P-32:4</c:v>
                </c:pt>
              </c:strCache>
            </c:strRef>
          </c:cat>
          <c:val>
            <c:numRef>
              <c:f>'Dharmafect Species'!$AA$29:$AA$77</c:f>
              <c:numCache>
                <c:formatCode>General</c:formatCode>
                <c:ptCount val="49"/>
                <c:pt idx="0">
                  <c:v>7451.659192403158</c:v>
                </c:pt>
                <c:pt idx="1">
                  <c:v>306632.3958333333</c:v>
                </c:pt>
                <c:pt idx="2">
                  <c:v>54300.19771321616</c:v>
                </c:pt>
                <c:pt idx="3">
                  <c:v>1.03956057421875E6</c:v>
                </c:pt>
                <c:pt idx="4">
                  <c:v>335373.3999023438</c:v>
                </c:pt>
                <c:pt idx="5">
                  <c:v>158369.5244140628</c:v>
                </c:pt>
                <c:pt idx="6">
                  <c:v>443367.6083190658</c:v>
                </c:pt>
                <c:pt idx="7">
                  <c:v>32287.7703450521</c:v>
                </c:pt>
                <c:pt idx="8">
                  <c:v>46113.56042480469</c:v>
                </c:pt>
                <c:pt idx="9">
                  <c:v>62132.67692057291</c:v>
                </c:pt>
                <c:pt idx="10">
                  <c:v>448206.9046148136</c:v>
                </c:pt>
                <c:pt idx="11">
                  <c:v>100865.8531479</c:v>
                </c:pt>
                <c:pt idx="12">
                  <c:v>1.92477635820785E6</c:v>
                </c:pt>
                <c:pt idx="13">
                  <c:v>1.60713161141937E6</c:v>
                </c:pt>
                <c:pt idx="14">
                  <c:v>167483.0942586355</c:v>
                </c:pt>
                <c:pt idx="15">
                  <c:v>15647.67187500003</c:v>
                </c:pt>
                <c:pt idx="16">
                  <c:v>40127.09122721355</c:v>
                </c:pt>
                <c:pt idx="17">
                  <c:v>1.56748867115398E6</c:v>
                </c:pt>
                <c:pt idx="18">
                  <c:v>351650.4320453372</c:v>
                </c:pt>
                <c:pt idx="19">
                  <c:v>435598.3657118885</c:v>
                </c:pt>
                <c:pt idx="20">
                  <c:v>21880.67643229167</c:v>
                </c:pt>
                <c:pt idx="21">
                  <c:v>8775.109115600584</c:v>
                </c:pt>
                <c:pt idx="22">
                  <c:v>2869.840548197428</c:v>
                </c:pt>
                <c:pt idx="23">
                  <c:v>2388.526662190754</c:v>
                </c:pt>
                <c:pt idx="24">
                  <c:v>2815.953285217285</c:v>
                </c:pt>
                <c:pt idx="25">
                  <c:v>30422.6288655599</c:v>
                </c:pt>
                <c:pt idx="26">
                  <c:v>55223.49800618491</c:v>
                </c:pt>
                <c:pt idx="27">
                  <c:v>411415.8242500388</c:v>
                </c:pt>
                <c:pt idx="28">
                  <c:v>45542.3203125</c:v>
                </c:pt>
                <c:pt idx="29">
                  <c:v>22014.5234375</c:v>
                </c:pt>
                <c:pt idx="30">
                  <c:v>16120.46748860679</c:v>
                </c:pt>
                <c:pt idx="31">
                  <c:v>1.32699473046875E6</c:v>
                </c:pt>
                <c:pt idx="32">
                  <c:v>1.32699473046875E6</c:v>
                </c:pt>
                <c:pt idx="33">
                  <c:v>1.49911988671875E6</c:v>
                </c:pt>
                <c:pt idx="34">
                  <c:v>814932.8395182289</c:v>
                </c:pt>
                <c:pt idx="35">
                  <c:v>871056.440730371</c:v>
                </c:pt>
                <c:pt idx="36">
                  <c:v>17439.43017578127</c:v>
                </c:pt>
                <c:pt idx="37">
                  <c:v>149738.0814208985</c:v>
                </c:pt>
                <c:pt idx="38">
                  <c:v>53599.1385091146</c:v>
                </c:pt>
                <c:pt idx="39">
                  <c:v>22670.37223307293</c:v>
                </c:pt>
                <c:pt idx="40">
                  <c:v>23153.53729248048</c:v>
                </c:pt>
                <c:pt idx="41">
                  <c:v>88756.6289876303</c:v>
                </c:pt>
                <c:pt idx="42">
                  <c:v>12878.11710611981</c:v>
                </c:pt>
                <c:pt idx="43">
                  <c:v>17468.35896809895</c:v>
                </c:pt>
                <c:pt idx="44">
                  <c:v>4862.995279947917</c:v>
                </c:pt>
                <c:pt idx="45">
                  <c:v>67224.61067708333</c:v>
                </c:pt>
                <c:pt idx="46">
                  <c:v>144502.4932057348</c:v>
                </c:pt>
                <c:pt idx="47">
                  <c:v>10718.12522888184</c:v>
                </c:pt>
                <c:pt idx="48">
                  <c:v>4894.35150146484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A1E-4742-9BD5-511198327357}"/>
            </c:ext>
          </c:extLst>
        </c:ser>
        <c:ser>
          <c:idx val="2"/>
          <c:order val="2"/>
          <c:tx>
            <c:strRef>
              <c:f>'Dharmafect Species'!$AB$28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H$29:$AH$77</c:f>
                <c:numCache>
                  <c:formatCode>General</c:formatCode>
                  <c:ptCount val="49"/>
                  <c:pt idx="0">
                    <c:v>1282.626271224591</c:v>
                  </c:pt>
                  <c:pt idx="1">
                    <c:v>73460.22201554924</c:v>
                  </c:pt>
                  <c:pt idx="2">
                    <c:v>78084.06836033247</c:v>
                  </c:pt>
                  <c:pt idx="3">
                    <c:v>350127.0896143653</c:v>
                  </c:pt>
                  <c:pt idx="4">
                    <c:v>103726.7808618514</c:v>
                  </c:pt>
                  <c:pt idx="5">
                    <c:v>35131.62088231002</c:v>
                  </c:pt>
                  <c:pt idx="6">
                    <c:v>96200.6246270763</c:v>
                  </c:pt>
                  <c:pt idx="7">
                    <c:v>11226.95706671571</c:v>
                  </c:pt>
                  <c:pt idx="8">
                    <c:v>22914.72701526627</c:v>
                  </c:pt>
                  <c:pt idx="9">
                    <c:v>19691.66124910122</c:v>
                  </c:pt>
                  <c:pt idx="10">
                    <c:v>135936.730567284</c:v>
                  </c:pt>
                  <c:pt idx="11">
                    <c:v>31674.215098791</c:v>
                  </c:pt>
                  <c:pt idx="12">
                    <c:v>696917.362457172</c:v>
                  </c:pt>
                  <c:pt idx="13">
                    <c:v>469699.1386734023</c:v>
                  </c:pt>
                  <c:pt idx="14">
                    <c:v>42813.37263192718</c:v>
                  </c:pt>
                  <c:pt idx="15">
                    <c:v>5654.988390420185</c:v>
                  </c:pt>
                  <c:pt idx="16">
                    <c:v>22084.063042967</c:v>
                  </c:pt>
                  <c:pt idx="17">
                    <c:v>467245.2551841656</c:v>
                  </c:pt>
                  <c:pt idx="18">
                    <c:v>100010.8772704867</c:v>
                  </c:pt>
                  <c:pt idx="19">
                    <c:v>339996.0171595901</c:v>
                  </c:pt>
                  <c:pt idx="20">
                    <c:v>5219.351312311142</c:v>
                  </c:pt>
                  <c:pt idx="21">
                    <c:v>1997.597175505391</c:v>
                  </c:pt>
                  <c:pt idx="22">
                    <c:v>296.6222609683508</c:v>
                  </c:pt>
                  <c:pt idx="23">
                    <c:v>268.3096365834672</c:v>
                  </c:pt>
                  <c:pt idx="24">
                    <c:v>259.6508352470879</c:v>
                  </c:pt>
                  <c:pt idx="25">
                    <c:v>6523.941142184492</c:v>
                  </c:pt>
                  <c:pt idx="26">
                    <c:v>13519.19074368068</c:v>
                  </c:pt>
                  <c:pt idx="27">
                    <c:v>114062.7894178264</c:v>
                  </c:pt>
                  <c:pt idx="28">
                    <c:v>17527.71233754263</c:v>
                  </c:pt>
                  <c:pt idx="29">
                    <c:v>29779.25876612135</c:v>
                  </c:pt>
                  <c:pt idx="30">
                    <c:v>4516.121768479974</c:v>
                  </c:pt>
                  <c:pt idx="31">
                    <c:v>399408.5708069858</c:v>
                  </c:pt>
                  <c:pt idx="32">
                    <c:v>399408.5708069858</c:v>
                  </c:pt>
                  <c:pt idx="33">
                    <c:v>717201.3591563946</c:v>
                  </c:pt>
                  <c:pt idx="34">
                    <c:v>256053.6799245552</c:v>
                  </c:pt>
                  <c:pt idx="35">
                    <c:v>257250.0612103925</c:v>
                  </c:pt>
                  <c:pt idx="36">
                    <c:v>29233.43967137045</c:v>
                  </c:pt>
                  <c:pt idx="37">
                    <c:v>38464.18314845517</c:v>
                  </c:pt>
                  <c:pt idx="38">
                    <c:v>25513.14829834592</c:v>
                  </c:pt>
                  <c:pt idx="39">
                    <c:v>6893.392524486936</c:v>
                  </c:pt>
                  <c:pt idx="40">
                    <c:v>7199.003452126531</c:v>
                  </c:pt>
                  <c:pt idx="41">
                    <c:v>21235.04385872997</c:v>
                  </c:pt>
                  <c:pt idx="42">
                    <c:v>4457.385562412884</c:v>
                  </c:pt>
                  <c:pt idx="43">
                    <c:v>33686.25018829469</c:v>
                  </c:pt>
                  <c:pt idx="44">
                    <c:v>1092.801674120322</c:v>
                  </c:pt>
                  <c:pt idx="45">
                    <c:v>8513.211556256308</c:v>
                  </c:pt>
                  <c:pt idx="46">
                    <c:v>50874.6376128788</c:v>
                  </c:pt>
                  <c:pt idx="47">
                    <c:v>1628.43738112105</c:v>
                  </c:pt>
                  <c:pt idx="48">
                    <c:v>629.4305098907028</c:v>
                  </c:pt>
                </c:numCache>
              </c:numRef>
            </c:plus>
            <c:minus>
              <c:numRef>
                <c:f>'Dharmafect Species'!$AH$29:$AH$77</c:f>
                <c:numCache>
                  <c:formatCode>General</c:formatCode>
                  <c:ptCount val="49"/>
                  <c:pt idx="0">
                    <c:v>1282.626271224591</c:v>
                  </c:pt>
                  <c:pt idx="1">
                    <c:v>73460.22201554924</c:v>
                  </c:pt>
                  <c:pt idx="2">
                    <c:v>78084.06836033247</c:v>
                  </c:pt>
                  <c:pt idx="3">
                    <c:v>350127.0896143653</c:v>
                  </c:pt>
                  <c:pt idx="4">
                    <c:v>103726.7808618514</c:v>
                  </c:pt>
                  <c:pt idx="5">
                    <c:v>35131.62088231002</c:v>
                  </c:pt>
                  <c:pt idx="6">
                    <c:v>96200.6246270763</c:v>
                  </c:pt>
                  <c:pt idx="7">
                    <c:v>11226.95706671571</c:v>
                  </c:pt>
                  <c:pt idx="8">
                    <c:v>22914.72701526627</c:v>
                  </c:pt>
                  <c:pt idx="9">
                    <c:v>19691.66124910122</c:v>
                  </c:pt>
                  <c:pt idx="10">
                    <c:v>135936.730567284</c:v>
                  </c:pt>
                  <c:pt idx="11">
                    <c:v>31674.215098791</c:v>
                  </c:pt>
                  <c:pt idx="12">
                    <c:v>696917.362457172</c:v>
                  </c:pt>
                  <c:pt idx="13">
                    <c:v>469699.1386734023</c:v>
                  </c:pt>
                  <c:pt idx="14">
                    <c:v>42813.37263192718</c:v>
                  </c:pt>
                  <c:pt idx="15">
                    <c:v>5654.988390420185</c:v>
                  </c:pt>
                  <c:pt idx="16">
                    <c:v>22084.063042967</c:v>
                  </c:pt>
                  <c:pt idx="17">
                    <c:v>467245.2551841656</c:v>
                  </c:pt>
                  <c:pt idx="18">
                    <c:v>100010.8772704867</c:v>
                  </c:pt>
                  <c:pt idx="19">
                    <c:v>339996.0171595901</c:v>
                  </c:pt>
                  <c:pt idx="20">
                    <c:v>5219.351312311142</c:v>
                  </c:pt>
                  <c:pt idx="21">
                    <c:v>1997.597175505391</c:v>
                  </c:pt>
                  <c:pt idx="22">
                    <c:v>296.6222609683508</c:v>
                  </c:pt>
                  <c:pt idx="23">
                    <c:v>268.3096365834672</c:v>
                  </c:pt>
                  <c:pt idx="24">
                    <c:v>259.6508352470879</c:v>
                  </c:pt>
                  <c:pt idx="25">
                    <c:v>6523.941142184492</c:v>
                  </c:pt>
                  <c:pt idx="26">
                    <c:v>13519.19074368068</c:v>
                  </c:pt>
                  <c:pt idx="27">
                    <c:v>114062.7894178264</c:v>
                  </c:pt>
                  <c:pt idx="28">
                    <c:v>17527.71233754263</c:v>
                  </c:pt>
                  <c:pt idx="29">
                    <c:v>29779.25876612135</c:v>
                  </c:pt>
                  <c:pt idx="30">
                    <c:v>4516.121768479974</c:v>
                  </c:pt>
                  <c:pt idx="31">
                    <c:v>399408.5708069858</c:v>
                  </c:pt>
                  <c:pt idx="32">
                    <c:v>399408.5708069858</c:v>
                  </c:pt>
                  <c:pt idx="33">
                    <c:v>717201.3591563946</c:v>
                  </c:pt>
                  <c:pt idx="34">
                    <c:v>256053.6799245552</c:v>
                  </c:pt>
                  <c:pt idx="35">
                    <c:v>257250.0612103925</c:v>
                  </c:pt>
                  <c:pt idx="36">
                    <c:v>29233.43967137045</c:v>
                  </c:pt>
                  <c:pt idx="37">
                    <c:v>38464.18314845517</c:v>
                  </c:pt>
                  <c:pt idx="38">
                    <c:v>25513.14829834592</c:v>
                  </c:pt>
                  <c:pt idx="39">
                    <c:v>6893.392524486936</c:v>
                  </c:pt>
                  <c:pt idx="40">
                    <c:v>7199.003452126531</c:v>
                  </c:pt>
                  <c:pt idx="41">
                    <c:v>21235.04385872997</c:v>
                  </c:pt>
                  <c:pt idx="42">
                    <c:v>4457.385562412884</c:v>
                  </c:pt>
                  <c:pt idx="43">
                    <c:v>33686.25018829469</c:v>
                  </c:pt>
                  <c:pt idx="44">
                    <c:v>1092.801674120322</c:v>
                  </c:pt>
                  <c:pt idx="45">
                    <c:v>8513.211556256308</c:v>
                  </c:pt>
                  <c:pt idx="46">
                    <c:v>50874.6376128788</c:v>
                  </c:pt>
                  <c:pt idx="47">
                    <c:v>1628.43738112105</c:v>
                  </c:pt>
                  <c:pt idx="48">
                    <c:v>629.43050989070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9:$Y$77</c:f>
              <c:strCache>
                <c:ptCount val="49"/>
                <c:pt idx="0">
                  <c:v>LPE 16:0</c:v>
                </c:pt>
                <c:pt idx="1">
                  <c:v>PE 16:0_16:1</c:v>
                </c:pt>
                <c:pt idx="2">
                  <c:v>PE 16:0_18:0</c:v>
                </c:pt>
                <c:pt idx="3">
                  <c:v>PE 16:0_18:1</c:v>
                </c:pt>
                <c:pt idx="4">
                  <c:v>PE 16:0_20:4</c:v>
                </c:pt>
                <c:pt idx="5">
                  <c:v>PE 16:0_20:5</c:v>
                </c:pt>
                <c:pt idx="6">
                  <c:v>PE 16:1_18:1</c:v>
                </c:pt>
                <c:pt idx="7">
                  <c:v>PE 17:0_20:4</c:v>
                </c:pt>
                <c:pt idx="8">
                  <c:v>PE 18:0_20:2</c:v>
                </c:pt>
                <c:pt idx="9">
                  <c:v>PE 18:0_20:3</c:v>
                </c:pt>
                <c:pt idx="10">
                  <c:v>PE 18:0_20:5</c:v>
                </c:pt>
                <c:pt idx="11">
                  <c:v>PE 18:0_22:5</c:v>
                </c:pt>
                <c:pt idx="12">
                  <c:v>PE 18:0_22:6</c:v>
                </c:pt>
                <c:pt idx="13">
                  <c:v>PE 18:1_18:1</c:v>
                </c:pt>
                <c:pt idx="14">
                  <c:v>PE 18:1_18:2</c:v>
                </c:pt>
                <c:pt idx="15">
                  <c:v>PE 18:1_20:0</c:v>
                </c:pt>
                <c:pt idx="16">
                  <c:v>PE 18:1_20:1</c:v>
                </c:pt>
                <c:pt idx="17">
                  <c:v>PE 18:1_20:3</c:v>
                </c:pt>
                <c:pt idx="18">
                  <c:v>PE 18:1_20:5</c:v>
                </c:pt>
                <c:pt idx="19">
                  <c:v>PE 18:1_22:6</c:v>
                </c:pt>
                <c:pt idx="20">
                  <c:v>PE 20:1_20:3</c:v>
                </c:pt>
                <c:pt idx="21">
                  <c:v>PE 20:5_22:6</c:v>
                </c:pt>
                <c:pt idx="22">
                  <c:v>PE P-14:0_16:1</c:v>
                </c:pt>
                <c:pt idx="23">
                  <c:v>PE P-16:0_12:0 </c:v>
                </c:pt>
                <c:pt idx="24">
                  <c:v>PE P-16:0_14:1</c:v>
                </c:pt>
                <c:pt idx="25">
                  <c:v>PE P-16:0_16:0</c:v>
                </c:pt>
                <c:pt idx="26">
                  <c:v>PE P-16:0_16:1</c:v>
                </c:pt>
                <c:pt idx="27">
                  <c:v>PE P-16:0_18:1</c:v>
                </c:pt>
                <c:pt idx="28">
                  <c:v>PE P-16:0_18:2</c:v>
                </c:pt>
                <c:pt idx="29">
                  <c:v>PE P-16:0_20:3</c:v>
                </c:pt>
                <c:pt idx="30">
                  <c:v>PE P-16:0_20:3</c:v>
                </c:pt>
                <c:pt idx="31">
                  <c:v>PE P-16:0_20:4 A</c:v>
                </c:pt>
                <c:pt idx="32">
                  <c:v>PE P-16:0_20:4 B</c:v>
                </c:pt>
                <c:pt idx="33">
                  <c:v>PE P-16:0_20:5</c:v>
                </c:pt>
                <c:pt idx="34">
                  <c:v>PE P-16:0_22:5</c:v>
                </c:pt>
                <c:pt idx="35">
                  <c:v>PE P-16:0_22:6</c:v>
                </c:pt>
                <c:pt idx="36">
                  <c:v>PE P-17:0_18:1</c:v>
                </c:pt>
                <c:pt idx="37">
                  <c:v>PE P-17:0_20:4</c:v>
                </c:pt>
                <c:pt idx="38">
                  <c:v>PE P-17:0_22:6</c:v>
                </c:pt>
                <c:pt idx="39">
                  <c:v>PE P-18:0_16:0</c:v>
                </c:pt>
                <c:pt idx="40">
                  <c:v>PE P-18:0_16:0</c:v>
                </c:pt>
                <c:pt idx="41">
                  <c:v>PE P-18:0_18:1</c:v>
                </c:pt>
                <c:pt idx="42">
                  <c:v>PE P-18:0_18:1</c:v>
                </c:pt>
                <c:pt idx="43">
                  <c:v>PE P-18:0_20:3</c:v>
                </c:pt>
                <c:pt idx="44">
                  <c:v>PE P-18:0_22:4</c:v>
                </c:pt>
                <c:pt idx="45">
                  <c:v>PE P-18:0_22:5</c:v>
                </c:pt>
                <c:pt idx="46">
                  <c:v>PE P-18:0_22:6</c:v>
                </c:pt>
                <c:pt idx="47">
                  <c:v>PE P-20:0_22:6</c:v>
                </c:pt>
                <c:pt idx="48">
                  <c:v>PE P-32:4</c:v>
                </c:pt>
              </c:strCache>
            </c:strRef>
          </c:cat>
          <c:val>
            <c:numRef>
              <c:f>'Dharmafect Species'!$AB$29:$AB$77</c:f>
              <c:numCache>
                <c:formatCode>General</c:formatCode>
                <c:ptCount val="49"/>
                <c:pt idx="0">
                  <c:v>5994.799883524577</c:v>
                </c:pt>
                <c:pt idx="1">
                  <c:v>172886.4514973957</c:v>
                </c:pt>
                <c:pt idx="2">
                  <c:v>80427.84678141275</c:v>
                </c:pt>
                <c:pt idx="3">
                  <c:v>781496.7112630216</c:v>
                </c:pt>
                <c:pt idx="4">
                  <c:v>286222.8174235029</c:v>
                </c:pt>
                <c:pt idx="5">
                  <c:v>140740.0399576823</c:v>
                </c:pt>
                <c:pt idx="6">
                  <c:v>294626.4718523154</c:v>
                </c:pt>
                <c:pt idx="7">
                  <c:v>32685.59383138022</c:v>
                </c:pt>
                <c:pt idx="8">
                  <c:v>46455.12532552082</c:v>
                </c:pt>
                <c:pt idx="9">
                  <c:v>59146.70092773437</c:v>
                </c:pt>
                <c:pt idx="10">
                  <c:v>419567.4271946533</c:v>
                </c:pt>
                <c:pt idx="11">
                  <c:v>92230.23248586306</c:v>
                </c:pt>
                <c:pt idx="12">
                  <c:v>1.5681262349891E6</c:v>
                </c:pt>
                <c:pt idx="13">
                  <c:v>1.27601979670538E6</c:v>
                </c:pt>
                <c:pt idx="14">
                  <c:v>138471.2211991026</c:v>
                </c:pt>
                <c:pt idx="15">
                  <c:v>16150.82165527345</c:v>
                </c:pt>
                <c:pt idx="16">
                  <c:v>40341.03149414062</c:v>
                </c:pt>
                <c:pt idx="17">
                  <c:v>1.34240110112372E6</c:v>
                </c:pt>
                <c:pt idx="18">
                  <c:v>310318.7208938927</c:v>
                </c:pt>
                <c:pt idx="19">
                  <c:v>399630.9325475805</c:v>
                </c:pt>
                <c:pt idx="20">
                  <c:v>22111.62760416667</c:v>
                </c:pt>
                <c:pt idx="21">
                  <c:v>7439.842768351234</c:v>
                </c:pt>
                <c:pt idx="22">
                  <c:v>2442.64096069336</c:v>
                </c:pt>
                <c:pt idx="23">
                  <c:v>2258.588694254557</c:v>
                </c:pt>
                <c:pt idx="24">
                  <c:v>2283.846649169921</c:v>
                </c:pt>
                <c:pt idx="25">
                  <c:v>23299.9958190918</c:v>
                </c:pt>
                <c:pt idx="26">
                  <c:v>39570.91696166993</c:v>
                </c:pt>
                <c:pt idx="27">
                  <c:v>335552.70973273</c:v>
                </c:pt>
                <c:pt idx="28">
                  <c:v>30558.4666341146</c:v>
                </c:pt>
                <c:pt idx="29">
                  <c:v>27037.70768229167</c:v>
                </c:pt>
                <c:pt idx="30">
                  <c:v>14911.11301676434</c:v>
                </c:pt>
                <c:pt idx="31">
                  <c:v>1.15080703320313E6</c:v>
                </c:pt>
                <c:pt idx="32">
                  <c:v>1.15080703320313E6</c:v>
                </c:pt>
                <c:pt idx="33">
                  <c:v>1.07203768033854E6</c:v>
                </c:pt>
                <c:pt idx="34">
                  <c:v>723352.0105794271</c:v>
                </c:pt>
                <c:pt idx="35">
                  <c:v>702933.5381959976</c:v>
                </c:pt>
                <c:pt idx="36">
                  <c:v>30474.15954589844</c:v>
                </c:pt>
                <c:pt idx="37">
                  <c:v>119702.6072998048</c:v>
                </c:pt>
                <c:pt idx="38">
                  <c:v>45980.40958658857</c:v>
                </c:pt>
                <c:pt idx="39">
                  <c:v>21761.39097086589</c:v>
                </c:pt>
                <c:pt idx="40">
                  <c:v>22638.23634847005</c:v>
                </c:pt>
                <c:pt idx="41">
                  <c:v>79310.3174641928</c:v>
                </c:pt>
                <c:pt idx="42">
                  <c:v>10068.6360880534</c:v>
                </c:pt>
                <c:pt idx="43">
                  <c:v>31692.53564453126</c:v>
                </c:pt>
                <c:pt idx="44">
                  <c:v>5286.622884114583</c:v>
                </c:pt>
                <c:pt idx="45">
                  <c:v>53505.63736979165</c:v>
                </c:pt>
                <c:pt idx="46">
                  <c:v>139811.717691932</c:v>
                </c:pt>
                <c:pt idx="47">
                  <c:v>9147.44623819987</c:v>
                </c:pt>
                <c:pt idx="48">
                  <c:v>3982.1709798177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A1E-4742-9BD5-5111983273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4961320"/>
        <c:axId val="-2124957672"/>
      </c:barChart>
      <c:catAx>
        <c:axId val="-2124961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957672"/>
        <c:crosses val="autoZero"/>
        <c:auto val="1"/>
        <c:lblAlgn val="ctr"/>
        <c:lblOffset val="100"/>
        <c:noMultiLvlLbl val="0"/>
      </c:catAx>
      <c:valAx>
        <c:axId val="-2124957672"/>
        <c:scaling>
          <c:orientation val="minMax"/>
          <c:min val="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961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81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82:$AE$112</c:f>
                <c:numCache>
                  <c:formatCode>General</c:formatCode>
                  <c:ptCount val="31"/>
                  <c:pt idx="0">
                    <c:v>3993.038311893597</c:v>
                  </c:pt>
                  <c:pt idx="1">
                    <c:v>586.3393600749098</c:v>
                  </c:pt>
                  <c:pt idx="2">
                    <c:v>2552.38191535003</c:v>
                  </c:pt>
                  <c:pt idx="3">
                    <c:v>14006.2353056284</c:v>
                  </c:pt>
                  <c:pt idx="4">
                    <c:v>78391.44687092701</c:v>
                  </c:pt>
                  <c:pt idx="5">
                    <c:v>29303.22717347225</c:v>
                  </c:pt>
                  <c:pt idx="6">
                    <c:v>2526.11393775111</c:v>
                  </c:pt>
                  <c:pt idx="7">
                    <c:v>49116.26032254245</c:v>
                  </c:pt>
                  <c:pt idx="8">
                    <c:v>88899.15349397543</c:v>
                  </c:pt>
                  <c:pt idx="9">
                    <c:v>14613.8474941914</c:v>
                  </c:pt>
                  <c:pt idx="10">
                    <c:v>6391.183433103316</c:v>
                  </c:pt>
                  <c:pt idx="11">
                    <c:v>152029.1686993351</c:v>
                  </c:pt>
                  <c:pt idx="12">
                    <c:v>17800.4601265858</c:v>
                  </c:pt>
                  <c:pt idx="13">
                    <c:v>2484.361204616191</c:v>
                  </c:pt>
                  <c:pt idx="14">
                    <c:v>23689.14055843653</c:v>
                  </c:pt>
                  <c:pt idx="15">
                    <c:v>7700.000099749825</c:v>
                  </c:pt>
                  <c:pt idx="16">
                    <c:v>9444.288081725657</c:v>
                  </c:pt>
                  <c:pt idx="17">
                    <c:v>17491.64425263044</c:v>
                  </c:pt>
                  <c:pt idx="18">
                    <c:v>794.6824864825827</c:v>
                  </c:pt>
                  <c:pt idx="19">
                    <c:v>6067.84467130441</c:v>
                  </c:pt>
                  <c:pt idx="20">
                    <c:v>11124.77080543473</c:v>
                  </c:pt>
                  <c:pt idx="21">
                    <c:v>9444.288081725657</c:v>
                  </c:pt>
                  <c:pt idx="22">
                    <c:v>699.9477094181744</c:v>
                  </c:pt>
                  <c:pt idx="23">
                    <c:v>1818.044205643953</c:v>
                  </c:pt>
                  <c:pt idx="24">
                    <c:v>45909.6566375261</c:v>
                  </c:pt>
                  <c:pt idx="25">
                    <c:v>1782.681372514762</c:v>
                  </c:pt>
                  <c:pt idx="26">
                    <c:v>9075.226727932596</c:v>
                  </c:pt>
                  <c:pt idx="27">
                    <c:v>3300.775654475971</c:v>
                  </c:pt>
                  <c:pt idx="28">
                    <c:v>8199.625616616627</c:v>
                  </c:pt>
                  <c:pt idx="29">
                    <c:v>3407.536235066841</c:v>
                  </c:pt>
                  <c:pt idx="30">
                    <c:v>3920.946278044747</c:v>
                  </c:pt>
                </c:numCache>
              </c:numRef>
            </c:plus>
            <c:minus>
              <c:numRef>
                <c:f>'Dharmafect Species'!$AE$82:$AE$112</c:f>
                <c:numCache>
                  <c:formatCode>General</c:formatCode>
                  <c:ptCount val="31"/>
                  <c:pt idx="0">
                    <c:v>3993.038311893597</c:v>
                  </c:pt>
                  <c:pt idx="1">
                    <c:v>586.3393600749098</c:v>
                  </c:pt>
                  <c:pt idx="2">
                    <c:v>2552.38191535003</c:v>
                  </c:pt>
                  <c:pt idx="3">
                    <c:v>14006.2353056284</c:v>
                  </c:pt>
                  <c:pt idx="4">
                    <c:v>78391.44687092701</c:v>
                  </c:pt>
                  <c:pt idx="5">
                    <c:v>29303.22717347225</c:v>
                  </c:pt>
                  <c:pt idx="6">
                    <c:v>2526.11393775111</c:v>
                  </c:pt>
                  <c:pt idx="7">
                    <c:v>49116.26032254245</c:v>
                  </c:pt>
                  <c:pt idx="8">
                    <c:v>88899.15349397543</c:v>
                  </c:pt>
                  <c:pt idx="9">
                    <c:v>14613.8474941914</c:v>
                  </c:pt>
                  <c:pt idx="10">
                    <c:v>6391.183433103316</c:v>
                  </c:pt>
                  <c:pt idx="11">
                    <c:v>152029.1686993351</c:v>
                  </c:pt>
                  <c:pt idx="12">
                    <c:v>17800.4601265858</c:v>
                  </c:pt>
                  <c:pt idx="13">
                    <c:v>2484.361204616191</c:v>
                  </c:pt>
                  <c:pt idx="14">
                    <c:v>23689.14055843653</c:v>
                  </c:pt>
                  <c:pt idx="15">
                    <c:v>7700.000099749825</c:v>
                  </c:pt>
                  <c:pt idx="16">
                    <c:v>9444.288081725657</c:v>
                  </c:pt>
                  <c:pt idx="17">
                    <c:v>17491.64425263044</c:v>
                  </c:pt>
                  <c:pt idx="18">
                    <c:v>794.6824864825827</c:v>
                  </c:pt>
                  <c:pt idx="19">
                    <c:v>6067.84467130441</c:v>
                  </c:pt>
                  <c:pt idx="20">
                    <c:v>11124.77080543473</c:v>
                  </c:pt>
                  <c:pt idx="21">
                    <c:v>9444.288081725657</c:v>
                  </c:pt>
                  <c:pt idx="22">
                    <c:v>699.9477094181744</c:v>
                  </c:pt>
                  <c:pt idx="23">
                    <c:v>1818.044205643953</c:v>
                  </c:pt>
                  <c:pt idx="24">
                    <c:v>45909.6566375261</c:v>
                  </c:pt>
                  <c:pt idx="25">
                    <c:v>1782.681372514762</c:v>
                  </c:pt>
                  <c:pt idx="26">
                    <c:v>9075.226727932596</c:v>
                  </c:pt>
                  <c:pt idx="27">
                    <c:v>3300.775654475971</c:v>
                  </c:pt>
                  <c:pt idx="28">
                    <c:v>8199.625616616627</c:v>
                  </c:pt>
                  <c:pt idx="29">
                    <c:v>3407.536235066841</c:v>
                  </c:pt>
                  <c:pt idx="30">
                    <c:v>3920.9462780447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82:$Y$112</c:f>
              <c:strCache>
                <c:ptCount val="31"/>
                <c:pt idx="0">
                  <c:v>LPC 16:0</c:v>
                </c:pt>
                <c:pt idx="1">
                  <c:v>LPC 18:1A</c:v>
                </c:pt>
                <c:pt idx="2">
                  <c:v>LPC 18:1B</c:v>
                </c:pt>
                <c:pt idx="3">
                  <c:v>PC 14:0_14:0</c:v>
                </c:pt>
                <c:pt idx="4">
                  <c:v>PC 14:0_16:0</c:v>
                </c:pt>
                <c:pt idx="5">
                  <c:v>PC 14:0_16:1</c:v>
                </c:pt>
                <c:pt idx="6">
                  <c:v>PC 14:0_20:4</c:v>
                </c:pt>
                <c:pt idx="7">
                  <c:v>PC 16:0_16:0</c:v>
                </c:pt>
                <c:pt idx="8">
                  <c:v>PC 16:0_16:1</c:v>
                </c:pt>
                <c:pt idx="9">
                  <c:v>PC 16:0_17:1</c:v>
                </c:pt>
                <c:pt idx="10">
                  <c:v>PC 16:0_18:0</c:v>
                </c:pt>
                <c:pt idx="11">
                  <c:v>PC 16:0_18:1</c:v>
                </c:pt>
                <c:pt idx="12">
                  <c:v>PC 16:0_20:1</c:v>
                </c:pt>
                <c:pt idx="13">
                  <c:v>PC 16:0_20:4</c:v>
                </c:pt>
                <c:pt idx="14">
                  <c:v>PC 16:0_20:5</c:v>
                </c:pt>
                <c:pt idx="15">
                  <c:v>PC 16:0_22:2</c:v>
                </c:pt>
                <c:pt idx="16">
                  <c:v>PC 16:0_22:6</c:v>
                </c:pt>
                <c:pt idx="17">
                  <c:v>PC 18:0_18:1</c:v>
                </c:pt>
                <c:pt idx="18">
                  <c:v>PC 18:0_20:3</c:v>
                </c:pt>
                <c:pt idx="19">
                  <c:v>PC 18:1_20:1</c:v>
                </c:pt>
                <c:pt idx="20">
                  <c:v>PC 18:1_20:5</c:v>
                </c:pt>
                <c:pt idx="21">
                  <c:v>PC 18:1_20:6</c:v>
                </c:pt>
                <c:pt idx="22">
                  <c:v>PC 18:1_22:4</c:v>
                </c:pt>
                <c:pt idx="23">
                  <c:v>PC 18:1_22:5</c:v>
                </c:pt>
                <c:pt idx="24">
                  <c:v>PC 18:2_16:0</c:v>
                </c:pt>
                <c:pt idx="25">
                  <c:v>PC 20:0_16:0</c:v>
                </c:pt>
                <c:pt idx="26">
                  <c:v>PC P-16:0_14:0</c:v>
                </c:pt>
                <c:pt idx="27">
                  <c:v>PC P-16:0_16:0</c:v>
                </c:pt>
                <c:pt idx="28">
                  <c:v>PC P-16:0_18:1</c:v>
                </c:pt>
                <c:pt idx="29">
                  <c:v>PC P-16:0_20:3</c:v>
                </c:pt>
                <c:pt idx="30">
                  <c:v>PC P-18:0_18:0</c:v>
                </c:pt>
              </c:strCache>
            </c:strRef>
          </c:cat>
          <c:val>
            <c:numRef>
              <c:f>'Dharmafect Species'!$Z$82:$Z$112</c:f>
              <c:numCache>
                <c:formatCode>General</c:formatCode>
                <c:ptCount val="31"/>
                <c:pt idx="0">
                  <c:v>37812.873819987</c:v>
                </c:pt>
                <c:pt idx="1">
                  <c:v>4085.196329752605</c:v>
                </c:pt>
                <c:pt idx="2">
                  <c:v>15624.861521403</c:v>
                </c:pt>
                <c:pt idx="3">
                  <c:v>161549.00825</c:v>
                </c:pt>
                <c:pt idx="4">
                  <c:v>612002.0102666666</c:v>
                </c:pt>
                <c:pt idx="5">
                  <c:v>360461.9547833333</c:v>
                </c:pt>
                <c:pt idx="6">
                  <c:v>11728.604247</c:v>
                </c:pt>
                <c:pt idx="7">
                  <c:v>681470.3707499997</c:v>
                </c:pt>
                <c:pt idx="8">
                  <c:v>1.28290004066667E6</c:v>
                </c:pt>
                <c:pt idx="9">
                  <c:v>154331.8613166667</c:v>
                </c:pt>
                <c:pt idx="10">
                  <c:v>61053.04134</c:v>
                </c:pt>
                <c:pt idx="11">
                  <c:v>1.84916883216667E6</c:v>
                </c:pt>
                <c:pt idx="12">
                  <c:v>176197.1736666666</c:v>
                </c:pt>
                <c:pt idx="13">
                  <c:v>25695.49039833333</c:v>
                </c:pt>
                <c:pt idx="14">
                  <c:v>171858.3347833333</c:v>
                </c:pt>
                <c:pt idx="15">
                  <c:v>63020.55118833332</c:v>
                </c:pt>
                <c:pt idx="16">
                  <c:v>78021.931965</c:v>
                </c:pt>
                <c:pt idx="17">
                  <c:v>185644.2367666667</c:v>
                </c:pt>
                <c:pt idx="18">
                  <c:v>8610.539916833333</c:v>
                </c:pt>
                <c:pt idx="19">
                  <c:v>57867.512165</c:v>
                </c:pt>
                <c:pt idx="20">
                  <c:v>104162.873395</c:v>
                </c:pt>
                <c:pt idx="21">
                  <c:v>78021.931965</c:v>
                </c:pt>
                <c:pt idx="22">
                  <c:v>4423.505778166667</c:v>
                </c:pt>
                <c:pt idx="23">
                  <c:v>10831.00423</c:v>
                </c:pt>
                <c:pt idx="24">
                  <c:v>562633.2740999996</c:v>
                </c:pt>
                <c:pt idx="25">
                  <c:v>11726.38606916667</c:v>
                </c:pt>
                <c:pt idx="26">
                  <c:v>34688.46407</c:v>
                </c:pt>
                <c:pt idx="27">
                  <c:v>67604.8925816666</c:v>
                </c:pt>
                <c:pt idx="28">
                  <c:v>63681.51135</c:v>
                </c:pt>
                <c:pt idx="29">
                  <c:v>47360.22440499999</c:v>
                </c:pt>
                <c:pt idx="30">
                  <c:v>29298.36979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626-46B3-BBBE-162DAE3C0705}"/>
            </c:ext>
          </c:extLst>
        </c:ser>
        <c:ser>
          <c:idx val="1"/>
          <c:order val="1"/>
          <c:tx>
            <c:strRef>
              <c:f>'Dharmafect Species'!$AA$81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82:$AF$112</c:f>
                <c:numCache>
                  <c:formatCode>General</c:formatCode>
                  <c:ptCount val="31"/>
                  <c:pt idx="0">
                    <c:v>4873.78503724553</c:v>
                  </c:pt>
                  <c:pt idx="1">
                    <c:v>630.2895361018332</c:v>
                  </c:pt>
                  <c:pt idx="2">
                    <c:v>1371.582450054497</c:v>
                  </c:pt>
                  <c:pt idx="3">
                    <c:v>16991.05217199878</c:v>
                  </c:pt>
                  <c:pt idx="4">
                    <c:v>119899.4625888393</c:v>
                  </c:pt>
                  <c:pt idx="5">
                    <c:v>35529.85624611856</c:v>
                  </c:pt>
                  <c:pt idx="6">
                    <c:v>1073.128931706505</c:v>
                  </c:pt>
                  <c:pt idx="7">
                    <c:v>57553.60194762327</c:v>
                  </c:pt>
                  <c:pt idx="8">
                    <c:v>98042.75049160588</c:v>
                  </c:pt>
                  <c:pt idx="9">
                    <c:v>12862.82701656559</c:v>
                  </c:pt>
                  <c:pt idx="10">
                    <c:v>5515.24402907163</c:v>
                  </c:pt>
                  <c:pt idx="11">
                    <c:v>201585.9622164636</c:v>
                  </c:pt>
                  <c:pt idx="12">
                    <c:v>18576.60530808653</c:v>
                  </c:pt>
                  <c:pt idx="13">
                    <c:v>2433.305059829898</c:v>
                  </c:pt>
                  <c:pt idx="14">
                    <c:v>13571.2668070414</c:v>
                  </c:pt>
                  <c:pt idx="15">
                    <c:v>5986.05673342323</c:v>
                  </c:pt>
                  <c:pt idx="16">
                    <c:v>8505.534378995998</c:v>
                  </c:pt>
                  <c:pt idx="17">
                    <c:v>18494.77902632208</c:v>
                  </c:pt>
                  <c:pt idx="18">
                    <c:v>461.2050303452449</c:v>
                  </c:pt>
                  <c:pt idx="19">
                    <c:v>7107.15604075101</c:v>
                  </c:pt>
                  <c:pt idx="20">
                    <c:v>11344.95790499876</c:v>
                  </c:pt>
                  <c:pt idx="21">
                    <c:v>8505.534378995998</c:v>
                  </c:pt>
                  <c:pt idx="22">
                    <c:v>756.4911932751795</c:v>
                  </c:pt>
                  <c:pt idx="23">
                    <c:v>1534.078263730231</c:v>
                  </c:pt>
                  <c:pt idx="24">
                    <c:v>47409.07542086862</c:v>
                  </c:pt>
                  <c:pt idx="25">
                    <c:v>1923.961637412993</c:v>
                  </c:pt>
                  <c:pt idx="26">
                    <c:v>3205.713169051424</c:v>
                  </c:pt>
                  <c:pt idx="27">
                    <c:v>4416.608304874427</c:v>
                  </c:pt>
                  <c:pt idx="28">
                    <c:v>4262.60369934246</c:v>
                  </c:pt>
                  <c:pt idx="29">
                    <c:v>5262.323094347138</c:v>
                  </c:pt>
                  <c:pt idx="30">
                    <c:v>3599.237564734601</c:v>
                  </c:pt>
                </c:numCache>
              </c:numRef>
            </c:plus>
            <c:minus>
              <c:numRef>
                <c:f>'Dharmafect Species'!$AF$82:$AF$112</c:f>
                <c:numCache>
                  <c:formatCode>General</c:formatCode>
                  <c:ptCount val="31"/>
                  <c:pt idx="0">
                    <c:v>4873.78503724553</c:v>
                  </c:pt>
                  <c:pt idx="1">
                    <c:v>630.2895361018332</c:v>
                  </c:pt>
                  <c:pt idx="2">
                    <c:v>1371.582450054497</c:v>
                  </c:pt>
                  <c:pt idx="3">
                    <c:v>16991.05217199878</c:v>
                  </c:pt>
                  <c:pt idx="4">
                    <c:v>119899.4625888393</c:v>
                  </c:pt>
                  <c:pt idx="5">
                    <c:v>35529.85624611856</c:v>
                  </c:pt>
                  <c:pt idx="6">
                    <c:v>1073.128931706505</c:v>
                  </c:pt>
                  <c:pt idx="7">
                    <c:v>57553.60194762327</c:v>
                  </c:pt>
                  <c:pt idx="8">
                    <c:v>98042.75049160588</c:v>
                  </c:pt>
                  <c:pt idx="9">
                    <c:v>12862.82701656559</c:v>
                  </c:pt>
                  <c:pt idx="10">
                    <c:v>5515.24402907163</c:v>
                  </c:pt>
                  <c:pt idx="11">
                    <c:v>201585.9622164636</c:v>
                  </c:pt>
                  <c:pt idx="12">
                    <c:v>18576.60530808653</c:v>
                  </c:pt>
                  <c:pt idx="13">
                    <c:v>2433.305059829898</c:v>
                  </c:pt>
                  <c:pt idx="14">
                    <c:v>13571.2668070414</c:v>
                  </c:pt>
                  <c:pt idx="15">
                    <c:v>5986.05673342323</c:v>
                  </c:pt>
                  <c:pt idx="16">
                    <c:v>8505.534378995998</c:v>
                  </c:pt>
                  <c:pt idx="17">
                    <c:v>18494.77902632208</c:v>
                  </c:pt>
                  <c:pt idx="18">
                    <c:v>461.2050303452449</c:v>
                  </c:pt>
                  <c:pt idx="19">
                    <c:v>7107.15604075101</c:v>
                  </c:pt>
                  <c:pt idx="20">
                    <c:v>11344.95790499876</c:v>
                  </c:pt>
                  <c:pt idx="21">
                    <c:v>8505.534378995998</c:v>
                  </c:pt>
                  <c:pt idx="22">
                    <c:v>756.4911932751795</c:v>
                  </c:pt>
                  <c:pt idx="23">
                    <c:v>1534.078263730231</c:v>
                  </c:pt>
                  <c:pt idx="24">
                    <c:v>47409.07542086862</c:v>
                  </c:pt>
                  <c:pt idx="25">
                    <c:v>1923.961637412993</c:v>
                  </c:pt>
                  <c:pt idx="26">
                    <c:v>3205.713169051424</c:v>
                  </c:pt>
                  <c:pt idx="27">
                    <c:v>4416.608304874427</c:v>
                  </c:pt>
                  <c:pt idx="28">
                    <c:v>4262.60369934246</c:v>
                  </c:pt>
                  <c:pt idx="29">
                    <c:v>5262.323094347138</c:v>
                  </c:pt>
                  <c:pt idx="30">
                    <c:v>3599.2375647346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82:$Y$112</c:f>
              <c:strCache>
                <c:ptCount val="31"/>
                <c:pt idx="0">
                  <c:v>LPC 16:0</c:v>
                </c:pt>
                <c:pt idx="1">
                  <c:v>LPC 18:1A</c:v>
                </c:pt>
                <c:pt idx="2">
                  <c:v>LPC 18:1B</c:v>
                </c:pt>
                <c:pt idx="3">
                  <c:v>PC 14:0_14:0</c:v>
                </c:pt>
                <c:pt idx="4">
                  <c:v>PC 14:0_16:0</c:v>
                </c:pt>
                <c:pt idx="5">
                  <c:v>PC 14:0_16:1</c:v>
                </c:pt>
                <c:pt idx="6">
                  <c:v>PC 14:0_20:4</c:v>
                </c:pt>
                <c:pt idx="7">
                  <c:v>PC 16:0_16:0</c:v>
                </c:pt>
                <c:pt idx="8">
                  <c:v>PC 16:0_16:1</c:v>
                </c:pt>
                <c:pt idx="9">
                  <c:v>PC 16:0_17:1</c:v>
                </c:pt>
                <c:pt idx="10">
                  <c:v>PC 16:0_18:0</c:v>
                </c:pt>
                <c:pt idx="11">
                  <c:v>PC 16:0_18:1</c:v>
                </c:pt>
                <c:pt idx="12">
                  <c:v>PC 16:0_20:1</c:v>
                </c:pt>
                <c:pt idx="13">
                  <c:v>PC 16:0_20:4</c:v>
                </c:pt>
                <c:pt idx="14">
                  <c:v>PC 16:0_20:5</c:v>
                </c:pt>
                <c:pt idx="15">
                  <c:v>PC 16:0_22:2</c:v>
                </c:pt>
                <c:pt idx="16">
                  <c:v>PC 16:0_22:6</c:v>
                </c:pt>
                <c:pt idx="17">
                  <c:v>PC 18:0_18:1</c:v>
                </c:pt>
                <c:pt idx="18">
                  <c:v>PC 18:0_20:3</c:v>
                </c:pt>
                <c:pt idx="19">
                  <c:v>PC 18:1_20:1</c:v>
                </c:pt>
                <c:pt idx="20">
                  <c:v>PC 18:1_20:5</c:v>
                </c:pt>
                <c:pt idx="21">
                  <c:v>PC 18:1_20:6</c:v>
                </c:pt>
                <c:pt idx="22">
                  <c:v>PC 18:1_22:4</c:v>
                </c:pt>
                <c:pt idx="23">
                  <c:v>PC 18:1_22:5</c:v>
                </c:pt>
                <c:pt idx="24">
                  <c:v>PC 18:2_16:0</c:v>
                </c:pt>
                <c:pt idx="25">
                  <c:v>PC 20:0_16:0</c:v>
                </c:pt>
                <c:pt idx="26">
                  <c:v>PC P-16:0_14:0</c:v>
                </c:pt>
                <c:pt idx="27">
                  <c:v>PC P-16:0_16:0</c:v>
                </c:pt>
                <c:pt idx="28">
                  <c:v>PC P-16:0_18:1</c:v>
                </c:pt>
                <c:pt idx="29">
                  <c:v>PC P-16:0_20:3</c:v>
                </c:pt>
                <c:pt idx="30">
                  <c:v>PC P-18:0_18:0</c:v>
                </c:pt>
              </c:strCache>
            </c:strRef>
          </c:cat>
          <c:val>
            <c:numRef>
              <c:f>'Dharmafect Species'!$AA$82:$AA$112</c:f>
              <c:numCache>
                <c:formatCode>General</c:formatCode>
                <c:ptCount val="31"/>
                <c:pt idx="0">
                  <c:v>34872.97528076169</c:v>
                </c:pt>
                <c:pt idx="1">
                  <c:v>4444.038045247396</c:v>
                </c:pt>
                <c:pt idx="2">
                  <c:v>15997.22977193197</c:v>
                </c:pt>
                <c:pt idx="3">
                  <c:v>145973.2681333333</c:v>
                </c:pt>
                <c:pt idx="4">
                  <c:v>633363.1787166664</c:v>
                </c:pt>
                <c:pt idx="5">
                  <c:v>315195.7837333334</c:v>
                </c:pt>
                <c:pt idx="6">
                  <c:v>9751.787840500002</c:v>
                </c:pt>
                <c:pt idx="7">
                  <c:v>769099.4824333334</c:v>
                </c:pt>
                <c:pt idx="8">
                  <c:v>1.19868520566667E6</c:v>
                </c:pt>
                <c:pt idx="9">
                  <c:v>152058.4563833333</c:v>
                </c:pt>
                <c:pt idx="10">
                  <c:v>76427.48177333333</c:v>
                </c:pt>
                <c:pt idx="11">
                  <c:v>1.8288744885E6</c:v>
                </c:pt>
                <c:pt idx="12">
                  <c:v>179723.194</c:v>
                </c:pt>
                <c:pt idx="13">
                  <c:v>28531.83919333333</c:v>
                </c:pt>
                <c:pt idx="14">
                  <c:v>173636.6603166667</c:v>
                </c:pt>
                <c:pt idx="15">
                  <c:v>58239.79998833331</c:v>
                </c:pt>
                <c:pt idx="16">
                  <c:v>95144.75489666664</c:v>
                </c:pt>
                <c:pt idx="17">
                  <c:v>191846.9767333333</c:v>
                </c:pt>
                <c:pt idx="18">
                  <c:v>10653.47859666666</c:v>
                </c:pt>
                <c:pt idx="19">
                  <c:v>53232.05932333333</c:v>
                </c:pt>
                <c:pt idx="20">
                  <c:v>123293.5963333333</c:v>
                </c:pt>
                <c:pt idx="21">
                  <c:v>95144.75489666664</c:v>
                </c:pt>
                <c:pt idx="22">
                  <c:v>7149.130899833332</c:v>
                </c:pt>
                <c:pt idx="23">
                  <c:v>12446.39298333333</c:v>
                </c:pt>
                <c:pt idx="24">
                  <c:v>564946.7792999996</c:v>
                </c:pt>
                <c:pt idx="25">
                  <c:v>10528.15095983333</c:v>
                </c:pt>
                <c:pt idx="26">
                  <c:v>48327.02897</c:v>
                </c:pt>
                <c:pt idx="27">
                  <c:v>69499.09993666664</c:v>
                </c:pt>
                <c:pt idx="28">
                  <c:v>58417.76039666665</c:v>
                </c:pt>
                <c:pt idx="29">
                  <c:v>45720.36470666665</c:v>
                </c:pt>
                <c:pt idx="30">
                  <c:v>27850.1936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626-46B3-BBBE-162DAE3C0705}"/>
            </c:ext>
          </c:extLst>
        </c:ser>
        <c:ser>
          <c:idx val="2"/>
          <c:order val="2"/>
          <c:tx>
            <c:strRef>
              <c:f>'Dharmafect Species'!$AB$81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82:$AG$112</c:f>
                <c:numCache>
                  <c:formatCode>General</c:formatCode>
                  <c:ptCount val="31"/>
                  <c:pt idx="0">
                    <c:v>5211.189169570815</c:v>
                  </c:pt>
                  <c:pt idx="1">
                    <c:v>742.189960277234</c:v>
                  </c:pt>
                  <c:pt idx="2">
                    <c:v>2579.327044822625</c:v>
                  </c:pt>
                  <c:pt idx="3">
                    <c:v>31549.17501770456</c:v>
                  </c:pt>
                  <c:pt idx="4">
                    <c:v>175993.8504366851</c:v>
                  </c:pt>
                  <c:pt idx="5">
                    <c:v>156541.5688090047</c:v>
                  </c:pt>
                  <c:pt idx="6">
                    <c:v>6440.61439822876</c:v>
                  </c:pt>
                  <c:pt idx="7">
                    <c:v>122745.5721606607</c:v>
                  </c:pt>
                  <c:pt idx="8">
                    <c:v>249500.8127095211</c:v>
                  </c:pt>
                  <c:pt idx="9">
                    <c:v>26093.16340203927</c:v>
                  </c:pt>
                  <c:pt idx="10">
                    <c:v>15500.04811760501</c:v>
                  </c:pt>
                  <c:pt idx="11">
                    <c:v>320525.5119130773</c:v>
                  </c:pt>
                  <c:pt idx="12">
                    <c:v>35887.26757533955</c:v>
                  </c:pt>
                  <c:pt idx="13">
                    <c:v>5532.461058899658</c:v>
                  </c:pt>
                  <c:pt idx="14">
                    <c:v>51792.51241876976</c:v>
                  </c:pt>
                  <c:pt idx="15">
                    <c:v>12428.21961462303</c:v>
                  </c:pt>
                  <c:pt idx="16">
                    <c:v>22894.83238742237</c:v>
                  </c:pt>
                  <c:pt idx="17">
                    <c:v>37097.89949557053</c:v>
                  </c:pt>
                  <c:pt idx="18">
                    <c:v>1599.096659224453</c:v>
                  </c:pt>
                  <c:pt idx="19">
                    <c:v>11486.37147622304</c:v>
                  </c:pt>
                  <c:pt idx="20">
                    <c:v>29011.85330027522</c:v>
                  </c:pt>
                  <c:pt idx="21">
                    <c:v>22736.96662368281</c:v>
                  </c:pt>
                  <c:pt idx="22">
                    <c:v>1408.463510232541</c:v>
                  </c:pt>
                  <c:pt idx="23">
                    <c:v>2449.600641130151</c:v>
                  </c:pt>
                  <c:pt idx="24">
                    <c:v>148518.1649594363</c:v>
                  </c:pt>
                  <c:pt idx="25">
                    <c:v>1699.700161037291</c:v>
                  </c:pt>
                  <c:pt idx="26">
                    <c:v>8657.619343535636</c:v>
                  </c:pt>
                  <c:pt idx="27">
                    <c:v>6508.365938011133</c:v>
                  </c:pt>
                  <c:pt idx="28">
                    <c:v>9640.654037521242</c:v>
                  </c:pt>
                  <c:pt idx="29">
                    <c:v>6268.86566560189</c:v>
                  </c:pt>
                  <c:pt idx="30">
                    <c:v>6137.926930209195</c:v>
                  </c:pt>
                </c:numCache>
              </c:numRef>
            </c:plus>
            <c:minus>
              <c:numRef>
                <c:f>'Dharmafect Species'!$AG$82:$AG$112</c:f>
                <c:numCache>
                  <c:formatCode>General</c:formatCode>
                  <c:ptCount val="31"/>
                  <c:pt idx="0">
                    <c:v>5211.189169570815</c:v>
                  </c:pt>
                  <c:pt idx="1">
                    <c:v>742.189960277234</c:v>
                  </c:pt>
                  <c:pt idx="2">
                    <c:v>2579.327044822625</c:v>
                  </c:pt>
                  <c:pt idx="3">
                    <c:v>31549.17501770456</c:v>
                  </c:pt>
                  <c:pt idx="4">
                    <c:v>175993.8504366851</c:v>
                  </c:pt>
                  <c:pt idx="5">
                    <c:v>156541.5688090047</c:v>
                  </c:pt>
                  <c:pt idx="6">
                    <c:v>6440.61439822876</c:v>
                  </c:pt>
                  <c:pt idx="7">
                    <c:v>122745.5721606607</c:v>
                  </c:pt>
                  <c:pt idx="8">
                    <c:v>249500.8127095211</c:v>
                  </c:pt>
                  <c:pt idx="9">
                    <c:v>26093.16340203927</c:v>
                  </c:pt>
                  <c:pt idx="10">
                    <c:v>15500.04811760501</c:v>
                  </c:pt>
                  <c:pt idx="11">
                    <c:v>320525.5119130773</c:v>
                  </c:pt>
                  <c:pt idx="12">
                    <c:v>35887.26757533955</c:v>
                  </c:pt>
                  <c:pt idx="13">
                    <c:v>5532.461058899658</c:v>
                  </c:pt>
                  <c:pt idx="14">
                    <c:v>51792.51241876976</c:v>
                  </c:pt>
                  <c:pt idx="15">
                    <c:v>12428.21961462303</c:v>
                  </c:pt>
                  <c:pt idx="16">
                    <c:v>22894.83238742237</c:v>
                  </c:pt>
                  <c:pt idx="17">
                    <c:v>37097.89949557053</c:v>
                  </c:pt>
                  <c:pt idx="18">
                    <c:v>1599.096659224453</c:v>
                  </c:pt>
                  <c:pt idx="19">
                    <c:v>11486.37147622304</c:v>
                  </c:pt>
                  <c:pt idx="20">
                    <c:v>29011.85330027522</c:v>
                  </c:pt>
                  <c:pt idx="21">
                    <c:v>22736.96662368281</c:v>
                  </c:pt>
                  <c:pt idx="22">
                    <c:v>1408.463510232541</c:v>
                  </c:pt>
                  <c:pt idx="23">
                    <c:v>2449.600641130151</c:v>
                  </c:pt>
                  <c:pt idx="24">
                    <c:v>148518.1649594363</c:v>
                  </c:pt>
                  <c:pt idx="25">
                    <c:v>1699.700161037291</c:v>
                  </c:pt>
                  <c:pt idx="26">
                    <c:v>8657.619343535636</c:v>
                  </c:pt>
                  <c:pt idx="27">
                    <c:v>6508.365938011133</c:v>
                  </c:pt>
                  <c:pt idx="28">
                    <c:v>9640.654037521242</c:v>
                  </c:pt>
                  <c:pt idx="29">
                    <c:v>6268.86566560189</c:v>
                  </c:pt>
                  <c:pt idx="30">
                    <c:v>6137.9269302091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82:$Y$112</c:f>
              <c:strCache>
                <c:ptCount val="31"/>
                <c:pt idx="0">
                  <c:v>LPC 16:0</c:v>
                </c:pt>
                <c:pt idx="1">
                  <c:v>LPC 18:1A</c:v>
                </c:pt>
                <c:pt idx="2">
                  <c:v>LPC 18:1B</c:v>
                </c:pt>
                <c:pt idx="3">
                  <c:v>PC 14:0_14:0</c:v>
                </c:pt>
                <c:pt idx="4">
                  <c:v>PC 14:0_16:0</c:v>
                </c:pt>
                <c:pt idx="5">
                  <c:v>PC 14:0_16:1</c:v>
                </c:pt>
                <c:pt idx="6">
                  <c:v>PC 14:0_20:4</c:v>
                </c:pt>
                <c:pt idx="7">
                  <c:v>PC 16:0_16:0</c:v>
                </c:pt>
                <c:pt idx="8">
                  <c:v>PC 16:0_16:1</c:v>
                </c:pt>
                <c:pt idx="9">
                  <c:v>PC 16:0_17:1</c:v>
                </c:pt>
                <c:pt idx="10">
                  <c:v>PC 16:0_18:0</c:v>
                </c:pt>
                <c:pt idx="11">
                  <c:v>PC 16:0_18:1</c:v>
                </c:pt>
                <c:pt idx="12">
                  <c:v>PC 16:0_20:1</c:v>
                </c:pt>
                <c:pt idx="13">
                  <c:v>PC 16:0_20:4</c:v>
                </c:pt>
                <c:pt idx="14">
                  <c:v>PC 16:0_20:5</c:v>
                </c:pt>
                <c:pt idx="15">
                  <c:v>PC 16:0_22:2</c:v>
                </c:pt>
                <c:pt idx="16">
                  <c:v>PC 16:0_22:6</c:v>
                </c:pt>
                <c:pt idx="17">
                  <c:v>PC 18:0_18:1</c:v>
                </c:pt>
                <c:pt idx="18">
                  <c:v>PC 18:0_20:3</c:v>
                </c:pt>
                <c:pt idx="19">
                  <c:v>PC 18:1_20:1</c:v>
                </c:pt>
                <c:pt idx="20">
                  <c:v>PC 18:1_20:5</c:v>
                </c:pt>
                <c:pt idx="21">
                  <c:v>PC 18:1_20:6</c:v>
                </c:pt>
                <c:pt idx="22">
                  <c:v>PC 18:1_22:4</c:v>
                </c:pt>
                <c:pt idx="23">
                  <c:v>PC 18:1_22:5</c:v>
                </c:pt>
                <c:pt idx="24">
                  <c:v>PC 18:2_16:0</c:v>
                </c:pt>
                <c:pt idx="25">
                  <c:v>PC 20:0_16:0</c:v>
                </c:pt>
                <c:pt idx="26">
                  <c:v>PC P-16:0_14:0</c:v>
                </c:pt>
                <c:pt idx="27">
                  <c:v>PC P-16:0_16:0</c:v>
                </c:pt>
                <c:pt idx="28">
                  <c:v>PC P-16:0_18:1</c:v>
                </c:pt>
                <c:pt idx="29">
                  <c:v>PC P-16:0_20:3</c:v>
                </c:pt>
                <c:pt idx="30">
                  <c:v>PC P-18:0_18:0</c:v>
                </c:pt>
              </c:strCache>
            </c:strRef>
          </c:cat>
          <c:val>
            <c:numRef>
              <c:f>'Dharmafect Species'!$AB$82:$AB$112</c:f>
              <c:numCache>
                <c:formatCode>General</c:formatCode>
                <c:ptCount val="31"/>
                <c:pt idx="0">
                  <c:v>27410.15004475913</c:v>
                </c:pt>
                <c:pt idx="1">
                  <c:v>3419.647735595705</c:v>
                </c:pt>
                <c:pt idx="2">
                  <c:v>11784.18659210206</c:v>
                </c:pt>
                <c:pt idx="3">
                  <c:v>113346.002405</c:v>
                </c:pt>
                <c:pt idx="4">
                  <c:v>465724.5937333334</c:v>
                </c:pt>
                <c:pt idx="5">
                  <c:v>286381.3805333334</c:v>
                </c:pt>
                <c:pt idx="6">
                  <c:v>12617.49772133333</c:v>
                </c:pt>
                <c:pt idx="7">
                  <c:v>667258.6796833335</c:v>
                </c:pt>
                <c:pt idx="8">
                  <c:v>1.01784684478333E6</c:v>
                </c:pt>
                <c:pt idx="9">
                  <c:v>144845.0410166667</c:v>
                </c:pt>
                <c:pt idx="10">
                  <c:v>75054.98274666663</c:v>
                </c:pt>
                <c:pt idx="11">
                  <c:v>1.55316357683333E6</c:v>
                </c:pt>
                <c:pt idx="12">
                  <c:v>179888.2765166667</c:v>
                </c:pt>
                <c:pt idx="13">
                  <c:v>22500.60270333333</c:v>
                </c:pt>
                <c:pt idx="14">
                  <c:v>192923.5296333333</c:v>
                </c:pt>
                <c:pt idx="15">
                  <c:v>46739.46531166664</c:v>
                </c:pt>
                <c:pt idx="16">
                  <c:v>105736.4479183333</c:v>
                </c:pt>
                <c:pt idx="17">
                  <c:v>191115.43795</c:v>
                </c:pt>
                <c:pt idx="18">
                  <c:v>11064.3802895</c:v>
                </c:pt>
                <c:pt idx="19">
                  <c:v>41792.45166166665</c:v>
                </c:pt>
                <c:pt idx="20">
                  <c:v>119166.9972333333</c:v>
                </c:pt>
                <c:pt idx="21">
                  <c:v>105865.4309916667</c:v>
                </c:pt>
                <c:pt idx="22">
                  <c:v>7770.375691833334</c:v>
                </c:pt>
                <c:pt idx="23">
                  <c:v>14877.54044666667</c:v>
                </c:pt>
                <c:pt idx="24">
                  <c:v>461808.3711</c:v>
                </c:pt>
                <c:pt idx="25">
                  <c:v>8134.439941333332</c:v>
                </c:pt>
                <c:pt idx="26">
                  <c:v>34202.20662333332</c:v>
                </c:pt>
                <c:pt idx="27">
                  <c:v>54304.57747333332</c:v>
                </c:pt>
                <c:pt idx="28">
                  <c:v>44969.93562833333</c:v>
                </c:pt>
                <c:pt idx="29">
                  <c:v>40358.75298833333</c:v>
                </c:pt>
                <c:pt idx="30">
                  <c:v>22097.716958333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626-46B3-BBBE-162DAE3C07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4871640"/>
        <c:axId val="-2124867992"/>
      </c:barChart>
      <c:catAx>
        <c:axId val="-2124871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867992"/>
        <c:crosses val="autoZero"/>
        <c:auto val="1"/>
        <c:lblAlgn val="ctr"/>
        <c:lblOffset val="100"/>
        <c:noMultiLvlLbl val="0"/>
      </c:catAx>
      <c:valAx>
        <c:axId val="-2124867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8716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117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118:$AE$138</c:f>
                <c:numCache>
                  <c:formatCode>General</c:formatCode>
                  <c:ptCount val="21"/>
                  <c:pt idx="0">
                    <c:v>806.6130065044063</c:v>
                  </c:pt>
                  <c:pt idx="1">
                    <c:v>439.7731607522698</c:v>
                  </c:pt>
                  <c:pt idx="2">
                    <c:v>328.3614501326037</c:v>
                  </c:pt>
                  <c:pt idx="3">
                    <c:v>2638.15593755348</c:v>
                  </c:pt>
                  <c:pt idx="4">
                    <c:v>19970.3322176541</c:v>
                  </c:pt>
                  <c:pt idx="5">
                    <c:v>31874.02218355686</c:v>
                  </c:pt>
                  <c:pt idx="6">
                    <c:v>10378.536179976</c:v>
                  </c:pt>
                  <c:pt idx="7">
                    <c:v>839.8872069553146</c:v>
                  </c:pt>
                  <c:pt idx="8">
                    <c:v>79.32028698726816</c:v>
                  </c:pt>
                  <c:pt idx="9">
                    <c:v>1236.613075469466</c:v>
                  </c:pt>
                  <c:pt idx="10">
                    <c:v>706.1893744734878</c:v>
                  </c:pt>
                  <c:pt idx="11">
                    <c:v>542.9782043454053</c:v>
                  </c:pt>
                  <c:pt idx="12">
                    <c:v>5975.46563847024</c:v>
                  </c:pt>
                  <c:pt idx="13">
                    <c:v>590.481892724682</c:v>
                  </c:pt>
                  <c:pt idx="14">
                    <c:v>6800.364008144523</c:v>
                  </c:pt>
                  <c:pt idx="15">
                    <c:v>253.6499478789936</c:v>
                  </c:pt>
                  <c:pt idx="16">
                    <c:v>582.8121432044811</c:v>
                  </c:pt>
                  <c:pt idx="17">
                    <c:v>147.9691902789164</c:v>
                  </c:pt>
                  <c:pt idx="18">
                    <c:v>248.1083605564582</c:v>
                  </c:pt>
                  <c:pt idx="19">
                    <c:v>1368.146150075386</c:v>
                  </c:pt>
                  <c:pt idx="20">
                    <c:v>7440.551987575715</c:v>
                  </c:pt>
                </c:numCache>
              </c:numRef>
            </c:plus>
            <c:minus>
              <c:numRef>
                <c:f>'Dharmafect Species'!$AE$118:$AE$138</c:f>
                <c:numCache>
                  <c:formatCode>General</c:formatCode>
                  <c:ptCount val="21"/>
                  <c:pt idx="0">
                    <c:v>806.6130065044063</c:v>
                  </c:pt>
                  <c:pt idx="1">
                    <c:v>439.7731607522698</c:v>
                  </c:pt>
                  <c:pt idx="2">
                    <c:v>328.3614501326037</c:v>
                  </c:pt>
                  <c:pt idx="3">
                    <c:v>2638.15593755348</c:v>
                  </c:pt>
                  <c:pt idx="4">
                    <c:v>19970.3322176541</c:v>
                  </c:pt>
                  <c:pt idx="5">
                    <c:v>31874.02218355686</c:v>
                  </c:pt>
                  <c:pt idx="6">
                    <c:v>10378.536179976</c:v>
                  </c:pt>
                  <c:pt idx="7">
                    <c:v>839.8872069553146</c:v>
                  </c:pt>
                  <c:pt idx="8">
                    <c:v>79.32028698726816</c:v>
                  </c:pt>
                  <c:pt idx="9">
                    <c:v>1236.613075469466</c:v>
                  </c:pt>
                  <c:pt idx="10">
                    <c:v>706.1893744734878</c:v>
                  </c:pt>
                  <c:pt idx="11">
                    <c:v>542.9782043454053</c:v>
                  </c:pt>
                  <c:pt idx="12">
                    <c:v>5975.46563847024</c:v>
                  </c:pt>
                  <c:pt idx="13">
                    <c:v>590.481892724682</c:v>
                  </c:pt>
                  <c:pt idx="14">
                    <c:v>6800.364008144523</c:v>
                  </c:pt>
                  <c:pt idx="15">
                    <c:v>253.6499478789936</c:v>
                  </c:pt>
                  <c:pt idx="16">
                    <c:v>582.8121432044811</c:v>
                  </c:pt>
                  <c:pt idx="17">
                    <c:v>147.9691902789164</c:v>
                  </c:pt>
                  <c:pt idx="18">
                    <c:v>248.1083605564582</c:v>
                  </c:pt>
                  <c:pt idx="19">
                    <c:v>1368.146150075386</c:v>
                  </c:pt>
                  <c:pt idx="20">
                    <c:v>7440.5519875757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18:$Y$138</c:f>
              <c:strCache>
                <c:ptCount val="21"/>
                <c:pt idx="0">
                  <c:v>PG 14:0_16:0</c:v>
                </c:pt>
                <c:pt idx="1">
                  <c:v>PG 14:0_18:2</c:v>
                </c:pt>
                <c:pt idx="2">
                  <c:v>PG 16:0_16:0</c:v>
                </c:pt>
                <c:pt idx="3">
                  <c:v>PG 16:0_16:1</c:v>
                </c:pt>
                <c:pt idx="4">
                  <c:v>PG 16:0_18:0</c:v>
                </c:pt>
                <c:pt idx="5">
                  <c:v>PG 16:0_18:1</c:v>
                </c:pt>
                <c:pt idx="6">
                  <c:v>PG 16:0_20:1</c:v>
                </c:pt>
                <c:pt idx="7">
                  <c:v>PG 16:0_22:6A</c:v>
                </c:pt>
                <c:pt idx="8">
                  <c:v>PG 16:0_22:6B</c:v>
                </c:pt>
                <c:pt idx="9">
                  <c:v>PG 16:1_18:1</c:v>
                </c:pt>
                <c:pt idx="10">
                  <c:v>PG 16:1_22:6</c:v>
                </c:pt>
                <c:pt idx="11">
                  <c:v>PG 18:0_22:6</c:v>
                </c:pt>
                <c:pt idx="12">
                  <c:v>PG 18:1_18:1</c:v>
                </c:pt>
                <c:pt idx="13">
                  <c:v>PG 18:1_22:5</c:v>
                </c:pt>
                <c:pt idx="14">
                  <c:v>PG 18:1_22:6</c:v>
                </c:pt>
                <c:pt idx="15">
                  <c:v>PG 18:2_22:6</c:v>
                </c:pt>
                <c:pt idx="16">
                  <c:v>PG 20:3_22:6</c:v>
                </c:pt>
                <c:pt idx="17">
                  <c:v>PG 20:5_22:6</c:v>
                </c:pt>
                <c:pt idx="18">
                  <c:v>PG 22:4_22:6</c:v>
                </c:pt>
                <c:pt idx="19">
                  <c:v>PG 22:5_22:6</c:v>
                </c:pt>
                <c:pt idx="20">
                  <c:v>PG 22:6_22:6</c:v>
                </c:pt>
              </c:strCache>
            </c:strRef>
          </c:cat>
          <c:val>
            <c:numRef>
              <c:f>'Dharmafect Species'!$Z$118:$Z$138</c:f>
              <c:numCache>
                <c:formatCode>General</c:formatCode>
                <c:ptCount val="21"/>
                <c:pt idx="0">
                  <c:v>5144.43304189046</c:v>
                </c:pt>
                <c:pt idx="1">
                  <c:v>3273.066551208497</c:v>
                </c:pt>
                <c:pt idx="2">
                  <c:v>2232.661544799803</c:v>
                </c:pt>
                <c:pt idx="3">
                  <c:v>21056.44326019287</c:v>
                </c:pt>
                <c:pt idx="4">
                  <c:v>86258.55744732301</c:v>
                </c:pt>
                <c:pt idx="5">
                  <c:v>303882.3018096455</c:v>
                </c:pt>
                <c:pt idx="6">
                  <c:v>65447.34448242191</c:v>
                </c:pt>
                <c:pt idx="7">
                  <c:v>5797.813771565755</c:v>
                </c:pt>
                <c:pt idx="8">
                  <c:v>1904.80458577474</c:v>
                </c:pt>
                <c:pt idx="9">
                  <c:v>10928.34643554687</c:v>
                </c:pt>
                <c:pt idx="10">
                  <c:v>6024.81266276042</c:v>
                </c:pt>
                <c:pt idx="11">
                  <c:v>4912.624348958335</c:v>
                </c:pt>
                <c:pt idx="12">
                  <c:v>38454.65917968749</c:v>
                </c:pt>
                <c:pt idx="13">
                  <c:v>4823.337677001954</c:v>
                </c:pt>
                <c:pt idx="14">
                  <c:v>43363.5491205851</c:v>
                </c:pt>
                <c:pt idx="15">
                  <c:v>1939.091224670411</c:v>
                </c:pt>
                <c:pt idx="16">
                  <c:v>2427.847544352215</c:v>
                </c:pt>
                <c:pt idx="17">
                  <c:v>952.1088765462247</c:v>
                </c:pt>
                <c:pt idx="18">
                  <c:v>1073.306546529134</c:v>
                </c:pt>
                <c:pt idx="19">
                  <c:v>5743.928064982097</c:v>
                </c:pt>
                <c:pt idx="20">
                  <c:v>24742.027282714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410-430C-92DB-D57B47C85C7C}"/>
            </c:ext>
          </c:extLst>
        </c:ser>
        <c:ser>
          <c:idx val="1"/>
          <c:order val="1"/>
          <c:tx>
            <c:strRef>
              <c:f>'Dharmafect Species'!$AA$117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118:$AF$138</c:f>
                <c:numCache>
                  <c:formatCode>General</c:formatCode>
                  <c:ptCount val="21"/>
                  <c:pt idx="0">
                    <c:v>773.1913299598938</c:v>
                  </c:pt>
                  <c:pt idx="1">
                    <c:v>587.3946570422171</c:v>
                  </c:pt>
                  <c:pt idx="2">
                    <c:v>168.1705639582035</c:v>
                  </c:pt>
                  <c:pt idx="3">
                    <c:v>2160.564366932373</c:v>
                  </c:pt>
                  <c:pt idx="4">
                    <c:v>30586.16932166355</c:v>
                  </c:pt>
                  <c:pt idx="5">
                    <c:v>51893.39129727014</c:v>
                  </c:pt>
                  <c:pt idx="6">
                    <c:v>13771.82859306714</c:v>
                  </c:pt>
                  <c:pt idx="7">
                    <c:v>764.4858680336196</c:v>
                  </c:pt>
                  <c:pt idx="8">
                    <c:v>411.5567934959607</c:v>
                  </c:pt>
                  <c:pt idx="9">
                    <c:v>1418.40338799852</c:v>
                  </c:pt>
                  <c:pt idx="10">
                    <c:v>1034.288718435982</c:v>
                  </c:pt>
                  <c:pt idx="11">
                    <c:v>836.1099297008544</c:v>
                  </c:pt>
                  <c:pt idx="12">
                    <c:v>4387.044212982702</c:v>
                  </c:pt>
                  <c:pt idx="13">
                    <c:v>853.0012886352878</c:v>
                  </c:pt>
                  <c:pt idx="14">
                    <c:v>8281.31581988164</c:v>
                  </c:pt>
                  <c:pt idx="15">
                    <c:v>289.0094563475431</c:v>
                  </c:pt>
                  <c:pt idx="16">
                    <c:v>225.5584818286703</c:v>
                  </c:pt>
                  <c:pt idx="17">
                    <c:v>275.9261371769362</c:v>
                  </c:pt>
                  <c:pt idx="18">
                    <c:v>504.4330019596055</c:v>
                  </c:pt>
                  <c:pt idx="19">
                    <c:v>1469.438112460673</c:v>
                  </c:pt>
                  <c:pt idx="20">
                    <c:v>8029.56079422035</c:v>
                  </c:pt>
                </c:numCache>
              </c:numRef>
            </c:plus>
            <c:minus>
              <c:numRef>
                <c:f>'Dharmafect Species'!$AF$118:$AF$138</c:f>
                <c:numCache>
                  <c:formatCode>General</c:formatCode>
                  <c:ptCount val="21"/>
                  <c:pt idx="0">
                    <c:v>773.1913299598938</c:v>
                  </c:pt>
                  <c:pt idx="1">
                    <c:v>587.3946570422171</c:v>
                  </c:pt>
                  <c:pt idx="2">
                    <c:v>168.1705639582035</c:v>
                  </c:pt>
                  <c:pt idx="3">
                    <c:v>2160.564366932373</c:v>
                  </c:pt>
                  <c:pt idx="4">
                    <c:v>30586.16932166355</c:v>
                  </c:pt>
                  <c:pt idx="5">
                    <c:v>51893.39129727014</c:v>
                  </c:pt>
                  <c:pt idx="6">
                    <c:v>13771.82859306714</c:v>
                  </c:pt>
                  <c:pt idx="7">
                    <c:v>764.4858680336196</c:v>
                  </c:pt>
                  <c:pt idx="8">
                    <c:v>411.5567934959607</c:v>
                  </c:pt>
                  <c:pt idx="9">
                    <c:v>1418.40338799852</c:v>
                  </c:pt>
                  <c:pt idx="10">
                    <c:v>1034.288718435982</c:v>
                  </c:pt>
                  <c:pt idx="11">
                    <c:v>836.1099297008544</c:v>
                  </c:pt>
                  <c:pt idx="12">
                    <c:v>4387.044212982702</c:v>
                  </c:pt>
                  <c:pt idx="13">
                    <c:v>853.0012886352878</c:v>
                  </c:pt>
                  <c:pt idx="14">
                    <c:v>8281.31581988164</c:v>
                  </c:pt>
                  <c:pt idx="15">
                    <c:v>289.0094563475431</c:v>
                  </c:pt>
                  <c:pt idx="16">
                    <c:v>225.5584818286703</c:v>
                  </c:pt>
                  <c:pt idx="17">
                    <c:v>275.9261371769362</c:v>
                  </c:pt>
                  <c:pt idx="18">
                    <c:v>504.4330019596055</c:v>
                  </c:pt>
                  <c:pt idx="19">
                    <c:v>1469.438112460673</c:v>
                  </c:pt>
                  <c:pt idx="20">
                    <c:v>8029.56079422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18:$Y$138</c:f>
              <c:strCache>
                <c:ptCount val="21"/>
                <c:pt idx="0">
                  <c:v>PG 14:0_16:0</c:v>
                </c:pt>
                <c:pt idx="1">
                  <c:v>PG 14:0_18:2</c:v>
                </c:pt>
                <c:pt idx="2">
                  <c:v>PG 16:0_16:0</c:v>
                </c:pt>
                <c:pt idx="3">
                  <c:v>PG 16:0_16:1</c:v>
                </c:pt>
                <c:pt idx="4">
                  <c:v>PG 16:0_18:0</c:v>
                </c:pt>
                <c:pt idx="5">
                  <c:v>PG 16:0_18:1</c:v>
                </c:pt>
                <c:pt idx="6">
                  <c:v>PG 16:0_20:1</c:v>
                </c:pt>
                <c:pt idx="7">
                  <c:v>PG 16:0_22:6A</c:v>
                </c:pt>
                <c:pt idx="8">
                  <c:v>PG 16:0_22:6B</c:v>
                </c:pt>
                <c:pt idx="9">
                  <c:v>PG 16:1_18:1</c:v>
                </c:pt>
                <c:pt idx="10">
                  <c:v>PG 16:1_22:6</c:v>
                </c:pt>
                <c:pt idx="11">
                  <c:v>PG 18:0_22:6</c:v>
                </c:pt>
                <c:pt idx="12">
                  <c:v>PG 18:1_18:1</c:v>
                </c:pt>
                <c:pt idx="13">
                  <c:v>PG 18:1_22:5</c:v>
                </c:pt>
                <c:pt idx="14">
                  <c:v>PG 18:1_22:6</c:v>
                </c:pt>
                <c:pt idx="15">
                  <c:v>PG 18:2_22:6</c:v>
                </c:pt>
                <c:pt idx="16">
                  <c:v>PG 20:3_22:6</c:v>
                </c:pt>
                <c:pt idx="17">
                  <c:v>PG 20:5_22:6</c:v>
                </c:pt>
                <c:pt idx="18">
                  <c:v>PG 22:4_22:6</c:v>
                </c:pt>
                <c:pt idx="19">
                  <c:v>PG 22:5_22:6</c:v>
                </c:pt>
                <c:pt idx="20">
                  <c:v>PG 22:6_22:6</c:v>
                </c:pt>
              </c:strCache>
            </c:strRef>
          </c:cat>
          <c:val>
            <c:numRef>
              <c:f>'Dharmafect Species'!$AA$118:$AA$138</c:f>
              <c:numCache>
                <c:formatCode>General</c:formatCode>
                <c:ptCount val="21"/>
                <c:pt idx="0">
                  <c:v>4907.015141805013</c:v>
                </c:pt>
                <c:pt idx="1">
                  <c:v>3636.221585591636</c:v>
                </c:pt>
                <c:pt idx="2">
                  <c:v>2170.9508005778</c:v>
                </c:pt>
                <c:pt idx="3">
                  <c:v>18638.98043823242</c:v>
                </c:pt>
                <c:pt idx="4">
                  <c:v>102706.4297939138</c:v>
                </c:pt>
                <c:pt idx="5">
                  <c:v>268784.9323131878</c:v>
                </c:pt>
                <c:pt idx="6">
                  <c:v>61601.70385742191</c:v>
                </c:pt>
                <c:pt idx="7">
                  <c:v>7394.898091634112</c:v>
                </c:pt>
                <c:pt idx="8">
                  <c:v>2083.141265869143</c:v>
                </c:pt>
                <c:pt idx="9">
                  <c:v>7996.74057006836</c:v>
                </c:pt>
                <c:pt idx="10">
                  <c:v>9978.220901489249</c:v>
                </c:pt>
                <c:pt idx="11">
                  <c:v>5991.641031901043</c:v>
                </c:pt>
                <c:pt idx="12">
                  <c:v>23860.51651000978</c:v>
                </c:pt>
                <c:pt idx="13">
                  <c:v>5958.456115722659</c:v>
                </c:pt>
                <c:pt idx="14">
                  <c:v>61368.16571807861</c:v>
                </c:pt>
                <c:pt idx="15">
                  <c:v>3503.691057840984</c:v>
                </c:pt>
                <c:pt idx="16">
                  <c:v>2601.191792805992</c:v>
                </c:pt>
                <c:pt idx="17">
                  <c:v>2047.03415934245</c:v>
                </c:pt>
                <c:pt idx="18">
                  <c:v>2030.637959798177</c:v>
                </c:pt>
                <c:pt idx="19">
                  <c:v>16583.45196533205</c:v>
                </c:pt>
                <c:pt idx="20">
                  <c:v>74809.827250162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410-430C-92DB-D57B47C85C7C}"/>
            </c:ext>
          </c:extLst>
        </c:ser>
        <c:ser>
          <c:idx val="2"/>
          <c:order val="2"/>
          <c:tx>
            <c:strRef>
              <c:f>'Dharmafect Species'!$AB$117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118:$AG$138</c:f>
                <c:numCache>
                  <c:formatCode>General</c:formatCode>
                  <c:ptCount val="21"/>
                  <c:pt idx="0">
                    <c:v>1033.745462098723</c:v>
                  </c:pt>
                  <c:pt idx="1">
                    <c:v>800.649401616433</c:v>
                  </c:pt>
                  <c:pt idx="2">
                    <c:v>389.9819346300056</c:v>
                  </c:pt>
                  <c:pt idx="3">
                    <c:v>3541.292134938775</c:v>
                  </c:pt>
                  <c:pt idx="4">
                    <c:v>42932.93543670198</c:v>
                  </c:pt>
                  <c:pt idx="5">
                    <c:v>63990.98604400888</c:v>
                  </c:pt>
                  <c:pt idx="6">
                    <c:v>21593.33121289085</c:v>
                  </c:pt>
                  <c:pt idx="7">
                    <c:v>2003.30158814446</c:v>
                  </c:pt>
                  <c:pt idx="8">
                    <c:v>532.9948051965633</c:v>
                  </c:pt>
                  <c:pt idx="9">
                    <c:v>3434.848005869294</c:v>
                  </c:pt>
                  <c:pt idx="10">
                    <c:v>1847.208626383611</c:v>
                  </c:pt>
                  <c:pt idx="11">
                    <c:v>1261.24366223224</c:v>
                  </c:pt>
                  <c:pt idx="12">
                    <c:v>6887.124137000535</c:v>
                  </c:pt>
                  <c:pt idx="13">
                    <c:v>1086.862200784449</c:v>
                  </c:pt>
                  <c:pt idx="14">
                    <c:v>16147.41208323418</c:v>
                  </c:pt>
                  <c:pt idx="15">
                    <c:v>594.9744254696483</c:v>
                  </c:pt>
                  <c:pt idx="16">
                    <c:v>514.2382755632366</c:v>
                  </c:pt>
                  <c:pt idx="17">
                    <c:v>643.2660767364463</c:v>
                  </c:pt>
                  <c:pt idx="18">
                    <c:v>593.2559822925898</c:v>
                  </c:pt>
                  <c:pt idx="19">
                    <c:v>5887.01841444863</c:v>
                  </c:pt>
                  <c:pt idx="20">
                    <c:v>32813.87092652568</c:v>
                  </c:pt>
                </c:numCache>
              </c:numRef>
            </c:plus>
            <c:minus>
              <c:numRef>
                <c:f>'Dharmafect Species'!$AG$118:$AG$138</c:f>
                <c:numCache>
                  <c:formatCode>General</c:formatCode>
                  <c:ptCount val="21"/>
                  <c:pt idx="0">
                    <c:v>1033.745462098723</c:v>
                  </c:pt>
                  <c:pt idx="1">
                    <c:v>800.649401616433</c:v>
                  </c:pt>
                  <c:pt idx="2">
                    <c:v>389.9819346300056</c:v>
                  </c:pt>
                  <c:pt idx="3">
                    <c:v>3541.292134938775</c:v>
                  </c:pt>
                  <c:pt idx="4">
                    <c:v>42932.93543670198</c:v>
                  </c:pt>
                  <c:pt idx="5">
                    <c:v>63990.98604400888</c:v>
                  </c:pt>
                  <c:pt idx="6">
                    <c:v>21593.33121289085</c:v>
                  </c:pt>
                  <c:pt idx="7">
                    <c:v>2003.30158814446</c:v>
                  </c:pt>
                  <c:pt idx="8">
                    <c:v>532.9948051965633</c:v>
                  </c:pt>
                  <c:pt idx="9">
                    <c:v>3434.848005869294</c:v>
                  </c:pt>
                  <c:pt idx="10">
                    <c:v>1847.208626383611</c:v>
                  </c:pt>
                  <c:pt idx="11">
                    <c:v>1261.24366223224</c:v>
                  </c:pt>
                  <c:pt idx="12">
                    <c:v>6887.124137000535</c:v>
                  </c:pt>
                  <c:pt idx="13">
                    <c:v>1086.862200784449</c:v>
                  </c:pt>
                  <c:pt idx="14">
                    <c:v>16147.41208323418</c:v>
                  </c:pt>
                  <c:pt idx="15">
                    <c:v>594.9744254696483</c:v>
                  </c:pt>
                  <c:pt idx="16">
                    <c:v>514.2382755632366</c:v>
                  </c:pt>
                  <c:pt idx="17">
                    <c:v>643.2660767364463</c:v>
                  </c:pt>
                  <c:pt idx="18">
                    <c:v>593.2559822925898</c:v>
                  </c:pt>
                  <c:pt idx="19">
                    <c:v>5887.01841444863</c:v>
                  </c:pt>
                  <c:pt idx="20">
                    <c:v>32813.870926525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18:$Y$138</c:f>
              <c:strCache>
                <c:ptCount val="21"/>
                <c:pt idx="0">
                  <c:v>PG 14:0_16:0</c:v>
                </c:pt>
                <c:pt idx="1">
                  <c:v>PG 14:0_18:2</c:v>
                </c:pt>
                <c:pt idx="2">
                  <c:v>PG 16:0_16:0</c:v>
                </c:pt>
                <c:pt idx="3">
                  <c:v>PG 16:0_16:1</c:v>
                </c:pt>
                <c:pt idx="4">
                  <c:v>PG 16:0_18:0</c:v>
                </c:pt>
                <c:pt idx="5">
                  <c:v>PG 16:0_18:1</c:v>
                </c:pt>
                <c:pt idx="6">
                  <c:v>PG 16:0_20:1</c:v>
                </c:pt>
                <c:pt idx="7">
                  <c:v>PG 16:0_22:6A</c:v>
                </c:pt>
                <c:pt idx="8">
                  <c:v>PG 16:0_22:6B</c:v>
                </c:pt>
                <c:pt idx="9">
                  <c:v>PG 16:1_18:1</c:v>
                </c:pt>
                <c:pt idx="10">
                  <c:v>PG 16:1_22:6</c:v>
                </c:pt>
                <c:pt idx="11">
                  <c:v>PG 18:0_22:6</c:v>
                </c:pt>
                <c:pt idx="12">
                  <c:v>PG 18:1_18:1</c:v>
                </c:pt>
                <c:pt idx="13">
                  <c:v>PG 18:1_22:5</c:v>
                </c:pt>
                <c:pt idx="14">
                  <c:v>PG 18:1_22:6</c:v>
                </c:pt>
                <c:pt idx="15">
                  <c:v>PG 18:2_22:6</c:v>
                </c:pt>
                <c:pt idx="16">
                  <c:v>PG 20:3_22:6</c:v>
                </c:pt>
                <c:pt idx="17">
                  <c:v>PG 20:5_22:6</c:v>
                </c:pt>
                <c:pt idx="18">
                  <c:v>PG 22:4_22:6</c:v>
                </c:pt>
                <c:pt idx="19">
                  <c:v>PG 22:5_22:6</c:v>
                </c:pt>
                <c:pt idx="20">
                  <c:v>PG 22:6_22:6</c:v>
                </c:pt>
              </c:strCache>
            </c:strRef>
          </c:cat>
          <c:val>
            <c:numRef>
              <c:f>'Dharmafect Species'!$AB$118:$AB$138</c:f>
              <c:numCache>
                <c:formatCode>General</c:formatCode>
                <c:ptCount val="21"/>
                <c:pt idx="0">
                  <c:v>3889.302541097006</c:v>
                </c:pt>
                <c:pt idx="1">
                  <c:v>2589.58401743571</c:v>
                </c:pt>
                <c:pt idx="2">
                  <c:v>1620.488255818683</c:v>
                </c:pt>
                <c:pt idx="3">
                  <c:v>12874.23249562583</c:v>
                </c:pt>
                <c:pt idx="4">
                  <c:v>74252.6896385214</c:v>
                </c:pt>
                <c:pt idx="5">
                  <c:v>211022.3489938897</c:v>
                </c:pt>
                <c:pt idx="6">
                  <c:v>50450.47615559898</c:v>
                </c:pt>
                <c:pt idx="7">
                  <c:v>6594.703226725261</c:v>
                </c:pt>
                <c:pt idx="8">
                  <c:v>1556.054178873698</c:v>
                </c:pt>
                <c:pt idx="9">
                  <c:v>5422.50609842936</c:v>
                </c:pt>
                <c:pt idx="10">
                  <c:v>7010.748372395831</c:v>
                </c:pt>
                <c:pt idx="11">
                  <c:v>5110.728434244791</c:v>
                </c:pt>
                <c:pt idx="12">
                  <c:v>16042.68909708662</c:v>
                </c:pt>
                <c:pt idx="13">
                  <c:v>4932.059672037761</c:v>
                </c:pt>
                <c:pt idx="14">
                  <c:v>50040.1285909017</c:v>
                </c:pt>
                <c:pt idx="15">
                  <c:v>3264.042673746746</c:v>
                </c:pt>
                <c:pt idx="16">
                  <c:v>2244.571848551434</c:v>
                </c:pt>
                <c:pt idx="17">
                  <c:v>2402.324259440105</c:v>
                </c:pt>
                <c:pt idx="18">
                  <c:v>2008.68559773763</c:v>
                </c:pt>
                <c:pt idx="19">
                  <c:v>18688.35587565105</c:v>
                </c:pt>
                <c:pt idx="20">
                  <c:v>87771.393269856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410-430C-92DB-D57B47C85C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4787352"/>
        <c:axId val="-2124783704"/>
      </c:barChart>
      <c:catAx>
        <c:axId val="-2124787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783704"/>
        <c:crosses val="autoZero"/>
        <c:auto val="1"/>
        <c:lblAlgn val="ctr"/>
        <c:lblOffset val="100"/>
        <c:noMultiLvlLbl val="0"/>
      </c:catAx>
      <c:valAx>
        <c:axId val="-2124783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787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145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146:$AE$153</c:f>
                <c:numCache>
                  <c:formatCode>General</c:formatCode>
                  <c:ptCount val="8"/>
                  <c:pt idx="0">
                    <c:v>28744.84245566015</c:v>
                  </c:pt>
                  <c:pt idx="1">
                    <c:v>2425.532879097058</c:v>
                  </c:pt>
                  <c:pt idx="2">
                    <c:v>10648.43358432893</c:v>
                  </c:pt>
                  <c:pt idx="3">
                    <c:v>4917.227971841001</c:v>
                  </c:pt>
                  <c:pt idx="4">
                    <c:v>3187.632552867425</c:v>
                  </c:pt>
                  <c:pt idx="5">
                    <c:v>6056.040783412543</c:v>
                  </c:pt>
                  <c:pt idx="6">
                    <c:v>41657.32575117794</c:v>
                  </c:pt>
                  <c:pt idx="7">
                    <c:v>6443.7959272999</c:v>
                  </c:pt>
                </c:numCache>
              </c:numRef>
            </c:plus>
            <c:minus>
              <c:numRef>
                <c:f>'Dharmafect Species'!$AE$146:$AE$153</c:f>
                <c:numCache>
                  <c:formatCode>General</c:formatCode>
                  <c:ptCount val="8"/>
                  <c:pt idx="0">
                    <c:v>28744.84245566015</c:v>
                  </c:pt>
                  <c:pt idx="1">
                    <c:v>2425.532879097058</c:v>
                  </c:pt>
                  <c:pt idx="2">
                    <c:v>10648.43358432893</c:v>
                  </c:pt>
                  <c:pt idx="3">
                    <c:v>4917.227971841001</c:v>
                  </c:pt>
                  <c:pt idx="4">
                    <c:v>3187.632552867425</c:v>
                  </c:pt>
                  <c:pt idx="5">
                    <c:v>6056.040783412543</c:v>
                  </c:pt>
                  <c:pt idx="6">
                    <c:v>41657.32575117794</c:v>
                  </c:pt>
                  <c:pt idx="7">
                    <c:v>6443.7959272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46:$Y$153</c:f>
              <c:strCache>
                <c:ptCount val="8"/>
                <c:pt idx="0">
                  <c:v>SM d34:1</c:v>
                </c:pt>
                <c:pt idx="1">
                  <c:v>SM d36:1</c:v>
                </c:pt>
                <c:pt idx="2">
                  <c:v>SM d40:1</c:v>
                </c:pt>
                <c:pt idx="3">
                  <c:v>SM d40:2</c:v>
                </c:pt>
                <c:pt idx="4">
                  <c:v>SM d41:1</c:v>
                </c:pt>
                <c:pt idx="5">
                  <c:v>SM d41:2</c:v>
                </c:pt>
                <c:pt idx="6">
                  <c:v>SM d42:2</c:v>
                </c:pt>
                <c:pt idx="7">
                  <c:v>SM d42:3</c:v>
                </c:pt>
              </c:strCache>
            </c:strRef>
          </c:cat>
          <c:val>
            <c:numRef>
              <c:f>'Dharmafect Species'!$Z$146:$Z$153</c:f>
              <c:numCache>
                <c:formatCode>General</c:formatCode>
                <c:ptCount val="8"/>
                <c:pt idx="0">
                  <c:v>503466.8441724401</c:v>
                </c:pt>
                <c:pt idx="1">
                  <c:v>24786.09629313152</c:v>
                </c:pt>
                <c:pt idx="2">
                  <c:v>66366.1005859375</c:v>
                </c:pt>
                <c:pt idx="3">
                  <c:v>56687.57529245971</c:v>
                </c:pt>
                <c:pt idx="4">
                  <c:v>17414.50154622396</c:v>
                </c:pt>
                <c:pt idx="5">
                  <c:v>62371.03869047418</c:v>
                </c:pt>
                <c:pt idx="6">
                  <c:v>407834.9565343231</c:v>
                </c:pt>
                <c:pt idx="7">
                  <c:v>95042.50319417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B99-4B00-B1EF-63349B37530E}"/>
            </c:ext>
          </c:extLst>
        </c:ser>
        <c:ser>
          <c:idx val="1"/>
          <c:order val="1"/>
          <c:tx>
            <c:strRef>
              <c:f>'Dharmafect Species'!$AA$145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146:$AF$153</c:f>
                <c:numCache>
                  <c:formatCode>General</c:formatCode>
                  <c:ptCount val="8"/>
                  <c:pt idx="0">
                    <c:v>35288.27807212514</c:v>
                  </c:pt>
                  <c:pt idx="1">
                    <c:v>2552.257942232731</c:v>
                  </c:pt>
                  <c:pt idx="2">
                    <c:v>6342.564774628071</c:v>
                  </c:pt>
                  <c:pt idx="3">
                    <c:v>6698.986373146196</c:v>
                  </c:pt>
                  <c:pt idx="4">
                    <c:v>1948.937118972142</c:v>
                  </c:pt>
                  <c:pt idx="5">
                    <c:v>4647.72946556225</c:v>
                  </c:pt>
                  <c:pt idx="6">
                    <c:v>43048.67274990446</c:v>
                  </c:pt>
                  <c:pt idx="7">
                    <c:v>7676.97050762339</c:v>
                  </c:pt>
                </c:numCache>
              </c:numRef>
            </c:plus>
            <c:minus>
              <c:numRef>
                <c:f>'Dharmafect Species'!$AF$146:$AF$153</c:f>
                <c:numCache>
                  <c:formatCode>General</c:formatCode>
                  <c:ptCount val="8"/>
                  <c:pt idx="0">
                    <c:v>35288.27807212514</c:v>
                  </c:pt>
                  <c:pt idx="1">
                    <c:v>2552.257942232731</c:v>
                  </c:pt>
                  <c:pt idx="2">
                    <c:v>6342.564774628071</c:v>
                  </c:pt>
                  <c:pt idx="3">
                    <c:v>6698.986373146196</c:v>
                  </c:pt>
                  <c:pt idx="4">
                    <c:v>1948.937118972142</c:v>
                  </c:pt>
                  <c:pt idx="5">
                    <c:v>4647.72946556225</c:v>
                  </c:pt>
                  <c:pt idx="6">
                    <c:v>43048.67274990446</c:v>
                  </c:pt>
                  <c:pt idx="7">
                    <c:v>7676.970507623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46:$Y$153</c:f>
              <c:strCache>
                <c:ptCount val="8"/>
                <c:pt idx="0">
                  <c:v>SM d34:1</c:v>
                </c:pt>
                <c:pt idx="1">
                  <c:v>SM d36:1</c:v>
                </c:pt>
                <c:pt idx="2">
                  <c:v>SM d40:1</c:v>
                </c:pt>
                <c:pt idx="3">
                  <c:v>SM d40:2</c:v>
                </c:pt>
                <c:pt idx="4">
                  <c:v>SM d41:1</c:v>
                </c:pt>
                <c:pt idx="5">
                  <c:v>SM d41:2</c:v>
                </c:pt>
                <c:pt idx="6">
                  <c:v>SM d42:2</c:v>
                </c:pt>
                <c:pt idx="7">
                  <c:v>SM d42:3</c:v>
                </c:pt>
              </c:strCache>
            </c:strRef>
          </c:cat>
          <c:val>
            <c:numRef>
              <c:f>'Dharmafect Species'!$AA$146:$AA$153</c:f>
              <c:numCache>
                <c:formatCode>General</c:formatCode>
                <c:ptCount val="8"/>
                <c:pt idx="0">
                  <c:v>558709.7927751177</c:v>
                </c:pt>
                <c:pt idx="1">
                  <c:v>21756.17198181152</c:v>
                </c:pt>
                <c:pt idx="2">
                  <c:v>75593.41259765619</c:v>
                </c:pt>
                <c:pt idx="3">
                  <c:v>60848.04113089634</c:v>
                </c:pt>
                <c:pt idx="4">
                  <c:v>20030.67594401042</c:v>
                </c:pt>
                <c:pt idx="5">
                  <c:v>69616.97597311181</c:v>
                </c:pt>
                <c:pt idx="6">
                  <c:v>434475.8056534956</c:v>
                </c:pt>
                <c:pt idx="7">
                  <c:v>98016.965799967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B99-4B00-B1EF-63349B37530E}"/>
            </c:ext>
          </c:extLst>
        </c:ser>
        <c:ser>
          <c:idx val="2"/>
          <c:order val="2"/>
          <c:tx>
            <c:strRef>
              <c:f>'Dharmafect Species'!$AB$145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146:$AG$153</c:f>
                <c:numCache>
                  <c:formatCode>General</c:formatCode>
                  <c:ptCount val="8"/>
                  <c:pt idx="0">
                    <c:v>66052.13557183483</c:v>
                  </c:pt>
                  <c:pt idx="1">
                    <c:v>3526.010175900028</c:v>
                  </c:pt>
                  <c:pt idx="2">
                    <c:v>15875.98537416635</c:v>
                  </c:pt>
                  <c:pt idx="3">
                    <c:v>7194.922129271444</c:v>
                  </c:pt>
                  <c:pt idx="4">
                    <c:v>3159.398864317532</c:v>
                  </c:pt>
                  <c:pt idx="5">
                    <c:v>12040.99366549558</c:v>
                  </c:pt>
                  <c:pt idx="6">
                    <c:v>72443.88578627238</c:v>
                  </c:pt>
                  <c:pt idx="7">
                    <c:v>15100.90673485731</c:v>
                  </c:pt>
                </c:numCache>
              </c:numRef>
            </c:plus>
            <c:minus>
              <c:numRef>
                <c:f>'Dharmafect Species'!$AG$146:$AG$153</c:f>
                <c:numCache>
                  <c:formatCode>General</c:formatCode>
                  <c:ptCount val="8"/>
                  <c:pt idx="0">
                    <c:v>66052.13557183483</c:v>
                  </c:pt>
                  <c:pt idx="1">
                    <c:v>3526.010175900028</c:v>
                  </c:pt>
                  <c:pt idx="2">
                    <c:v>15875.98537416635</c:v>
                  </c:pt>
                  <c:pt idx="3">
                    <c:v>7194.922129271444</c:v>
                  </c:pt>
                  <c:pt idx="4">
                    <c:v>3159.398864317532</c:v>
                  </c:pt>
                  <c:pt idx="5">
                    <c:v>12040.99366549558</c:v>
                  </c:pt>
                  <c:pt idx="6">
                    <c:v>72443.88578627238</c:v>
                  </c:pt>
                  <c:pt idx="7">
                    <c:v>15100.906734857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46:$Y$153</c:f>
              <c:strCache>
                <c:ptCount val="8"/>
                <c:pt idx="0">
                  <c:v>SM d34:1</c:v>
                </c:pt>
                <c:pt idx="1">
                  <c:v>SM d36:1</c:v>
                </c:pt>
                <c:pt idx="2">
                  <c:v>SM d40:1</c:v>
                </c:pt>
                <c:pt idx="3">
                  <c:v>SM d40:2</c:v>
                </c:pt>
                <c:pt idx="4">
                  <c:v>SM d41:1</c:v>
                </c:pt>
                <c:pt idx="5">
                  <c:v>SM d41:2</c:v>
                </c:pt>
                <c:pt idx="6">
                  <c:v>SM d42:2</c:v>
                </c:pt>
                <c:pt idx="7">
                  <c:v>SM d42:3</c:v>
                </c:pt>
              </c:strCache>
            </c:strRef>
          </c:cat>
          <c:val>
            <c:numRef>
              <c:f>'Dharmafect Species'!$AB$146:$AB$153</c:f>
              <c:numCache>
                <c:formatCode>General</c:formatCode>
                <c:ptCount val="8"/>
                <c:pt idx="0">
                  <c:v>487830.6767286338</c:v>
                </c:pt>
                <c:pt idx="1">
                  <c:v>15431.54650624593</c:v>
                </c:pt>
                <c:pt idx="2">
                  <c:v>64381.05078125</c:v>
                </c:pt>
                <c:pt idx="3">
                  <c:v>47184.63194067264</c:v>
                </c:pt>
                <c:pt idx="4">
                  <c:v>16065.94213867188</c:v>
                </c:pt>
                <c:pt idx="5">
                  <c:v>57572.40594496601</c:v>
                </c:pt>
                <c:pt idx="6">
                  <c:v>355301.0240211126</c:v>
                </c:pt>
                <c:pt idx="7">
                  <c:v>86006.291330973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B99-4B00-B1EF-63349B3753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4713208"/>
        <c:axId val="-2124709512"/>
      </c:barChart>
      <c:catAx>
        <c:axId val="-2124713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709512"/>
        <c:crosses val="autoZero"/>
        <c:auto val="1"/>
        <c:lblAlgn val="ctr"/>
        <c:lblOffset val="100"/>
        <c:noMultiLvlLbl val="0"/>
      </c:catAx>
      <c:valAx>
        <c:axId val="-2124709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713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157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158:$AE$165</c:f>
                <c:numCache>
                  <c:formatCode>General</c:formatCode>
                  <c:ptCount val="8"/>
                  <c:pt idx="0">
                    <c:v>2093.53041905434</c:v>
                  </c:pt>
                  <c:pt idx="1">
                    <c:v>2523.046420002789</c:v>
                  </c:pt>
                  <c:pt idx="2">
                    <c:v>9046.787673404806</c:v>
                  </c:pt>
                  <c:pt idx="3">
                    <c:v>6488.89829479855</c:v>
                  </c:pt>
                  <c:pt idx="4">
                    <c:v>871.6692690553974</c:v>
                  </c:pt>
                  <c:pt idx="5">
                    <c:v>2523.874758086033</c:v>
                  </c:pt>
                  <c:pt idx="6">
                    <c:v>698.1100257686845</c:v>
                  </c:pt>
                  <c:pt idx="7">
                    <c:v>1044.27419114942</c:v>
                  </c:pt>
                </c:numCache>
              </c:numRef>
            </c:plus>
            <c:minus>
              <c:numRef>
                <c:f>'Dharmafect Species'!$AE$158:$AE$165</c:f>
                <c:numCache>
                  <c:formatCode>General</c:formatCode>
                  <c:ptCount val="8"/>
                  <c:pt idx="0">
                    <c:v>2093.53041905434</c:v>
                  </c:pt>
                  <c:pt idx="1">
                    <c:v>2523.046420002789</c:v>
                  </c:pt>
                  <c:pt idx="2">
                    <c:v>9046.787673404806</c:v>
                  </c:pt>
                  <c:pt idx="3">
                    <c:v>6488.89829479855</c:v>
                  </c:pt>
                  <c:pt idx="4">
                    <c:v>871.6692690553974</c:v>
                  </c:pt>
                  <c:pt idx="5">
                    <c:v>2523.874758086033</c:v>
                  </c:pt>
                  <c:pt idx="6">
                    <c:v>698.1100257686845</c:v>
                  </c:pt>
                  <c:pt idx="7">
                    <c:v>1044.274191149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58:$Y$165</c:f>
              <c:strCache>
                <c:ptCount val="8"/>
                <c:pt idx="0">
                  <c:v>FA 22:2</c:v>
                </c:pt>
                <c:pt idx="1">
                  <c:v>FA 24:5</c:v>
                </c:pt>
                <c:pt idx="2">
                  <c:v>FA 22:6</c:v>
                </c:pt>
                <c:pt idx="3">
                  <c:v>FA 22:5</c:v>
                </c:pt>
                <c:pt idx="4">
                  <c:v>FA 24:6</c:v>
                </c:pt>
                <c:pt idx="5">
                  <c:v>FA 24:5</c:v>
                </c:pt>
                <c:pt idx="6">
                  <c:v>FA 26:6</c:v>
                </c:pt>
                <c:pt idx="7">
                  <c:v>FA 26:5</c:v>
                </c:pt>
              </c:strCache>
            </c:strRef>
          </c:cat>
          <c:val>
            <c:numRef>
              <c:f>'Dharmafect Species'!$Z$158:$Z$165</c:f>
              <c:numCache>
                <c:formatCode>General</c:formatCode>
                <c:ptCount val="8"/>
                <c:pt idx="0">
                  <c:v>15822.55624706612</c:v>
                </c:pt>
                <c:pt idx="1">
                  <c:v>16666.09602167176</c:v>
                </c:pt>
                <c:pt idx="2">
                  <c:v>113832.883292559</c:v>
                </c:pt>
                <c:pt idx="3">
                  <c:v>99825.54900180077</c:v>
                </c:pt>
                <c:pt idx="4">
                  <c:v>8084.998163573975</c:v>
                </c:pt>
                <c:pt idx="5">
                  <c:v>16665.4888072784</c:v>
                </c:pt>
                <c:pt idx="6">
                  <c:v>7639.892733058894</c:v>
                </c:pt>
                <c:pt idx="7">
                  <c:v>11027.963428176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F58-47EE-BAAD-D84AF176D6F8}"/>
            </c:ext>
          </c:extLst>
        </c:ser>
        <c:ser>
          <c:idx val="1"/>
          <c:order val="1"/>
          <c:tx>
            <c:strRef>
              <c:f>'Dharmafect Species'!$AA$157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158:$AF$165</c:f>
                <c:numCache>
                  <c:formatCode>General</c:formatCode>
                  <c:ptCount val="8"/>
                  <c:pt idx="0">
                    <c:v>1787.124806108075</c:v>
                  </c:pt>
                  <c:pt idx="1">
                    <c:v>3411.973501846791</c:v>
                  </c:pt>
                  <c:pt idx="2">
                    <c:v>23718.77875453845</c:v>
                  </c:pt>
                  <c:pt idx="3">
                    <c:v>19825.90985978145</c:v>
                  </c:pt>
                  <c:pt idx="4">
                    <c:v>1894.674665863987</c:v>
                  </c:pt>
                  <c:pt idx="5">
                    <c:v>3413.373634525411</c:v>
                  </c:pt>
                  <c:pt idx="6">
                    <c:v>2220.91455653072</c:v>
                  </c:pt>
                  <c:pt idx="7">
                    <c:v>3223.395470549786</c:v>
                  </c:pt>
                </c:numCache>
              </c:numRef>
            </c:plus>
            <c:minus>
              <c:numRef>
                <c:f>'Dharmafect Species'!$AF$158:$AF$165</c:f>
                <c:numCache>
                  <c:formatCode>General</c:formatCode>
                  <c:ptCount val="8"/>
                  <c:pt idx="0">
                    <c:v>1787.124806108075</c:v>
                  </c:pt>
                  <c:pt idx="1">
                    <c:v>3411.973501846791</c:v>
                  </c:pt>
                  <c:pt idx="2">
                    <c:v>23718.77875453845</c:v>
                  </c:pt>
                  <c:pt idx="3">
                    <c:v>19825.90985978145</c:v>
                  </c:pt>
                  <c:pt idx="4">
                    <c:v>1894.674665863987</c:v>
                  </c:pt>
                  <c:pt idx="5">
                    <c:v>3413.373634525411</c:v>
                  </c:pt>
                  <c:pt idx="6">
                    <c:v>2220.91455653072</c:v>
                  </c:pt>
                  <c:pt idx="7">
                    <c:v>3223.3954705497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58:$Y$165</c:f>
              <c:strCache>
                <c:ptCount val="8"/>
                <c:pt idx="0">
                  <c:v>FA 22:2</c:v>
                </c:pt>
                <c:pt idx="1">
                  <c:v>FA 24:5</c:v>
                </c:pt>
                <c:pt idx="2">
                  <c:v>FA 22:6</c:v>
                </c:pt>
                <c:pt idx="3">
                  <c:v>FA 22:5</c:v>
                </c:pt>
                <c:pt idx="4">
                  <c:v>FA 24:6</c:v>
                </c:pt>
                <c:pt idx="5">
                  <c:v>FA 24:5</c:v>
                </c:pt>
                <c:pt idx="6">
                  <c:v>FA 26:6</c:v>
                </c:pt>
                <c:pt idx="7">
                  <c:v>FA 26:5</c:v>
                </c:pt>
              </c:strCache>
            </c:strRef>
          </c:cat>
          <c:val>
            <c:numRef>
              <c:f>'Dharmafect Species'!$AA$158:$AA$165</c:f>
              <c:numCache>
                <c:formatCode>General</c:formatCode>
                <c:ptCount val="8"/>
                <c:pt idx="0">
                  <c:v>10879.52563476562</c:v>
                </c:pt>
                <c:pt idx="1">
                  <c:v>28114.59383247147</c:v>
                </c:pt>
                <c:pt idx="2">
                  <c:v>161786.9966204843</c:v>
                </c:pt>
                <c:pt idx="3">
                  <c:v>138705.0797156032</c:v>
                </c:pt>
                <c:pt idx="4">
                  <c:v>14287.74234879112</c:v>
                </c:pt>
                <c:pt idx="5">
                  <c:v>28117.36871341558</c:v>
                </c:pt>
                <c:pt idx="6">
                  <c:v>15336.93512732557</c:v>
                </c:pt>
                <c:pt idx="7">
                  <c:v>21271.237721441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F58-47EE-BAAD-D84AF176D6F8}"/>
            </c:ext>
          </c:extLst>
        </c:ser>
        <c:ser>
          <c:idx val="2"/>
          <c:order val="2"/>
          <c:tx>
            <c:strRef>
              <c:f>'Dharmafect Species'!$AB$157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158:$AG$165</c:f>
                <c:numCache>
                  <c:formatCode>General</c:formatCode>
                  <c:ptCount val="8"/>
                  <c:pt idx="0">
                    <c:v>2880.223573922033</c:v>
                  </c:pt>
                  <c:pt idx="1">
                    <c:v>7809.26844419171</c:v>
                  </c:pt>
                  <c:pt idx="2">
                    <c:v>40440.90443469179</c:v>
                  </c:pt>
                  <c:pt idx="3">
                    <c:v>35298.76603428165</c:v>
                  </c:pt>
                  <c:pt idx="4">
                    <c:v>4368.559116489274</c:v>
                  </c:pt>
                  <c:pt idx="5">
                    <c:v>7808.335600873232</c:v>
                  </c:pt>
                  <c:pt idx="6">
                    <c:v>3307.225269649065</c:v>
                  </c:pt>
                  <c:pt idx="7">
                    <c:v>5812.862423472034</c:v>
                  </c:pt>
                </c:numCache>
              </c:numRef>
            </c:plus>
            <c:minus>
              <c:numRef>
                <c:f>'Dharmafect Species'!$AG$158:$AG$165</c:f>
                <c:numCache>
                  <c:formatCode>General</c:formatCode>
                  <c:ptCount val="8"/>
                  <c:pt idx="0">
                    <c:v>2880.223573922033</c:v>
                  </c:pt>
                  <c:pt idx="1">
                    <c:v>7809.26844419171</c:v>
                  </c:pt>
                  <c:pt idx="2">
                    <c:v>40440.90443469179</c:v>
                  </c:pt>
                  <c:pt idx="3">
                    <c:v>35298.76603428165</c:v>
                  </c:pt>
                  <c:pt idx="4">
                    <c:v>4368.559116489274</c:v>
                  </c:pt>
                  <c:pt idx="5">
                    <c:v>7808.335600873232</c:v>
                  </c:pt>
                  <c:pt idx="6">
                    <c:v>3307.225269649065</c:v>
                  </c:pt>
                  <c:pt idx="7">
                    <c:v>5812.8624234720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58:$Y$165</c:f>
              <c:strCache>
                <c:ptCount val="8"/>
                <c:pt idx="0">
                  <c:v>FA 22:2</c:v>
                </c:pt>
                <c:pt idx="1">
                  <c:v>FA 24:5</c:v>
                </c:pt>
                <c:pt idx="2">
                  <c:v>FA 22:6</c:v>
                </c:pt>
                <c:pt idx="3">
                  <c:v>FA 22:5</c:v>
                </c:pt>
                <c:pt idx="4">
                  <c:v>FA 24:6</c:v>
                </c:pt>
                <c:pt idx="5">
                  <c:v>FA 24:5</c:v>
                </c:pt>
                <c:pt idx="6">
                  <c:v>FA 26:6</c:v>
                </c:pt>
                <c:pt idx="7">
                  <c:v>FA 26:5</c:v>
                </c:pt>
              </c:strCache>
            </c:strRef>
          </c:cat>
          <c:val>
            <c:numRef>
              <c:f>'Dharmafect Species'!$AB$158:$AB$165</c:f>
              <c:numCache>
                <c:formatCode>General</c:formatCode>
                <c:ptCount val="8"/>
                <c:pt idx="0">
                  <c:v>9834.746487645516</c:v>
                </c:pt>
                <c:pt idx="1">
                  <c:v>31081.30271149958</c:v>
                </c:pt>
                <c:pt idx="2">
                  <c:v>158953.9735331622</c:v>
                </c:pt>
                <c:pt idx="3">
                  <c:v>145042.5009519886</c:v>
                </c:pt>
                <c:pt idx="4">
                  <c:v>15684.31105610862</c:v>
                </c:pt>
                <c:pt idx="5">
                  <c:v>31080.57066818362</c:v>
                </c:pt>
                <c:pt idx="6">
                  <c:v>15764.74370067717</c:v>
                </c:pt>
                <c:pt idx="7">
                  <c:v>23917.870805142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F58-47EE-BAAD-D84AF176D6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4629816"/>
        <c:axId val="-2124626120"/>
      </c:barChart>
      <c:catAx>
        <c:axId val="-2124629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626120"/>
        <c:crosses val="autoZero"/>
        <c:auto val="1"/>
        <c:lblAlgn val="ctr"/>
        <c:lblOffset val="100"/>
        <c:noMultiLvlLbl val="0"/>
      </c:catAx>
      <c:valAx>
        <c:axId val="-21246261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6298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170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171:$AE$174</c:f>
                <c:numCache>
                  <c:formatCode>General</c:formatCode>
                  <c:ptCount val="4"/>
                  <c:pt idx="0">
                    <c:v>2746.346000638531</c:v>
                  </c:pt>
                  <c:pt idx="1">
                    <c:v>1961.124067092961</c:v>
                  </c:pt>
                  <c:pt idx="2">
                    <c:v>4501.555109656284</c:v>
                  </c:pt>
                  <c:pt idx="3">
                    <c:v>7232.462961972481</c:v>
                  </c:pt>
                </c:numCache>
              </c:numRef>
            </c:plus>
            <c:minus>
              <c:numRef>
                <c:f>'Dharmafect Species'!$AE$171:$AE$174</c:f>
                <c:numCache>
                  <c:formatCode>General</c:formatCode>
                  <c:ptCount val="4"/>
                  <c:pt idx="0">
                    <c:v>2746.346000638531</c:v>
                  </c:pt>
                  <c:pt idx="1">
                    <c:v>1961.124067092961</c:v>
                  </c:pt>
                  <c:pt idx="2">
                    <c:v>4501.555109656284</c:v>
                  </c:pt>
                  <c:pt idx="3">
                    <c:v>7232.4629619724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71:$Y$174</c:f>
              <c:strCache>
                <c:ptCount val="4"/>
                <c:pt idx="0">
                  <c:v>GM3 d18:1_16:0</c:v>
                </c:pt>
                <c:pt idx="1">
                  <c:v>GM3 d18:1_22:0</c:v>
                </c:pt>
                <c:pt idx="2">
                  <c:v>GM3 d18:1_24:0</c:v>
                </c:pt>
                <c:pt idx="3">
                  <c:v>GM3 d18:1_24:1</c:v>
                </c:pt>
              </c:strCache>
            </c:strRef>
          </c:cat>
          <c:val>
            <c:numRef>
              <c:f>'Dharmafect Species'!$Z$171:$Z$174</c:f>
              <c:numCache>
                <c:formatCode>General</c:formatCode>
                <c:ptCount val="4"/>
                <c:pt idx="0">
                  <c:v>10456.00112676847</c:v>
                </c:pt>
                <c:pt idx="1">
                  <c:v>8319.976651778941</c:v>
                </c:pt>
                <c:pt idx="2">
                  <c:v>16617.40447615272</c:v>
                </c:pt>
                <c:pt idx="3">
                  <c:v>27478.856745214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E06-4733-AE6B-70B71649FF1A}"/>
            </c:ext>
          </c:extLst>
        </c:ser>
        <c:ser>
          <c:idx val="1"/>
          <c:order val="1"/>
          <c:tx>
            <c:strRef>
              <c:f>'Dharmafect Species'!$AA$170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171:$AF$174</c:f>
                <c:numCache>
                  <c:formatCode>General</c:formatCode>
                  <c:ptCount val="4"/>
                  <c:pt idx="0">
                    <c:v>11206.98572182331</c:v>
                  </c:pt>
                  <c:pt idx="1">
                    <c:v>6375.450630557204</c:v>
                  </c:pt>
                  <c:pt idx="2">
                    <c:v>13529.89734978373</c:v>
                  </c:pt>
                  <c:pt idx="3">
                    <c:v>25303.643222014</c:v>
                  </c:pt>
                </c:numCache>
              </c:numRef>
            </c:plus>
            <c:minus>
              <c:numRef>
                <c:f>'Dharmafect Species'!$AF$171:$AF$174</c:f>
                <c:numCache>
                  <c:formatCode>General</c:formatCode>
                  <c:ptCount val="4"/>
                  <c:pt idx="0">
                    <c:v>11206.98572182331</c:v>
                  </c:pt>
                  <c:pt idx="1">
                    <c:v>6375.450630557204</c:v>
                  </c:pt>
                  <c:pt idx="2">
                    <c:v>13529.89734978373</c:v>
                  </c:pt>
                  <c:pt idx="3">
                    <c:v>25303.6432220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71:$Y$174</c:f>
              <c:strCache>
                <c:ptCount val="4"/>
                <c:pt idx="0">
                  <c:v>GM3 d18:1_16:0</c:v>
                </c:pt>
                <c:pt idx="1">
                  <c:v>GM3 d18:1_22:0</c:v>
                </c:pt>
                <c:pt idx="2">
                  <c:v>GM3 d18:1_24:0</c:v>
                </c:pt>
                <c:pt idx="3">
                  <c:v>GM3 d18:1_24:1</c:v>
                </c:pt>
              </c:strCache>
            </c:strRef>
          </c:cat>
          <c:val>
            <c:numRef>
              <c:f>'Dharmafect Species'!$AA$171:$AA$174</c:f>
              <c:numCache>
                <c:formatCode>General</c:formatCode>
                <c:ptCount val="4"/>
                <c:pt idx="0">
                  <c:v>19632.89906714169</c:v>
                </c:pt>
                <c:pt idx="1">
                  <c:v>12672.53197959107</c:v>
                </c:pt>
                <c:pt idx="2">
                  <c:v>25475.60577243142</c:v>
                </c:pt>
                <c:pt idx="3">
                  <c:v>46777.229049338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E06-4733-AE6B-70B71649FF1A}"/>
            </c:ext>
          </c:extLst>
        </c:ser>
        <c:ser>
          <c:idx val="2"/>
          <c:order val="2"/>
          <c:tx>
            <c:strRef>
              <c:f>'Dharmafect Species'!$AB$170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171:$AG$174</c:f>
                <c:numCache>
                  <c:formatCode>General</c:formatCode>
                  <c:ptCount val="4"/>
                  <c:pt idx="0">
                    <c:v>7201.719852840455</c:v>
                  </c:pt>
                  <c:pt idx="1">
                    <c:v>3737.472136728447</c:v>
                  </c:pt>
                  <c:pt idx="2">
                    <c:v>8431.189953325797</c:v>
                  </c:pt>
                  <c:pt idx="3">
                    <c:v>14008.39912388161</c:v>
                  </c:pt>
                </c:numCache>
              </c:numRef>
            </c:plus>
            <c:minus>
              <c:numRef>
                <c:f>'Dharmafect Species'!$AG$171:$AG$174</c:f>
                <c:numCache>
                  <c:formatCode>General</c:formatCode>
                  <c:ptCount val="4"/>
                  <c:pt idx="0">
                    <c:v>7201.719852840455</c:v>
                  </c:pt>
                  <c:pt idx="1">
                    <c:v>3737.472136728447</c:v>
                  </c:pt>
                  <c:pt idx="2">
                    <c:v>8431.189953325797</c:v>
                  </c:pt>
                  <c:pt idx="3">
                    <c:v>14008.399123881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71:$Y$174</c:f>
              <c:strCache>
                <c:ptCount val="4"/>
                <c:pt idx="0">
                  <c:v>GM3 d18:1_16:0</c:v>
                </c:pt>
                <c:pt idx="1">
                  <c:v>GM3 d18:1_22:0</c:v>
                </c:pt>
                <c:pt idx="2">
                  <c:v>GM3 d18:1_24:0</c:v>
                </c:pt>
                <c:pt idx="3">
                  <c:v>GM3 d18:1_24:1</c:v>
                </c:pt>
              </c:strCache>
            </c:strRef>
          </c:cat>
          <c:val>
            <c:numRef>
              <c:f>'Dharmafect Species'!$AB$171:$AB$174</c:f>
              <c:numCache>
                <c:formatCode>General</c:formatCode>
                <c:ptCount val="4"/>
                <c:pt idx="0">
                  <c:v>17363.42860898091</c:v>
                </c:pt>
                <c:pt idx="1">
                  <c:v>11629.42264721397</c:v>
                </c:pt>
                <c:pt idx="2">
                  <c:v>24957.7652276837</c:v>
                </c:pt>
                <c:pt idx="3">
                  <c:v>39077.393676800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E06-4733-AE6B-70B71649FF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4549816"/>
        <c:axId val="-2124546120"/>
      </c:barChart>
      <c:catAx>
        <c:axId val="-2124549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546120"/>
        <c:crosses val="autoZero"/>
        <c:auto val="1"/>
        <c:lblAlgn val="ctr"/>
        <c:lblOffset val="100"/>
        <c:noMultiLvlLbl val="0"/>
      </c:catAx>
      <c:valAx>
        <c:axId val="-21245461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5498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178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179:$AE$197</c:f>
                <c:numCache>
                  <c:formatCode>General</c:formatCode>
                  <c:ptCount val="19"/>
                  <c:pt idx="0">
                    <c:v>71893.47872687352</c:v>
                  </c:pt>
                  <c:pt idx="1">
                    <c:v>10221.42562188005</c:v>
                  </c:pt>
                  <c:pt idx="2">
                    <c:v>34673.68784168232</c:v>
                  </c:pt>
                  <c:pt idx="3">
                    <c:v>123883.7101834553</c:v>
                  </c:pt>
                  <c:pt idx="4">
                    <c:v>10673.42454528994</c:v>
                  </c:pt>
                  <c:pt idx="5">
                    <c:v>438891.0874890318</c:v>
                  </c:pt>
                  <c:pt idx="6">
                    <c:v>39551.88018883509</c:v>
                  </c:pt>
                  <c:pt idx="7">
                    <c:v>87421.64858537784</c:v>
                  </c:pt>
                  <c:pt idx="8">
                    <c:v>19290.13759516656</c:v>
                  </c:pt>
                  <c:pt idx="9">
                    <c:v>1963.382725917631</c:v>
                  </c:pt>
                  <c:pt idx="10">
                    <c:v>438882.0811796377</c:v>
                  </c:pt>
                  <c:pt idx="11">
                    <c:v>18945.36969443362</c:v>
                  </c:pt>
                  <c:pt idx="12">
                    <c:v>71035.68921462405</c:v>
                  </c:pt>
                  <c:pt idx="13">
                    <c:v>968304.5638711688</c:v>
                  </c:pt>
                  <c:pt idx="14">
                    <c:v>321130.0986563771</c:v>
                  </c:pt>
                  <c:pt idx="15">
                    <c:v>34746.73467225002</c:v>
                  </c:pt>
                  <c:pt idx="16">
                    <c:v>22869.97363747534</c:v>
                  </c:pt>
                  <c:pt idx="17">
                    <c:v>24017.60923007417</c:v>
                  </c:pt>
                  <c:pt idx="18">
                    <c:v>19708.522011294</c:v>
                  </c:pt>
                </c:numCache>
              </c:numRef>
            </c:plus>
            <c:minus>
              <c:numRef>
                <c:f>'Dharmafect Species'!$AE$179:$AE$197</c:f>
                <c:numCache>
                  <c:formatCode>General</c:formatCode>
                  <c:ptCount val="19"/>
                  <c:pt idx="0">
                    <c:v>71893.47872687352</c:v>
                  </c:pt>
                  <c:pt idx="1">
                    <c:v>10221.42562188005</c:v>
                  </c:pt>
                  <c:pt idx="2">
                    <c:v>34673.68784168232</c:v>
                  </c:pt>
                  <c:pt idx="3">
                    <c:v>123883.7101834553</c:v>
                  </c:pt>
                  <c:pt idx="4">
                    <c:v>10673.42454528994</c:v>
                  </c:pt>
                  <c:pt idx="5">
                    <c:v>438891.0874890318</c:v>
                  </c:pt>
                  <c:pt idx="6">
                    <c:v>39551.88018883509</c:v>
                  </c:pt>
                  <c:pt idx="7">
                    <c:v>87421.64858537784</c:v>
                  </c:pt>
                  <c:pt idx="8">
                    <c:v>19290.13759516656</c:v>
                  </c:pt>
                  <c:pt idx="9">
                    <c:v>1963.382725917631</c:v>
                  </c:pt>
                  <c:pt idx="10">
                    <c:v>438882.0811796377</c:v>
                  </c:pt>
                  <c:pt idx="11">
                    <c:v>18945.36969443362</c:v>
                  </c:pt>
                  <c:pt idx="12">
                    <c:v>71035.68921462405</c:v>
                  </c:pt>
                  <c:pt idx="13">
                    <c:v>968304.5638711688</c:v>
                  </c:pt>
                  <c:pt idx="14">
                    <c:v>321130.0986563771</c:v>
                  </c:pt>
                  <c:pt idx="15">
                    <c:v>34746.73467225002</c:v>
                  </c:pt>
                  <c:pt idx="16">
                    <c:v>22869.97363747534</c:v>
                  </c:pt>
                  <c:pt idx="17">
                    <c:v>24017.60923007417</c:v>
                  </c:pt>
                  <c:pt idx="18">
                    <c:v>19708.5220112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79:$Y$197</c:f>
              <c:strCache>
                <c:ptCount val="19"/>
                <c:pt idx="0">
                  <c:v>PI(16:0/20:4)</c:v>
                </c:pt>
                <c:pt idx="1">
                  <c:v>PI(16:0/20:5)</c:v>
                </c:pt>
                <c:pt idx="2">
                  <c:v>PI(16:0/22:6)</c:v>
                </c:pt>
                <c:pt idx="3">
                  <c:v>PI(16:1/18:1)</c:v>
                </c:pt>
                <c:pt idx="4">
                  <c:v>PI(16:1/20:4)</c:v>
                </c:pt>
                <c:pt idx="5">
                  <c:v>PI(18:0/18:2)</c:v>
                </c:pt>
                <c:pt idx="6">
                  <c:v>PI(18:0/22:4)</c:v>
                </c:pt>
                <c:pt idx="7">
                  <c:v>PI(18:0/22:5)</c:v>
                </c:pt>
                <c:pt idx="8">
                  <c:v>PI(18:0/22:6)A</c:v>
                </c:pt>
                <c:pt idx="9">
                  <c:v>PI(18:0/22:6)B</c:v>
                </c:pt>
                <c:pt idx="10">
                  <c:v>PI(18:1/18:1)</c:v>
                </c:pt>
                <c:pt idx="11">
                  <c:v>PI(18:1/18:2)</c:v>
                </c:pt>
                <c:pt idx="12">
                  <c:v>PI(18:1/20:2)</c:v>
                </c:pt>
                <c:pt idx="13">
                  <c:v>PI(18:1/20:3)</c:v>
                </c:pt>
                <c:pt idx="14">
                  <c:v>PI(18:1/20:4)</c:v>
                </c:pt>
                <c:pt idx="15">
                  <c:v>PI(18:1/20:5)</c:v>
                </c:pt>
                <c:pt idx="16">
                  <c:v>PI(18:1/22:5)</c:v>
                </c:pt>
                <c:pt idx="17">
                  <c:v>PI(18:1/22:6)</c:v>
                </c:pt>
                <c:pt idx="18">
                  <c:v>PI(18:3/22:0)</c:v>
                </c:pt>
              </c:strCache>
            </c:strRef>
          </c:cat>
          <c:val>
            <c:numRef>
              <c:f>'Dharmafect Species'!$Z$179:$Z$197</c:f>
              <c:numCache>
                <c:formatCode>General</c:formatCode>
                <c:ptCount val="19"/>
                <c:pt idx="0">
                  <c:v>241795.2272899475</c:v>
                </c:pt>
                <c:pt idx="1">
                  <c:v>30281.35184733074</c:v>
                </c:pt>
                <c:pt idx="2">
                  <c:v>119503.9985148112</c:v>
                </c:pt>
                <c:pt idx="3">
                  <c:v>415071.2738035347</c:v>
                </c:pt>
                <c:pt idx="4">
                  <c:v>32554.3044290673</c:v>
                </c:pt>
                <c:pt idx="5">
                  <c:v>1.32481406463961E6</c:v>
                </c:pt>
                <c:pt idx="6">
                  <c:v>107745.4314121603</c:v>
                </c:pt>
                <c:pt idx="7">
                  <c:v>240445.1143265101</c:v>
                </c:pt>
                <c:pt idx="8">
                  <c:v>83464.0565185547</c:v>
                </c:pt>
                <c:pt idx="9">
                  <c:v>9261.576904296888</c:v>
                </c:pt>
                <c:pt idx="10">
                  <c:v>1.32479637970103E6</c:v>
                </c:pt>
                <c:pt idx="11">
                  <c:v>71915.68520100911</c:v>
                </c:pt>
                <c:pt idx="12">
                  <c:v>230336.6892604595</c:v>
                </c:pt>
                <c:pt idx="13">
                  <c:v>2.5737013873673E6</c:v>
                </c:pt>
                <c:pt idx="14">
                  <c:v>1.09900882189863E6</c:v>
                </c:pt>
                <c:pt idx="15">
                  <c:v>120418.0044293676</c:v>
                </c:pt>
                <c:pt idx="16">
                  <c:v>90387.93497922644</c:v>
                </c:pt>
                <c:pt idx="17">
                  <c:v>76932.6941931805</c:v>
                </c:pt>
                <c:pt idx="18">
                  <c:v>78437.636969176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7AD-47AA-9327-1923373D9F48}"/>
            </c:ext>
          </c:extLst>
        </c:ser>
        <c:ser>
          <c:idx val="1"/>
          <c:order val="1"/>
          <c:tx>
            <c:strRef>
              <c:f>'Dharmafect Species'!$AA$178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179:$AF$197</c:f>
                <c:numCache>
                  <c:formatCode>General</c:formatCode>
                  <c:ptCount val="19"/>
                  <c:pt idx="0">
                    <c:v>121859.6139764587</c:v>
                  </c:pt>
                  <c:pt idx="1">
                    <c:v>15571.14241763046</c:v>
                  </c:pt>
                  <c:pt idx="2">
                    <c:v>75178.96063986256</c:v>
                  </c:pt>
                  <c:pt idx="3">
                    <c:v>228559.8531947777</c:v>
                  </c:pt>
                  <c:pt idx="4">
                    <c:v>16927.83644713887</c:v>
                  </c:pt>
                  <c:pt idx="5">
                    <c:v>809364.8414011256</c:v>
                  </c:pt>
                  <c:pt idx="6">
                    <c:v>105752.5485192197</c:v>
                  </c:pt>
                  <c:pt idx="7">
                    <c:v>189450.4431550815</c:v>
                  </c:pt>
                  <c:pt idx="8">
                    <c:v>60927.99630870554</c:v>
                  </c:pt>
                  <c:pt idx="9">
                    <c:v>5011.21495963669</c:v>
                  </c:pt>
                  <c:pt idx="10">
                    <c:v>809266.4027436519</c:v>
                  </c:pt>
                  <c:pt idx="11">
                    <c:v>50501.43825921104</c:v>
                  </c:pt>
                  <c:pt idx="12">
                    <c:v>154723.3043048499</c:v>
                  </c:pt>
                  <c:pt idx="13">
                    <c:v>1.91267783612786E6</c:v>
                  </c:pt>
                  <c:pt idx="14">
                    <c:v>635351.9072352878</c:v>
                  </c:pt>
                  <c:pt idx="15">
                    <c:v>76590.75967391327</c:v>
                  </c:pt>
                  <c:pt idx="16">
                    <c:v>63664.41437668468</c:v>
                  </c:pt>
                  <c:pt idx="17">
                    <c:v>55631.20722357845</c:v>
                  </c:pt>
                  <c:pt idx="18">
                    <c:v>18447.39845644127</c:v>
                  </c:pt>
                </c:numCache>
              </c:numRef>
            </c:plus>
            <c:minus>
              <c:numRef>
                <c:f>'Dharmafect Species'!$AF$179:$AF$197</c:f>
                <c:numCache>
                  <c:formatCode>General</c:formatCode>
                  <c:ptCount val="19"/>
                  <c:pt idx="0">
                    <c:v>121859.6139764587</c:v>
                  </c:pt>
                  <c:pt idx="1">
                    <c:v>15571.14241763046</c:v>
                  </c:pt>
                  <c:pt idx="2">
                    <c:v>75178.96063986256</c:v>
                  </c:pt>
                  <c:pt idx="3">
                    <c:v>228559.8531947777</c:v>
                  </c:pt>
                  <c:pt idx="4">
                    <c:v>16927.83644713887</c:v>
                  </c:pt>
                  <c:pt idx="5">
                    <c:v>809364.8414011256</c:v>
                  </c:pt>
                  <c:pt idx="6">
                    <c:v>105752.5485192197</c:v>
                  </c:pt>
                  <c:pt idx="7">
                    <c:v>189450.4431550815</c:v>
                  </c:pt>
                  <c:pt idx="8">
                    <c:v>60927.99630870554</c:v>
                  </c:pt>
                  <c:pt idx="9">
                    <c:v>5011.21495963669</c:v>
                  </c:pt>
                  <c:pt idx="10">
                    <c:v>809266.4027436519</c:v>
                  </c:pt>
                  <c:pt idx="11">
                    <c:v>50501.43825921104</c:v>
                  </c:pt>
                  <c:pt idx="12">
                    <c:v>154723.3043048499</c:v>
                  </c:pt>
                  <c:pt idx="13">
                    <c:v>1.91267783612786E6</c:v>
                  </c:pt>
                  <c:pt idx="14">
                    <c:v>635351.9072352878</c:v>
                  </c:pt>
                  <c:pt idx="15">
                    <c:v>76590.75967391327</c:v>
                  </c:pt>
                  <c:pt idx="16">
                    <c:v>63664.41437668468</c:v>
                  </c:pt>
                  <c:pt idx="17">
                    <c:v>55631.20722357845</c:v>
                  </c:pt>
                  <c:pt idx="18">
                    <c:v>18447.398456441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79:$Y$197</c:f>
              <c:strCache>
                <c:ptCount val="19"/>
                <c:pt idx="0">
                  <c:v>PI(16:0/20:4)</c:v>
                </c:pt>
                <c:pt idx="1">
                  <c:v>PI(16:0/20:5)</c:v>
                </c:pt>
                <c:pt idx="2">
                  <c:v>PI(16:0/22:6)</c:v>
                </c:pt>
                <c:pt idx="3">
                  <c:v>PI(16:1/18:1)</c:v>
                </c:pt>
                <c:pt idx="4">
                  <c:v>PI(16:1/20:4)</c:v>
                </c:pt>
                <c:pt idx="5">
                  <c:v>PI(18:0/18:2)</c:v>
                </c:pt>
                <c:pt idx="6">
                  <c:v>PI(18:0/22:4)</c:v>
                </c:pt>
                <c:pt idx="7">
                  <c:v>PI(18:0/22:5)</c:v>
                </c:pt>
                <c:pt idx="8">
                  <c:v>PI(18:0/22:6)A</c:v>
                </c:pt>
                <c:pt idx="9">
                  <c:v>PI(18:0/22:6)B</c:v>
                </c:pt>
                <c:pt idx="10">
                  <c:v>PI(18:1/18:1)</c:v>
                </c:pt>
                <c:pt idx="11">
                  <c:v>PI(18:1/18:2)</c:v>
                </c:pt>
                <c:pt idx="12">
                  <c:v>PI(18:1/20:2)</c:v>
                </c:pt>
                <c:pt idx="13">
                  <c:v>PI(18:1/20:3)</c:v>
                </c:pt>
                <c:pt idx="14">
                  <c:v>PI(18:1/20:4)</c:v>
                </c:pt>
                <c:pt idx="15">
                  <c:v>PI(18:1/20:5)</c:v>
                </c:pt>
                <c:pt idx="16">
                  <c:v>PI(18:1/22:5)</c:v>
                </c:pt>
                <c:pt idx="17">
                  <c:v>PI(18:1/22:6)</c:v>
                </c:pt>
                <c:pt idx="18">
                  <c:v>PI(18:3/22:0)</c:v>
                </c:pt>
              </c:strCache>
            </c:strRef>
          </c:cat>
          <c:val>
            <c:numRef>
              <c:f>'Dharmafect Species'!$AA$179:$AA$197</c:f>
              <c:numCache>
                <c:formatCode>General</c:formatCode>
                <c:ptCount val="19"/>
                <c:pt idx="0">
                  <c:v>206217.2904783262</c:v>
                </c:pt>
                <c:pt idx="1">
                  <c:v>25559.8260904948</c:v>
                </c:pt>
                <c:pt idx="2">
                  <c:v>121747.824564616</c:v>
                </c:pt>
                <c:pt idx="3">
                  <c:v>378072.0287331347</c:v>
                </c:pt>
                <c:pt idx="4">
                  <c:v>28015.83258738121</c:v>
                </c:pt>
                <c:pt idx="5">
                  <c:v>1.17799870012679E6</c:v>
                </c:pt>
                <c:pt idx="6">
                  <c:v>155503.7955790207</c:v>
                </c:pt>
                <c:pt idx="7">
                  <c:v>287704.1068966144</c:v>
                </c:pt>
                <c:pt idx="8">
                  <c:v>102802.172526042</c:v>
                </c:pt>
                <c:pt idx="9">
                  <c:v>11333.22515869142</c:v>
                </c:pt>
                <c:pt idx="10">
                  <c:v>1.17806072054434E6</c:v>
                </c:pt>
                <c:pt idx="11">
                  <c:v>84433.22949218755</c:v>
                </c:pt>
                <c:pt idx="12">
                  <c:v>264334.9281324165</c:v>
                </c:pt>
                <c:pt idx="13">
                  <c:v>2.80101746422279E6</c:v>
                </c:pt>
                <c:pt idx="14">
                  <c:v>1.05016990646284E6</c:v>
                </c:pt>
                <c:pt idx="15">
                  <c:v>123574.1532308251</c:v>
                </c:pt>
                <c:pt idx="16">
                  <c:v>108285.8988998625</c:v>
                </c:pt>
                <c:pt idx="17">
                  <c:v>93271.3838004917</c:v>
                </c:pt>
                <c:pt idx="18">
                  <c:v>57195.969771163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7AD-47AA-9327-1923373D9F48}"/>
            </c:ext>
          </c:extLst>
        </c:ser>
        <c:ser>
          <c:idx val="2"/>
          <c:order val="2"/>
          <c:tx>
            <c:strRef>
              <c:f>'Dharmafect Species'!$AB$178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179:$AG$197</c:f>
                <c:numCache>
                  <c:formatCode>General</c:formatCode>
                  <c:ptCount val="19"/>
                  <c:pt idx="0">
                    <c:v>70819.28757006055</c:v>
                  </c:pt>
                  <c:pt idx="1">
                    <c:v>8048.91864179194</c:v>
                  </c:pt>
                  <c:pt idx="2">
                    <c:v>38737.20535786652</c:v>
                  </c:pt>
                  <c:pt idx="3">
                    <c:v>123942.7501484563</c:v>
                  </c:pt>
                  <c:pt idx="4">
                    <c:v>8908.558647277547</c:v>
                  </c:pt>
                  <c:pt idx="5">
                    <c:v>437953.494722945</c:v>
                  </c:pt>
                  <c:pt idx="6">
                    <c:v>55445.35191024353</c:v>
                  </c:pt>
                  <c:pt idx="7">
                    <c:v>103304.2819163423</c:v>
                  </c:pt>
                  <c:pt idx="8">
                    <c:v>32479.52886236238</c:v>
                  </c:pt>
                  <c:pt idx="9">
                    <c:v>3350.929879874554</c:v>
                  </c:pt>
                  <c:pt idx="10">
                    <c:v>438079.4914409382</c:v>
                  </c:pt>
                  <c:pt idx="11">
                    <c:v>26940.08025441152</c:v>
                  </c:pt>
                  <c:pt idx="12">
                    <c:v>90137.99208654514</c:v>
                  </c:pt>
                  <c:pt idx="13">
                    <c:v>1.09913852060745E6</c:v>
                  </c:pt>
                  <c:pt idx="14">
                    <c:v>331248.2148470563</c:v>
                  </c:pt>
                  <c:pt idx="15">
                    <c:v>39378.40665767103</c:v>
                  </c:pt>
                  <c:pt idx="16">
                    <c:v>33618.0870563119</c:v>
                  </c:pt>
                  <c:pt idx="17">
                    <c:v>31785.26262740711</c:v>
                  </c:pt>
                  <c:pt idx="18">
                    <c:v>18861.48621158524</c:v>
                  </c:pt>
                </c:numCache>
              </c:numRef>
            </c:plus>
            <c:minus>
              <c:numRef>
                <c:f>'Dharmafect Species'!$AG$179:$AG$197</c:f>
                <c:numCache>
                  <c:formatCode>General</c:formatCode>
                  <c:ptCount val="19"/>
                  <c:pt idx="0">
                    <c:v>70819.28757006055</c:v>
                  </c:pt>
                  <c:pt idx="1">
                    <c:v>8048.91864179194</c:v>
                  </c:pt>
                  <c:pt idx="2">
                    <c:v>38737.20535786652</c:v>
                  </c:pt>
                  <c:pt idx="3">
                    <c:v>123942.7501484563</c:v>
                  </c:pt>
                  <c:pt idx="4">
                    <c:v>8908.558647277547</c:v>
                  </c:pt>
                  <c:pt idx="5">
                    <c:v>437953.494722945</c:v>
                  </c:pt>
                  <c:pt idx="6">
                    <c:v>55445.35191024353</c:v>
                  </c:pt>
                  <c:pt idx="7">
                    <c:v>103304.2819163423</c:v>
                  </c:pt>
                  <c:pt idx="8">
                    <c:v>32479.52886236238</c:v>
                  </c:pt>
                  <c:pt idx="9">
                    <c:v>3350.929879874554</c:v>
                  </c:pt>
                  <c:pt idx="10">
                    <c:v>438079.4914409382</c:v>
                  </c:pt>
                  <c:pt idx="11">
                    <c:v>26940.08025441152</c:v>
                  </c:pt>
                  <c:pt idx="12">
                    <c:v>90137.99208654514</c:v>
                  </c:pt>
                  <c:pt idx="13">
                    <c:v>1.09913852060745E6</c:v>
                  </c:pt>
                  <c:pt idx="14">
                    <c:v>331248.2148470563</c:v>
                  </c:pt>
                  <c:pt idx="15">
                    <c:v>39378.40665767103</c:v>
                  </c:pt>
                  <c:pt idx="16">
                    <c:v>33618.0870563119</c:v>
                  </c:pt>
                  <c:pt idx="17">
                    <c:v>31785.26262740711</c:v>
                  </c:pt>
                  <c:pt idx="18">
                    <c:v>18861.486211585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179:$Y$197</c:f>
              <c:strCache>
                <c:ptCount val="19"/>
                <c:pt idx="0">
                  <c:v>PI(16:0/20:4)</c:v>
                </c:pt>
                <c:pt idx="1">
                  <c:v>PI(16:0/20:5)</c:v>
                </c:pt>
                <c:pt idx="2">
                  <c:v>PI(16:0/22:6)</c:v>
                </c:pt>
                <c:pt idx="3">
                  <c:v>PI(16:1/18:1)</c:v>
                </c:pt>
                <c:pt idx="4">
                  <c:v>PI(16:1/20:4)</c:v>
                </c:pt>
                <c:pt idx="5">
                  <c:v>PI(18:0/18:2)</c:v>
                </c:pt>
                <c:pt idx="6">
                  <c:v>PI(18:0/22:4)</c:v>
                </c:pt>
                <c:pt idx="7">
                  <c:v>PI(18:0/22:5)</c:v>
                </c:pt>
                <c:pt idx="8">
                  <c:v>PI(18:0/22:6)A</c:v>
                </c:pt>
                <c:pt idx="9">
                  <c:v>PI(18:0/22:6)B</c:v>
                </c:pt>
                <c:pt idx="10">
                  <c:v>PI(18:1/18:1)</c:v>
                </c:pt>
                <c:pt idx="11">
                  <c:v>PI(18:1/18:2)</c:v>
                </c:pt>
                <c:pt idx="12">
                  <c:v>PI(18:1/20:2)</c:v>
                </c:pt>
                <c:pt idx="13">
                  <c:v>PI(18:1/20:3)</c:v>
                </c:pt>
                <c:pt idx="14">
                  <c:v>PI(18:1/20:4)</c:v>
                </c:pt>
                <c:pt idx="15">
                  <c:v>PI(18:1/20:5)</c:v>
                </c:pt>
                <c:pt idx="16">
                  <c:v>PI(18:1/22:5)</c:v>
                </c:pt>
                <c:pt idx="17">
                  <c:v>PI(18:1/22:6)</c:v>
                </c:pt>
                <c:pt idx="18">
                  <c:v>PI(18:3/22:0)</c:v>
                </c:pt>
              </c:strCache>
            </c:strRef>
          </c:cat>
          <c:val>
            <c:numRef>
              <c:f>'Dharmafect Species'!$AB$179:$AB$197</c:f>
              <c:numCache>
                <c:formatCode>General</c:formatCode>
                <c:ptCount val="19"/>
                <c:pt idx="0">
                  <c:v>207276.8089073201</c:v>
                </c:pt>
                <c:pt idx="1">
                  <c:v>22997.02126057943</c:v>
                </c:pt>
                <c:pt idx="2">
                  <c:v>99974.8644409179</c:v>
                </c:pt>
                <c:pt idx="3">
                  <c:v>289077.0764946635</c:v>
                </c:pt>
                <c:pt idx="4">
                  <c:v>25198.63502653355</c:v>
                </c:pt>
                <c:pt idx="5">
                  <c:v>909899.3167409503</c:v>
                </c:pt>
                <c:pt idx="6">
                  <c:v>138999.6487308751</c:v>
                </c:pt>
                <c:pt idx="7">
                  <c:v>270034.7621150206</c:v>
                </c:pt>
                <c:pt idx="8">
                  <c:v>97399.11657714858</c:v>
                </c:pt>
                <c:pt idx="9">
                  <c:v>11580.08622233073</c:v>
                </c:pt>
                <c:pt idx="10">
                  <c:v>909858.4887406073</c:v>
                </c:pt>
                <c:pt idx="11">
                  <c:v>76665.31990559898</c:v>
                </c:pt>
                <c:pt idx="12">
                  <c:v>254591.7647067175</c:v>
                </c:pt>
                <c:pt idx="13">
                  <c:v>2.75249483076212E6</c:v>
                </c:pt>
                <c:pt idx="14">
                  <c:v>919851.0983385156</c:v>
                </c:pt>
                <c:pt idx="15">
                  <c:v>102063.6075898042</c:v>
                </c:pt>
                <c:pt idx="16">
                  <c:v>100435.2394218483</c:v>
                </c:pt>
                <c:pt idx="17">
                  <c:v>84344.12329281475</c:v>
                </c:pt>
                <c:pt idx="18">
                  <c:v>59147.383686465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7AD-47AA-9327-1923373D9F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24465432"/>
        <c:axId val="-2124461784"/>
      </c:barChart>
      <c:catAx>
        <c:axId val="-2124465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461784"/>
        <c:crosses val="autoZero"/>
        <c:auto val="1"/>
        <c:lblAlgn val="ctr"/>
        <c:lblOffset val="100"/>
        <c:noMultiLvlLbl val="0"/>
      </c:catAx>
      <c:valAx>
        <c:axId val="-21244617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24465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harmafect Species'!$Z$200</c:f>
              <c:strCache>
                <c:ptCount val="1"/>
                <c:pt idx="0">
                  <c:v>He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E$201:$AE$204</c:f>
                <c:numCache>
                  <c:formatCode>General</c:formatCode>
                  <c:ptCount val="4"/>
                  <c:pt idx="0">
                    <c:v>80797.81599964732</c:v>
                  </c:pt>
                  <c:pt idx="1">
                    <c:v>122852.6171681265</c:v>
                  </c:pt>
                  <c:pt idx="2">
                    <c:v>32882.24140076518</c:v>
                  </c:pt>
                  <c:pt idx="3">
                    <c:v>32606.54175570852</c:v>
                  </c:pt>
                </c:numCache>
              </c:numRef>
            </c:plus>
            <c:minus>
              <c:numRef>
                <c:f>'Dharmafect Species'!$AE$201:$AE$204</c:f>
                <c:numCache>
                  <c:formatCode>General</c:formatCode>
                  <c:ptCount val="4"/>
                  <c:pt idx="0">
                    <c:v>80797.81599964732</c:v>
                  </c:pt>
                  <c:pt idx="1">
                    <c:v>122852.6171681265</c:v>
                  </c:pt>
                  <c:pt idx="2">
                    <c:v>32882.24140076518</c:v>
                  </c:pt>
                  <c:pt idx="3">
                    <c:v>32606.541755708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01:$Y$204</c:f>
              <c:strCache>
                <c:ptCount val="4"/>
                <c:pt idx="0">
                  <c:v>PS(16:1/18:0)</c:v>
                </c:pt>
                <c:pt idx="1">
                  <c:v>PS(18:0/18:1)</c:v>
                </c:pt>
                <c:pt idx="2">
                  <c:v>PS(18:1/18:1)</c:v>
                </c:pt>
                <c:pt idx="3">
                  <c:v>PS(18:1/21:2)</c:v>
                </c:pt>
              </c:strCache>
            </c:strRef>
          </c:cat>
          <c:val>
            <c:numRef>
              <c:f>'Dharmafect Species'!$Z$201:$Z$204</c:f>
              <c:numCache>
                <c:formatCode>General</c:formatCode>
                <c:ptCount val="4"/>
                <c:pt idx="0">
                  <c:v>239381.0434163412</c:v>
                </c:pt>
                <c:pt idx="1">
                  <c:v>318278.7993164063</c:v>
                </c:pt>
                <c:pt idx="2">
                  <c:v>99383.79256184906</c:v>
                </c:pt>
                <c:pt idx="3">
                  <c:v>70074.32488769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70C-4B66-B2BB-B97EDB5BFE26}"/>
            </c:ext>
          </c:extLst>
        </c:ser>
        <c:ser>
          <c:idx val="1"/>
          <c:order val="1"/>
          <c:tx>
            <c:strRef>
              <c:f>'Dharmafect Species'!$AA$200</c:f>
              <c:strCache>
                <c:ptCount val="1"/>
                <c:pt idx="0">
                  <c:v>DharmaFECT 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F$201:$AF$204</c:f>
                <c:numCache>
                  <c:formatCode>General</c:formatCode>
                  <c:ptCount val="4"/>
                  <c:pt idx="0">
                    <c:v>125697.967268715</c:v>
                  </c:pt>
                  <c:pt idx="1">
                    <c:v>172712.6259920891</c:v>
                  </c:pt>
                  <c:pt idx="2">
                    <c:v>49273.92609678303</c:v>
                  </c:pt>
                  <c:pt idx="3">
                    <c:v>12688.14532614221</c:v>
                  </c:pt>
                </c:numCache>
              </c:numRef>
            </c:plus>
            <c:minus>
              <c:numRef>
                <c:f>'Dharmafect Species'!$AF$201:$AF$204</c:f>
                <c:numCache>
                  <c:formatCode>General</c:formatCode>
                  <c:ptCount val="4"/>
                  <c:pt idx="0">
                    <c:v>125697.967268715</c:v>
                  </c:pt>
                  <c:pt idx="1">
                    <c:v>172712.6259920891</c:v>
                  </c:pt>
                  <c:pt idx="2">
                    <c:v>49273.92609678303</c:v>
                  </c:pt>
                  <c:pt idx="3">
                    <c:v>12688.145326142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01:$Y$204</c:f>
              <c:strCache>
                <c:ptCount val="4"/>
                <c:pt idx="0">
                  <c:v>PS(16:1/18:0)</c:v>
                </c:pt>
                <c:pt idx="1">
                  <c:v>PS(18:0/18:1)</c:v>
                </c:pt>
                <c:pt idx="2">
                  <c:v>PS(18:1/18:1)</c:v>
                </c:pt>
                <c:pt idx="3">
                  <c:v>PS(18:1/21:2)</c:v>
                </c:pt>
              </c:strCache>
            </c:strRef>
          </c:cat>
          <c:val>
            <c:numRef>
              <c:f>'Dharmafect Species'!$AA$201:$AA$204</c:f>
              <c:numCache>
                <c:formatCode>General</c:formatCode>
                <c:ptCount val="4"/>
                <c:pt idx="0">
                  <c:v>200847.0831095378</c:v>
                </c:pt>
                <c:pt idx="1">
                  <c:v>264001.1848958333</c:v>
                </c:pt>
                <c:pt idx="2">
                  <c:v>85127.6524047851</c:v>
                </c:pt>
                <c:pt idx="3">
                  <c:v>30172.027518388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70C-4B66-B2BB-B97EDB5BFE26}"/>
            </c:ext>
          </c:extLst>
        </c:ser>
        <c:ser>
          <c:idx val="2"/>
          <c:order val="2"/>
          <c:tx>
            <c:strRef>
              <c:f>'Dharmafect Species'!$AB$200</c:f>
              <c:strCache>
                <c:ptCount val="1"/>
                <c:pt idx="0">
                  <c:v>DharmaFECT 1+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Dharmafect Species'!$AG$201:$AG$204</c:f>
                <c:numCache>
                  <c:formatCode>General</c:formatCode>
                  <c:ptCount val="4"/>
                  <c:pt idx="0">
                    <c:v>77384.07423404671</c:v>
                  </c:pt>
                  <c:pt idx="1">
                    <c:v>103211.3669739641</c:v>
                  </c:pt>
                  <c:pt idx="2">
                    <c:v>30567.85893562997</c:v>
                  </c:pt>
                  <c:pt idx="3">
                    <c:v>9272.190296544606</c:v>
                  </c:pt>
                </c:numCache>
              </c:numRef>
            </c:plus>
            <c:minus>
              <c:numRef>
                <c:f>'Dharmafect Species'!$AG$201:$AG$204</c:f>
                <c:numCache>
                  <c:formatCode>General</c:formatCode>
                  <c:ptCount val="4"/>
                  <c:pt idx="0">
                    <c:v>77384.07423404671</c:v>
                  </c:pt>
                  <c:pt idx="1">
                    <c:v>103211.3669739641</c:v>
                  </c:pt>
                  <c:pt idx="2">
                    <c:v>30567.85893562997</c:v>
                  </c:pt>
                  <c:pt idx="3">
                    <c:v>9272.1902965446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harmafect Species'!$Y$201:$Y$204</c:f>
              <c:strCache>
                <c:ptCount val="4"/>
                <c:pt idx="0">
                  <c:v>PS(16:1/18:0)</c:v>
                </c:pt>
                <c:pt idx="1">
                  <c:v>PS(18:0/18:1)</c:v>
                </c:pt>
                <c:pt idx="2">
                  <c:v>PS(18:1/18:1)</c:v>
                </c:pt>
                <c:pt idx="3">
                  <c:v>PS(18:1/21:2)</c:v>
                </c:pt>
              </c:strCache>
            </c:strRef>
          </c:cat>
          <c:val>
            <c:numRef>
              <c:f>'Dharmafect Species'!$AB$201:$AB$204</c:f>
              <c:numCache>
                <c:formatCode>General</c:formatCode>
                <c:ptCount val="4"/>
                <c:pt idx="0">
                  <c:v>150072.6420694988</c:v>
                </c:pt>
                <c:pt idx="1">
                  <c:v>216937.0551757813</c:v>
                </c:pt>
                <c:pt idx="2">
                  <c:v>71577.49401855486</c:v>
                </c:pt>
                <c:pt idx="3">
                  <c:v>34666.103081304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70C-4B66-B2BB-B97EDB5BFE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2143480696"/>
        <c:axId val="-2143477832"/>
      </c:barChart>
      <c:catAx>
        <c:axId val="-2143480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477832"/>
        <c:crosses val="autoZero"/>
        <c:auto val="1"/>
        <c:lblAlgn val="ctr"/>
        <c:lblOffset val="100"/>
        <c:noMultiLvlLbl val="0"/>
      </c:catAx>
      <c:valAx>
        <c:axId val="-21434778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 i="0" baseline="0" dirty="0">
                    <a:effectLst/>
                  </a:rPr>
                  <a:t>Peak Height (ion counts) </a:t>
                </a:r>
                <a:endParaRPr lang="en-US" sz="11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21434806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 err="1"/>
            <a:t>Cer</a:t>
          </a:r>
          <a:r>
            <a:rPr lang="en-US" sz="1800" b="1" dirty="0"/>
            <a:t> Species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TG species</a:t>
          </a:r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DG species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/>
            <a:t>PE</a:t>
          </a:r>
        </a:p>
        <a:p xmlns:a="http://schemas.openxmlformats.org/drawingml/2006/main">
          <a:endParaRPr lang="en-US" sz="1800" b="1"/>
        </a:p>
      </cdr:txBody>
    </cdr:sp>
  </cdr:relSizeAnchor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4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5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E species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C Species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G species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/>
            <a:t>SM species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FA species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3019</cdr:x>
      <cdr:y>0.0234</cdr:y>
    </cdr:from>
    <cdr:to>
      <cdr:x>0.45787</cdr:x>
      <cdr:y>0.13333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1380272" y="64185"/>
          <a:ext cx="713094" cy="3015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GM3 species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I species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55341</cdr:x>
      <cdr:y>0.10016</cdr:y>
    </cdr:from>
    <cdr:to>
      <cdr:x>0.55973</cdr:x>
      <cdr:y>0.1101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DB30FE71-9462-4FAA-9B95-9619FB98DCDA}"/>
            </a:ext>
          </a:extLst>
        </cdr:cNvPr>
        <cdr:cNvSpPr txBox="1"/>
      </cdr:nvSpPr>
      <cdr:spPr>
        <a:xfrm xmlns:a="http://schemas.openxmlformats.org/drawingml/2006/main">
          <a:off x="5884689" y="459441"/>
          <a:ext cx="67235" cy="45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2273</cdr:x>
      <cdr:y>0.02687</cdr:y>
    </cdr:from>
    <cdr:to>
      <cdr:x>0.5787</cdr:x>
      <cdr:y>0.13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3BB50983-7EEE-45EA-9CFB-73E2694897DC}"/>
            </a:ext>
          </a:extLst>
        </cdr:cNvPr>
        <cdr:cNvSpPr txBox="1"/>
      </cdr:nvSpPr>
      <cdr:spPr>
        <a:xfrm xmlns:a="http://schemas.openxmlformats.org/drawingml/2006/main">
          <a:off x="4495158" y="123264"/>
          <a:ext cx="1658471" cy="5042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800" b="1" dirty="0"/>
            <a:t>PS species</a:t>
          </a:r>
        </a:p>
        <a:p xmlns:a="http://schemas.openxmlformats.org/drawingml/2006/main">
          <a:endParaRPr lang="en-US" sz="1800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0536A53-9B07-4406-B3E9-06AA681EAC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1D360F31-E8D8-4606-B279-E0E9E991D8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2E474EB-2A23-4C56-841E-C0135F127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3227D58-9E35-4775-806E-52CAE7830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C7AE0C7-F6DA-4BE1-BC32-69E03155F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701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0A7E793-535A-4A72-B450-ABAD6559D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E23BF33C-B0C2-41EA-AE78-6E340CCA7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EEF2F57-6096-4445-836B-B86D73860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A4A995E-BC47-4C32-856C-FF3FE5211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3AAB115-9DC9-4C9D-AE1B-E9C315DE3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05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51B8CC90-5A95-4FAD-9F17-01FE54CD3F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F2009AE-4817-4AB0-A48C-EFE2E4C7DA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F2DD61F-4B75-4022-855F-25026B3E9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70F6002-80F5-411D-98F0-D5AA0A2FF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49D24BC-F7E4-48B9-8A76-E7E7D4CDD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78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59A5203-0AEE-47BF-B7C1-9E30B68EA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36DC41DF-BE4D-46A5-9C46-6092566E8A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B7FFE43-5497-4D23-9EED-4D74ED278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977DD20-9B5C-4F6C-9A70-8BDDC206D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7F48AB6-D1A2-40CA-9204-ECB99EA60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043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ECF3C04-FC20-4231-BCA1-D818750BE2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C0F00C8E-C877-46CA-8414-B33CA080DF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A533423-3DC0-490C-BE4F-566F96D49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8EF0C49-2DF7-4481-BC1D-1AC9C97C0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C3C8D9F-9EB0-426A-8393-BB25752B7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177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6C49924-B3E1-49A7-9A14-1C04EDFDE0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01005D6-A185-445C-BC4A-A1E86C00B6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4195ABCF-76D2-4B3A-8958-2C5B236FA2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DF528C8A-5225-400E-9B5B-54841F13E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F475393-B1FF-4B68-9470-A15C4E930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89582DEE-D824-4228-AAC3-792711A5C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212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D571BF5-C8F3-48D4-8ACA-8F6D76930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A9CCF7A-668D-47AE-A2CB-9121EFECB3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9C4B03F1-3964-477A-8EDA-710ADC482A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C04670FD-C114-45B1-AFA7-A3DF6F8045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46F250AB-8740-471F-AEAF-E1CF3922AA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5783CF6D-47C4-4B32-9F05-740B87EC8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E57B64B7-F6D9-4EC5-BDC0-323A9137C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DA6CCD4F-D6EC-4913-B1BE-025E49005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269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93BC0DA-7098-4287-A43D-DACA8140C9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F22C70A1-7DCF-4858-A357-132754BDE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D011173E-CC69-42CB-9ABD-CE4DE85A8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8B36CB2F-C089-4DA3-8A0E-5B0B3F2F2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236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C82FBD67-D61B-4ABD-B6DC-B85AFEF46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10DDE92E-A842-4C50-85E4-2A3FC49CA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CF7AFA98-8B98-443D-8BB9-598A0E966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191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8A01D21-5287-46F0-9242-7ADF0EDF7B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DD3D9C51-D995-4A33-9A8B-F281117753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2C2C247-5A26-47B9-99F9-988E01DC96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A98FFE9A-1958-44DF-8AEC-B9D0E116E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0B18CA5-4303-447B-A7E9-DD31A8E84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F9406B6-20F6-483B-98D8-DFCAFF1BF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311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54CF0D2-7DA7-4D5B-8D1B-6E6C0AEDA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977B615A-F93A-4BF3-9499-3E2C0FF9A5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881C4A3F-0BF3-4D03-9C08-1D395C1180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047EEC3-5B62-414B-ABF9-46D3AA8AF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0210607C-C242-435E-926D-B6A54F6BE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8EADF79D-E603-4790-B62D-B65CC36A3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443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84068AEF-9565-4F26-BB4B-0BD28D050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C6167F1-2A09-4A40-B452-840532CF42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98246BF-F095-4DB3-9646-5ECBFCBEB5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2D576-1DFB-43A1-86CF-0BED6558B0AE}" type="datetimeFigureOut">
              <a:rPr lang="en-US" smtClean="0"/>
              <a:t>29/0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FBBAEED-F1BF-4144-B8A5-8F239094D6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F26857B-80F1-4570-B1AB-AED80F430C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C2745-5B14-4AC8-8BD5-A70CB83B5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697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0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8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="" xmlns:a16="http://schemas.microsoft.com/office/drawing/2014/main" id="{5C94F627-51AB-4FE9-B00F-52233F0BCF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3349988"/>
              </p:ext>
            </p:extLst>
          </p:nvPr>
        </p:nvGraphicFramePr>
        <p:xfrm>
          <a:off x="899160" y="441960"/>
          <a:ext cx="10774680" cy="5913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716034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="" xmlns:a16="http://schemas.microsoft.com/office/drawing/2014/main" id="{0FD19B56-A57C-4904-8B06-26EDAC91BB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8168826"/>
              </p:ext>
            </p:extLst>
          </p:nvPr>
        </p:nvGraphicFramePr>
        <p:xfrm>
          <a:off x="-35719" y="945356"/>
          <a:ext cx="12263438" cy="4967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1100111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="" xmlns:a16="http://schemas.microsoft.com/office/drawing/2014/main" id="{F351BDEE-6B68-4B66-A3C3-9915AE67AB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2969011"/>
              </p:ext>
            </p:extLst>
          </p:nvPr>
        </p:nvGraphicFramePr>
        <p:xfrm>
          <a:off x="1728952" y="811924"/>
          <a:ext cx="9259614" cy="5147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99878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="" xmlns:a16="http://schemas.microsoft.com/office/drawing/2014/main" id="{96CC186A-B92E-47CC-8B1A-1C2AF158E4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791822"/>
              </p:ext>
            </p:extLst>
          </p:nvPr>
        </p:nvGraphicFramePr>
        <p:xfrm>
          <a:off x="960120" y="289560"/>
          <a:ext cx="10789919" cy="6156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892660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="" xmlns:a16="http://schemas.microsoft.com/office/drawing/2014/main" id="{90BBAEA4-A491-4847-871B-E62165B7C7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7996067"/>
              </p:ext>
            </p:extLst>
          </p:nvPr>
        </p:nvGraphicFramePr>
        <p:xfrm>
          <a:off x="466725" y="1013221"/>
          <a:ext cx="11258550" cy="48315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494593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="" xmlns:a16="http://schemas.microsoft.com/office/drawing/2014/main" id="{1E6E6F78-8DC6-475F-9F93-02BC2DA718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3366223"/>
              </p:ext>
            </p:extLst>
          </p:nvPr>
        </p:nvGraphicFramePr>
        <p:xfrm>
          <a:off x="909637" y="945355"/>
          <a:ext cx="10372725" cy="49672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466105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="" xmlns:a16="http://schemas.microsoft.com/office/drawing/2014/main" id="{8FE83882-8792-4DCC-8322-F690E3290F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4109337"/>
              </p:ext>
            </p:extLst>
          </p:nvPr>
        </p:nvGraphicFramePr>
        <p:xfrm>
          <a:off x="2261616" y="960120"/>
          <a:ext cx="8223504" cy="4953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003899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102D32B-1B35-4A7A-BCB3-26CF98806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50DA5FE-B03E-465D-9067-AEDC09801C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graphicFrame>
        <p:nvGraphicFramePr>
          <p:cNvPr id="4" name="Chart 3">
            <a:extLst>
              <a:ext uri="{FF2B5EF4-FFF2-40B4-BE49-F238E27FC236}">
                <a16:creationId xmlns="" xmlns:a16="http://schemas.microsoft.com/office/drawing/2014/main" id="{2D16159B-CD73-4513-A7D1-724616CE81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2494147"/>
              </p:ext>
            </p:extLst>
          </p:nvPr>
        </p:nvGraphicFramePr>
        <p:xfrm>
          <a:off x="1541776" y="1027906"/>
          <a:ext cx="9674863" cy="51490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58326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="" xmlns:a16="http://schemas.microsoft.com/office/drawing/2014/main" id="{81703EAA-FC46-47A8-A798-7DDCEC74C4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4123715"/>
              </p:ext>
            </p:extLst>
          </p:nvPr>
        </p:nvGraphicFramePr>
        <p:xfrm>
          <a:off x="2225040" y="669036"/>
          <a:ext cx="8107680" cy="4683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385535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="" xmlns:a16="http://schemas.microsoft.com/office/drawing/2014/main" id="{0D5EBD3E-D559-4CCC-9D91-5D1FA04B56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2921468"/>
              </p:ext>
            </p:extLst>
          </p:nvPr>
        </p:nvGraphicFramePr>
        <p:xfrm>
          <a:off x="1158240" y="585216"/>
          <a:ext cx="10277856" cy="5571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427738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="" xmlns:a16="http://schemas.microsoft.com/office/drawing/2014/main" id="{D828BBB1-42FC-48E9-B1AE-09511A9A37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417601"/>
              </p:ext>
            </p:extLst>
          </p:nvPr>
        </p:nvGraphicFramePr>
        <p:xfrm>
          <a:off x="2121408" y="609600"/>
          <a:ext cx="8302752" cy="5205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108026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995</TotalTime>
  <Words>89</Words>
  <Application>Microsoft Macintosh PowerPoint</Application>
  <PresentationFormat>Custom</PresentationFormat>
  <Paragraphs>23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ggert</dc:creator>
  <cp:lastModifiedBy>Riki Eggert</cp:lastModifiedBy>
  <cp:revision>10</cp:revision>
  <dcterms:created xsi:type="dcterms:W3CDTF">2019-04-18T13:17:57Z</dcterms:created>
  <dcterms:modified xsi:type="dcterms:W3CDTF">2019-04-29T14:02:49Z</dcterms:modified>
</cp:coreProperties>
</file>